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  <p:sldId id="267" r:id="rId3"/>
    <p:sldId id="606" r:id="rId4"/>
    <p:sldId id="604" r:id="rId5"/>
    <p:sldId id="265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128" d="100"/>
          <a:sy n="128" d="100"/>
        </p:scale>
        <p:origin x="17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higeokashigeru/Desktop/&#35542;&#25991;&#36914;&#34892;&#20013;/FRTF19/&#32113;&#35336;&#20966;&#29702;&#24460;/mutant%20screening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higeokashigeru/Desktop/&#35542;&#25991;&#36914;&#34892;&#20013;/FRTF19/&#32113;&#35336;&#20966;&#29702;&#24460;/&#39640;&#28201;&#12473;&#12488;&#12524;&#12473;37&#8451;%20qPC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shigeokashigeru/Desktop/&#35542;&#25991;&#36914;&#34892;&#20013;/FRTF19/&#32113;&#35336;&#20966;&#29702;&#24460;/&#39640;&#28201;&#12473;&#12488;&#12524;&#12473;37&#8451;%20qPCR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shigeokashigeru/Desktop/&#35542;&#25991;&#36914;&#34892;&#20013;/FRTF19/&#32113;&#35336;&#20966;&#29702;&#24460;/&#39640;&#28201;&#12473;&#12488;&#12524;&#12473;37&#8451;%20qPCR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shigeokashigeru/Desktop/&#35542;&#25991;&#36914;&#34892;&#20013;/FRTF19/&#32113;&#35336;&#20966;&#29702;&#24460;/&#39640;&#28201;&#12473;&#12488;&#12524;&#12473;37&#8451;%20qPCR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shigeokashigeru/Desktop/&#35542;&#25991;&#36914;&#34892;&#20013;/FRTF19/&#32113;&#35336;&#20966;&#29702;&#24460;/&#39640;&#28201;&#12473;&#12488;&#12524;&#12473;37&#8451;%20&#12501;&#12521;&#12498;&#12441;&#12531;&#23450;&#37327;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shigeokashigeru/Desktop/&#35542;&#25991;&#36914;&#34892;&#20013;/FRTF19/&#32113;&#35336;&#20966;&#29702;&#24460;/&#39640;&#28201;&#12473;&#12488;&#12524;&#12473;37&#8451;%20&#12501;&#12521;&#12498;&#12441;&#12531;&#23450;&#37327;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shigeokashigeru/Desktop/&#35542;&#25991;&#36914;&#34892;&#20013;/FRTF19/&#32113;&#35336;&#20966;&#29702;&#24460;/&#39640;&#28201;&#12473;&#12488;&#12524;&#12473;37&#8451;%20&#12501;&#12521;&#12498;&#12441;&#12531;&#23450;&#37327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8355877215733349E-2"/>
          <c:y val="1.9441420300822927E-2"/>
          <c:w val="0.95517920206040641"/>
          <c:h val="0.93955791852388826"/>
        </c:manualLayout>
      </c:layout>
      <c:barChart>
        <c:barDir val="col"/>
        <c:grouping val="clustered"/>
        <c:varyColors val="0"/>
        <c:ser>
          <c:idx val="0"/>
          <c:order val="0"/>
          <c:tx>
            <c:v>FAD</c:v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まとめ (2)'!$AF$2:$AF$21</c:f>
                <c:numCache>
                  <c:formatCode>General</c:formatCode>
                  <c:ptCount val="20"/>
                  <c:pt idx="0">
                    <c:v>5.5294299194117853</c:v>
                  </c:pt>
                  <c:pt idx="1">
                    <c:v>5.4738082080000003</c:v>
                  </c:pt>
                  <c:pt idx="2">
                    <c:v>5.2089542348424471</c:v>
                  </c:pt>
                  <c:pt idx="3">
                    <c:v>4.9390139197617602</c:v>
                  </c:pt>
                  <c:pt idx="4">
                    <c:v>4.4400897729386291</c:v>
                  </c:pt>
                  <c:pt idx="5">
                    <c:v>1.9801882827696686</c:v>
                  </c:pt>
                  <c:pt idx="6">
                    <c:v>4.4680852340564741</c:v>
                  </c:pt>
                  <c:pt idx="7">
                    <c:v>5.6575682609687519</c:v>
                  </c:pt>
                  <c:pt idx="8">
                    <c:v>1.5281519210258461</c:v>
                  </c:pt>
                  <c:pt idx="9">
                    <c:v>7.6612590383250305</c:v>
                  </c:pt>
                  <c:pt idx="10">
                    <c:v>2.7480080093941788</c:v>
                  </c:pt>
                  <c:pt idx="11">
                    <c:v>11.009837166525999</c:v>
                  </c:pt>
                  <c:pt idx="12">
                    <c:v>5.2056465329910262</c:v>
                  </c:pt>
                  <c:pt idx="13">
                    <c:v>5.3446274954188118</c:v>
                  </c:pt>
                  <c:pt idx="14">
                    <c:v>4.6547422349056715</c:v>
                  </c:pt>
                  <c:pt idx="15">
                    <c:v>6.5920255056939112</c:v>
                  </c:pt>
                  <c:pt idx="16">
                    <c:v>6.3215774486196432</c:v>
                  </c:pt>
                  <c:pt idx="17">
                    <c:v>6.9325037897081465</c:v>
                  </c:pt>
                  <c:pt idx="18">
                    <c:v>7.0235537873810925</c:v>
                  </c:pt>
                  <c:pt idx="19">
                    <c:v>5.1297379234028195</c:v>
                  </c:pt>
                </c:numCache>
              </c:numRef>
            </c:plus>
            <c:minus>
              <c:numRef>
                <c:f>'まとめ (2)'!$AF$2:$AF$21</c:f>
                <c:numCache>
                  <c:formatCode>General</c:formatCode>
                  <c:ptCount val="20"/>
                  <c:pt idx="0">
                    <c:v>5.5294299194117853</c:v>
                  </c:pt>
                  <c:pt idx="1">
                    <c:v>5.4738082080000003</c:v>
                  </c:pt>
                  <c:pt idx="2">
                    <c:v>5.2089542348424471</c:v>
                  </c:pt>
                  <c:pt idx="3">
                    <c:v>4.9390139197617602</c:v>
                  </c:pt>
                  <c:pt idx="4">
                    <c:v>4.4400897729386291</c:v>
                  </c:pt>
                  <c:pt idx="5">
                    <c:v>1.9801882827696686</c:v>
                  </c:pt>
                  <c:pt idx="6">
                    <c:v>4.4680852340564741</c:v>
                  </c:pt>
                  <c:pt idx="7">
                    <c:v>5.6575682609687519</c:v>
                  </c:pt>
                  <c:pt idx="8">
                    <c:v>1.5281519210258461</c:v>
                  </c:pt>
                  <c:pt idx="9">
                    <c:v>7.6612590383250305</c:v>
                  </c:pt>
                  <c:pt idx="10">
                    <c:v>2.7480080093941788</c:v>
                  </c:pt>
                  <c:pt idx="11">
                    <c:v>11.009837166525999</c:v>
                  </c:pt>
                  <c:pt idx="12">
                    <c:v>5.2056465329910262</c:v>
                  </c:pt>
                  <c:pt idx="13">
                    <c:v>5.3446274954188118</c:v>
                  </c:pt>
                  <c:pt idx="14">
                    <c:v>4.6547422349056715</c:v>
                  </c:pt>
                  <c:pt idx="15">
                    <c:v>6.5920255056939112</c:v>
                  </c:pt>
                  <c:pt idx="16">
                    <c:v>6.3215774486196432</c:v>
                  </c:pt>
                  <c:pt idx="17">
                    <c:v>6.9325037897081465</c:v>
                  </c:pt>
                  <c:pt idx="18">
                    <c:v>7.0235537873810925</c:v>
                  </c:pt>
                  <c:pt idx="19">
                    <c:v>5.12973792340281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まとめ (2)'!$AB$2:$AB$21</c:f>
              <c:strCache>
                <c:ptCount val="20"/>
                <c:pt idx="0">
                  <c:v>WT</c:v>
                </c:pt>
                <c:pt idx="1">
                  <c:v>frtf1</c:v>
                </c:pt>
                <c:pt idx="2">
                  <c:v>frtf2</c:v>
                </c:pt>
                <c:pt idx="3">
                  <c:v>frtf3</c:v>
                </c:pt>
                <c:pt idx="4">
                  <c:v>frtf4</c:v>
                </c:pt>
                <c:pt idx="5">
                  <c:v>frtf5</c:v>
                </c:pt>
                <c:pt idx="6">
                  <c:v>frtf6</c:v>
                </c:pt>
                <c:pt idx="7">
                  <c:v>frtf7</c:v>
                </c:pt>
                <c:pt idx="8">
                  <c:v>frtf8</c:v>
                </c:pt>
                <c:pt idx="9">
                  <c:v>frtf9</c:v>
                </c:pt>
                <c:pt idx="10">
                  <c:v>frtf10</c:v>
                </c:pt>
                <c:pt idx="11">
                  <c:v>frtf11</c:v>
                </c:pt>
                <c:pt idx="12">
                  <c:v>frtf12</c:v>
                </c:pt>
                <c:pt idx="13">
                  <c:v>frtf13</c:v>
                </c:pt>
                <c:pt idx="14">
                  <c:v>frtf14</c:v>
                </c:pt>
                <c:pt idx="15">
                  <c:v>frtf15</c:v>
                </c:pt>
                <c:pt idx="16">
                  <c:v>frtf16</c:v>
                </c:pt>
                <c:pt idx="17">
                  <c:v>frtf17</c:v>
                </c:pt>
                <c:pt idx="18">
                  <c:v>frtf18</c:v>
                </c:pt>
                <c:pt idx="19">
                  <c:v>frtf19.1</c:v>
                </c:pt>
              </c:strCache>
            </c:strRef>
          </c:cat>
          <c:val>
            <c:numRef>
              <c:f>'まとめ (2)'!$AD$2:$AD$21</c:f>
              <c:numCache>
                <c:formatCode>General</c:formatCode>
                <c:ptCount val="20"/>
                <c:pt idx="0">
                  <c:v>100</c:v>
                </c:pt>
                <c:pt idx="1">
                  <c:v>92.229043909401597</c:v>
                </c:pt>
                <c:pt idx="2">
                  <c:v>84.598063226924864</c:v>
                </c:pt>
                <c:pt idx="3">
                  <c:v>87.787673342523348</c:v>
                </c:pt>
                <c:pt idx="4">
                  <c:v>75.94873493800803</c:v>
                </c:pt>
                <c:pt idx="5">
                  <c:v>89.778299538171495</c:v>
                </c:pt>
                <c:pt idx="6">
                  <c:v>82.350174019629705</c:v>
                </c:pt>
                <c:pt idx="7">
                  <c:v>84.067536776948359</c:v>
                </c:pt>
                <c:pt idx="8">
                  <c:v>75.20025795896359</c:v>
                </c:pt>
                <c:pt idx="9">
                  <c:v>83.55547112682035</c:v>
                </c:pt>
                <c:pt idx="10">
                  <c:v>88.192941606088084</c:v>
                </c:pt>
                <c:pt idx="11">
                  <c:v>87.505668541394158</c:v>
                </c:pt>
                <c:pt idx="12">
                  <c:v>111.20000305891664</c:v>
                </c:pt>
                <c:pt idx="13">
                  <c:v>102.89156536564839</c:v>
                </c:pt>
                <c:pt idx="14">
                  <c:v>104.65300585431513</c:v>
                </c:pt>
                <c:pt idx="15">
                  <c:v>102.34446767210042</c:v>
                </c:pt>
                <c:pt idx="16">
                  <c:v>102.97768041375933</c:v>
                </c:pt>
                <c:pt idx="17">
                  <c:v>94.34144994415675</c:v>
                </c:pt>
                <c:pt idx="18">
                  <c:v>109.21453943920044</c:v>
                </c:pt>
                <c:pt idx="19">
                  <c:v>87.4460184501603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E29-C643-A34E-5D288374FFF3}"/>
            </c:ext>
          </c:extLst>
        </c:ser>
        <c:ser>
          <c:idx val="1"/>
          <c:order val="1"/>
          <c:tx>
            <c:v>FMN</c:v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まとめ (2)'!$AJ$2:$AJ$21</c:f>
                <c:numCache>
                  <c:formatCode>General</c:formatCode>
                  <c:ptCount val="20"/>
                  <c:pt idx="0">
                    <c:v>7.68100870506359</c:v>
                  </c:pt>
                  <c:pt idx="1">
                    <c:v>15.810777401026678</c:v>
                  </c:pt>
                  <c:pt idx="2">
                    <c:v>8.9699750260541613</c:v>
                  </c:pt>
                  <c:pt idx="3">
                    <c:v>12.432195583302022</c:v>
                  </c:pt>
                  <c:pt idx="4">
                    <c:v>6.5843193163015705</c:v>
                  </c:pt>
                  <c:pt idx="5">
                    <c:v>5.5391238393950877</c:v>
                  </c:pt>
                  <c:pt idx="6">
                    <c:v>9.2838261331723686</c:v>
                  </c:pt>
                  <c:pt idx="7">
                    <c:v>8.0329960980038209</c:v>
                  </c:pt>
                  <c:pt idx="8">
                    <c:v>6.8213056477075833</c:v>
                  </c:pt>
                  <c:pt idx="9">
                    <c:v>7.5005817636285315</c:v>
                  </c:pt>
                  <c:pt idx="10">
                    <c:v>3.5348245549421282</c:v>
                  </c:pt>
                  <c:pt idx="11">
                    <c:v>9.8058917341517446</c:v>
                  </c:pt>
                  <c:pt idx="12">
                    <c:v>8.6785801955444626</c:v>
                  </c:pt>
                  <c:pt idx="13">
                    <c:v>6.2810488631607884</c:v>
                  </c:pt>
                  <c:pt idx="14">
                    <c:v>3.9073251136162024</c:v>
                  </c:pt>
                  <c:pt idx="15">
                    <c:v>5.3669501775461796</c:v>
                  </c:pt>
                  <c:pt idx="16">
                    <c:v>12.291745382881082</c:v>
                  </c:pt>
                  <c:pt idx="17">
                    <c:v>7.8064366525305999</c:v>
                  </c:pt>
                  <c:pt idx="18">
                    <c:v>9.8200196984931178</c:v>
                  </c:pt>
                  <c:pt idx="19">
                    <c:v>2.1424223750555353</c:v>
                  </c:pt>
                </c:numCache>
              </c:numRef>
            </c:plus>
            <c:minus>
              <c:numRef>
                <c:f>'まとめ (2)'!$AJ$2:$AJ$21</c:f>
                <c:numCache>
                  <c:formatCode>General</c:formatCode>
                  <c:ptCount val="20"/>
                  <c:pt idx="0">
                    <c:v>7.68100870506359</c:v>
                  </c:pt>
                  <c:pt idx="1">
                    <c:v>15.810777401026678</c:v>
                  </c:pt>
                  <c:pt idx="2">
                    <c:v>8.9699750260541613</c:v>
                  </c:pt>
                  <c:pt idx="3">
                    <c:v>12.432195583302022</c:v>
                  </c:pt>
                  <c:pt idx="4">
                    <c:v>6.5843193163015705</c:v>
                  </c:pt>
                  <c:pt idx="5">
                    <c:v>5.5391238393950877</c:v>
                  </c:pt>
                  <c:pt idx="6">
                    <c:v>9.2838261331723686</c:v>
                  </c:pt>
                  <c:pt idx="7">
                    <c:v>8.0329960980038209</c:v>
                  </c:pt>
                  <c:pt idx="8">
                    <c:v>6.8213056477075833</c:v>
                  </c:pt>
                  <c:pt idx="9">
                    <c:v>7.5005817636285315</c:v>
                  </c:pt>
                  <c:pt idx="10">
                    <c:v>3.5348245549421282</c:v>
                  </c:pt>
                  <c:pt idx="11">
                    <c:v>9.8058917341517446</c:v>
                  </c:pt>
                  <c:pt idx="12">
                    <c:v>8.6785801955444626</c:v>
                  </c:pt>
                  <c:pt idx="13">
                    <c:v>6.2810488631607884</c:v>
                  </c:pt>
                  <c:pt idx="14">
                    <c:v>3.9073251136162024</c:v>
                  </c:pt>
                  <c:pt idx="15">
                    <c:v>5.3669501775461796</c:v>
                  </c:pt>
                  <c:pt idx="16">
                    <c:v>12.291745382881082</c:v>
                  </c:pt>
                  <c:pt idx="17">
                    <c:v>7.8064366525305999</c:v>
                  </c:pt>
                  <c:pt idx="18">
                    <c:v>9.8200196984931178</c:v>
                  </c:pt>
                  <c:pt idx="19">
                    <c:v>2.142422375055535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まとめ (2)'!$AH$2:$AH$21</c:f>
              <c:numCache>
                <c:formatCode>General</c:formatCode>
                <c:ptCount val="20"/>
                <c:pt idx="0">
                  <c:v>100</c:v>
                </c:pt>
                <c:pt idx="1">
                  <c:v>92.61028584527773</c:v>
                </c:pt>
                <c:pt idx="2">
                  <c:v>90.134769956899873</c:v>
                </c:pt>
                <c:pt idx="3">
                  <c:v>94.518630510167014</c:v>
                </c:pt>
                <c:pt idx="4">
                  <c:v>81.712823822513954</c:v>
                </c:pt>
                <c:pt idx="5">
                  <c:v>82.919530854875006</c:v>
                </c:pt>
                <c:pt idx="6">
                  <c:v>93.628370659336298</c:v>
                </c:pt>
                <c:pt idx="7">
                  <c:v>89.285791040811432</c:v>
                </c:pt>
                <c:pt idx="8">
                  <c:v>80.289544873299093</c:v>
                </c:pt>
                <c:pt idx="9">
                  <c:v>92.711916061579245</c:v>
                </c:pt>
                <c:pt idx="10">
                  <c:v>68.488566965104852</c:v>
                </c:pt>
                <c:pt idx="11">
                  <c:v>86.432760025722189</c:v>
                </c:pt>
                <c:pt idx="12">
                  <c:v>90.020177271242218</c:v>
                </c:pt>
                <c:pt idx="13">
                  <c:v>83.287118281329299</c:v>
                </c:pt>
                <c:pt idx="14">
                  <c:v>83.116469672961387</c:v>
                </c:pt>
                <c:pt idx="15">
                  <c:v>83.396168712170066</c:v>
                </c:pt>
                <c:pt idx="16">
                  <c:v>97.17400515217507</c:v>
                </c:pt>
                <c:pt idx="17">
                  <c:v>80.19399172480091</c:v>
                </c:pt>
                <c:pt idx="18">
                  <c:v>92.739909854113435</c:v>
                </c:pt>
                <c:pt idx="19">
                  <c:v>57.2360911522386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E29-C643-A34E-5D288374FFF3}"/>
            </c:ext>
          </c:extLst>
        </c:ser>
        <c:ser>
          <c:idx val="2"/>
          <c:order val="2"/>
          <c:tx>
            <c:v>RF</c:v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まとめ (2)'!$AN$2:$AN$21</c:f>
                <c:numCache>
                  <c:formatCode>General</c:formatCode>
                  <c:ptCount val="20"/>
                  <c:pt idx="0">
                    <c:v>4.5369210082942333</c:v>
                  </c:pt>
                  <c:pt idx="1">
                    <c:v>10.276416190241566</c:v>
                  </c:pt>
                  <c:pt idx="2">
                    <c:v>19.966005851838258</c:v>
                  </c:pt>
                  <c:pt idx="3">
                    <c:v>6.6821898413109402</c:v>
                  </c:pt>
                  <c:pt idx="4">
                    <c:v>10.759779946360855</c:v>
                  </c:pt>
                  <c:pt idx="5">
                    <c:v>8.4197694175930771</c:v>
                  </c:pt>
                  <c:pt idx="6">
                    <c:v>11.695680803379931</c:v>
                  </c:pt>
                  <c:pt idx="7">
                    <c:v>6.6800559501017611</c:v>
                  </c:pt>
                  <c:pt idx="8">
                    <c:v>14.005090979324661</c:v>
                  </c:pt>
                  <c:pt idx="9">
                    <c:v>11.074884768644418</c:v>
                  </c:pt>
                  <c:pt idx="10">
                    <c:v>7.8638533576180292</c:v>
                  </c:pt>
                  <c:pt idx="11">
                    <c:v>12.129836484979689</c:v>
                  </c:pt>
                  <c:pt idx="12">
                    <c:v>10.167997156951413</c:v>
                  </c:pt>
                  <c:pt idx="13">
                    <c:v>9.1648851929891162</c:v>
                  </c:pt>
                  <c:pt idx="14">
                    <c:v>5.359557268847146</c:v>
                  </c:pt>
                  <c:pt idx="15">
                    <c:v>11.659482060827665</c:v>
                  </c:pt>
                  <c:pt idx="16">
                    <c:v>6.1333753901408894</c:v>
                  </c:pt>
                  <c:pt idx="17">
                    <c:v>3.5021162073097813</c:v>
                  </c:pt>
                  <c:pt idx="18">
                    <c:v>12.632021602790028</c:v>
                  </c:pt>
                  <c:pt idx="19">
                    <c:v>4.5901660706537264</c:v>
                  </c:pt>
                </c:numCache>
              </c:numRef>
            </c:plus>
            <c:minus>
              <c:numRef>
                <c:f>'まとめ (2)'!$AN$2:$AN$21</c:f>
                <c:numCache>
                  <c:formatCode>General</c:formatCode>
                  <c:ptCount val="20"/>
                  <c:pt idx="0">
                    <c:v>4.5369210082942333</c:v>
                  </c:pt>
                  <c:pt idx="1">
                    <c:v>10.276416190241566</c:v>
                  </c:pt>
                  <c:pt idx="2">
                    <c:v>19.966005851838258</c:v>
                  </c:pt>
                  <c:pt idx="3">
                    <c:v>6.6821898413109402</c:v>
                  </c:pt>
                  <c:pt idx="4">
                    <c:v>10.759779946360855</c:v>
                  </c:pt>
                  <c:pt idx="5">
                    <c:v>8.4197694175930771</c:v>
                  </c:pt>
                  <c:pt idx="6">
                    <c:v>11.695680803379931</c:v>
                  </c:pt>
                  <c:pt idx="7">
                    <c:v>6.6800559501017611</c:v>
                  </c:pt>
                  <c:pt idx="8">
                    <c:v>14.005090979324661</c:v>
                  </c:pt>
                  <c:pt idx="9">
                    <c:v>11.074884768644418</c:v>
                  </c:pt>
                  <c:pt idx="10">
                    <c:v>7.8638533576180292</c:v>
                  </c:pt>
                  <c:pt idx="11">
                    <c:v>12.129836484979689</c:v>
                  </c:pt>
                  <c:pt idx="12">
                    <c:v>10.167997156951413</c:v>
                  </c:pt>
                  <c:pt idx="13">
                    <c:v>9.1648851929891162</c:v>
                  </c:pt>
                  <c:pt idx="14">
                    <c:v>5.359557268847146</c:v>
                  </c:pt>
                  <c:pt idx="15">
                    <c:v>11.659482060827665</c:v>
                  </c:pt>
                  <c:pt idx="16">
                    <c:v>6.1333753901408894</c:v>
                  </c:pt>
                  <c:pt idx="17">
                    <c:v>3.5021162073097813</c:v>
                  </c:pt>
                  <c:pt idx="18">
                    <c:v>12.632021602790028</c:v>
                  </c:pt>
                  <c:pt idx="19">
                    <c:v>4.590166070653726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まとめ (2)'!$AL$2:$AL$21</c:f>
              <c:numCache>
                <c:formatCode>General</c:formatCode>
                <c:ptCount val="20"/>
                <c:pt idx="0">
                  <c:v>100</c:v>
                </c:pt>
                <c:pt idx="1">
                  <c:v>87.05842844826482</c:v>
                </c:pt>
                <c:pt idx="2">
                  <c:v>83.44385159175917</c:v>
                </c:pt>
                <c:pt idx="3">
                  <c:v>97.434538912190661</c:v>
                </c:pt>
                <c:pt idx="4">
                  <c:v>98.672681437745453</c:v>
                </c:pt>
                <c:pt idx="5">
                  <c:v>100.0565513815839</c:v>
                </c:pt>
                <c:pt idx="6">
                  <c:v>89.308445204753937</c:v>
                </c:pt>
                <c:pt idx="7">
                  <c:v>68.911783804843793</c:v>
                </c:pt>
                <c:pt idx="8">
                  <c:v>70.904212033863558</c:v>
                </c:pt>
                <c:pt idx="9">
                  <c:v>64.46929200921258</c:v>
                </c:pt>
                <c:pt idx="10">
                  <c:v>75.012980546601582</c:v>
                </c:pt>
                <c:pt idx="11">
                  <c:v>62.841062130978273</c:v>
                </c:pt>
                <c:pt idx="12">
                  <c:v>74.041476153141318</c:v>
                </c:pt>
                <c:pt idx="13">
                  <c:v>80.341396659709261</c:v>
                </c:pt>
                <c:pt idx="14">
                  <c:v>62.000182783002309</c:v>
                </c:pt>
                <c:pt idx="15">
                  <c:v>74.601503780158112</c:v>
                </c:pt>
                <c:pt idx="16">
                  <c:v>96.043628161464127</c:v>
                </c:pt>
                <c:pt idx="17">
                  <c:v>82.093796643785296</c:v>
                </c:pt>
                <c:pt idx="18">
                  <c:v>109.34399466527313</c:v>
                </c:pt>
                <c:pt idx="19">
                  <c:v>50.7277132044684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E29-C643-A34E-5D288374FF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0182175"/>
        <c:axId val="650449743"/>
      </c:barChart>
      <c:catAx>
        <c:axId val="650182175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650449743"/>
        <c:crosses val="autoZero"/>
        <c:auto val="1"/>
        <c:lblAlgn val="ctr"/>
        <c:lblOffset val="100"/>
        <c:noMultiLvlLbl val="0"/>
      </c:catAx>
      <c:valAx>
        <c:axId val="650449743"/>
        <c:scaling>
          <c:orientation val="minMax"/>
          <c:max val="150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650182175"/>
        <c:crosses val="autoZero"/>
        <c:crossBetween val="between"/>
      </c:valAx>
      <c:spPr>
        <a:noFill/>
        <a:ln w="19050">
          <a:solidFill>
            <a:schemeClr val="tx1"/>
          </a:solidFill>
        </a:ln>
        <a:effectLst/>
      </c:spPr>
    </c:plotArea>
    <c:legend>
      <c:legendPos val="r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</c:legendEntry>
      <c:legendEntry>
        <c:idx val="2"/>
        <c:txPr>
          <a:bodyPr rot="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</c:legendEntry>
      <c:layout>
        <c:manualLayout>
          <c:xMode val="edge"/>
          <c:yMode val="edge"/>
          <c:x val="4.2118921383186021E-2"/>
          <c:y val="2.5723913569221234E-2"/>
          <c:w val="0.30164794696575187"/>
          <c:h val="0.12923153551196004"/>
        </c:manualLayout>
      </c:layout>
      <c:overlay val="0"/>
      <c:spPr>
        <a:noFill/>
        <a:ln w="19050"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Helvetica" pitchFamily="2" charset="0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1" u="none" strike="noStrike" kern="1200" spc="0" baseline="0">
                <a:solidFill>
                  <a:schemeClr val="tx1"/>
                </a:solidFill>
                <a:latin typeface="Helvetica" pitchFamily="2" charset="0"/>
                <a:ea typeface="Meiryo" panose="020B0604030504040204" pitchFamily="34" charset="-128"/>
                <a:cs typeface="+mn-cs"/>
              </a:defRPr>
            </a:pPr>
            <a:r>
              <a:rPr lang="en-US" altLang="ja-JP" sz="1100" i="1" dirty="0">
                <a:solidFill>
                  <a:schemeClr val="tx1"/>
                </a:solidFill>
                <a:latin typeface="Helvetica" pitchFamily="2" charset="0"/>
                <a:ea typeface="Meiryo" panose="020B0604030504040204" pitchFamily="34" charset="-128"/>
              </a:rPr>
              <a:t>AtDREB2G</a:t>
            </a:r>
            <a:endParaRPr lang="ja-JP" altLang="en-US" sz="1100" i="1">
              <a:solidFill>
                <a:schemeClr val="tx1"/>
              </a:solidFill>
              <a:latin typeface="Helvetica" pitchFamily="2" charset="0"/>
              <a:ea typeface="Meiryo" panose="020B0604030504040204" pitchFamily="34" charset="-128"/>
            </a:endParaRPr>
          </a:p>
        </c:rich>
      </c:tx>
      <c:layout>
        <c:manualLayout>
          <c:xMode val="edge"/>
          <c:yMode val="edge"/>
          <c:x val="0.10990033076501024"/>
          <c:y val="0.1052577066261427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1" u="none" strike="noStrike" kern="1200" spc="0" baseline="0">
              <a:solidFill>
                <a:schemeClr val="tx1"/>
              </a:solidFill>
              <a:latin typeface="Helvetica" pitchFamily="2" charset="0"/>
              <a:ea typeface="Meiryo" panose="020B0604030504040204" pitchFamily="34" charset="-128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7.5041354038787492E-2"/>
          <c:y val="7.3068134720875699E-2"/>
          <c:w val="0.82297392689590243"/>
          <c:h val="0.7897220666291301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RTF19!$W$8:$W$10</c:f>
                <c:numCache>
                  <c:formatCode>General</c:formatCode>
                  <c:ptCount val="3"/>
                  <c:pt idx="0">
                    <c:v>0.19559097414401597</c:v>
                  </c:pt>
                  <c:pt idx="1">
                    <c:v>1.9648269751191823</c:v>
                  </c:pt>
                  <c:pt idx="2">
                    <c:v>1.6370958522514907</c:v>
                  </c:pt>
                </c:numCache>
              </c:numRef>
            </c:plus>
            <c:minus>
              <c:numRef>
                <c:f>FRTF19!$W$8:$W$10</c:f>
                <c:numCache>
                  <c:formatCode>General</c:formatCode>
                  <c:ptCount val="3"/>
                  <c:pt idx="0">
                    <c:v>0.19559097414401597</c:v>
                  </c:pt>
                  <c:pt idx="1">
                    <c:v>1.9648269751191823</c:v>
                  </c:pt>
                  <c:pt idx="2">
                    <c:v>1.6370958522514907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RTF19!$B$3:$B$5</c:f>
              <c:strCache>
                <c:ptCount val="3"/>
                <c:pt idx="0">
                  <c:v>0h</c:v>
                </c:pt>
                <c:pt idx="1">
                  <c:v>3h</c:v>
                </c:pt>
                <c:pt idx="2">
                  <c:v>6h</c:v>
                </c:pt>
              </c:strCache>
            </c:strRef>
          </c:cat>
          <c:val>
            <c:numRef>
              <c:f>FRTF19!$V$3:$V$5</c:f>
              <c:numCache>
                <c:formatCode>General</c:formatCode>
                <c:ptCount val="3"/>
                <c:pt idx="0">
                  <c:v>1</c:v>
                </c:pt>
                <c:pt idx="1">
                  <c:v>5.427029586616043</c:v>
                </c:pt>
                <c:pt idx="2">
                  <c:v>7.94148060367180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5F9-1249-A048-8F81EC730F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3495295"/>
        <c:axId val="183475919"/>
      </c:barChart>
      <c:catAx>
        <c:axId val="183495295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83475919"/>
        <c:crosses val="autoZero"/>
        <c:auto val="1"/>
        <c:lblAlgn val="ctr"/>
        <c:lblOffset val="100"/>
        <c:noMultiLvlLbl val="0"/>
      </c:catAx>
      <c:valAx>
        <c:axId val="183475919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Meiryo" panose="020B0604030504040204" pitchFamily="34" charset="-128"/>
                <a:cs typeface="+mn-cs"/>
              </a:defRPr>
            </a:pPr>
            <a:endParaRPr lang="ja-JP"/>
          </a:p>
        </c:txPr>
        <c:crossAx val="183495295"/>
        <c:crosses val="autoZero"/>
        <c:crossBetween val="between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1" u="none" strike="noStrike" kern="1200" spc="0" baseline="0">
                <a:solidFill>
                  <a:schemeClr val="tx1"/>
                </a:solidFill>
                <a:latin typeface="Helvetica" pitchFamily="2" charset="0"/>
                <a:ea typeface="Meiryo" panose="020B0604030504040204" pitchFamily="34" charset="-128"/>
                <a:cs typeface="+mn-cs"/>
              </a:defRPr>
            </a:pPr>
            <a:r>
              <a:rPr lang="en-US" altLang="ja-JP" sz="1100" i="1">
                <a:solidFill>
                  <a:schemeClr val="tx1"/>
                </a:solidFill>
                <a:latin typeface="Helvetica" pitchFamily="2" charset="0"/>
                <a:ea typeface="Meiryo" panose="020B0604030504040204" pitchFamily="34" charset="-128"/>
              </a:rPr>
              <a:t>AtRibA1</a:t>
            </a:r>
            <a:endParaRPr lang="ja-JP" altLang="en-US" sz="1100" i="1">
              <a:solidFill>
                <a:schemeClr val="tx1"/>
              </a:solidFill>
              <a:latin typeface="Helvetica" pitchFamily="2" charset="0"/>
              <a:ea typeface="Meiryo" panose="020B0604030504040204" pitchFamily="34" charset="-128"/>
            </a:endParaRPr>
          </a:p>
        </c:rich>
      </c:tx>
      <c:layout>
        <c:manualLayout>
          <c:xMode val="edge"/>
          <c:yMode val="edge"/>
          <c:x val="0.1894228996510432"/>
          <c:y val="7.0478483272098408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617365082471241"/>
          <c:y val="5.4344252112196012E-2"/>
          <c:w val="0.78973393670671987"/>
          <c:h val="0.82484147213868497"/>
        </c:manualLayout>
      </c:layout>
      <c:barChart>
        <c:barDir val="col"/>
        <c:grouping val="clustered"/>
        <c:varyColors val="0"/>
        <c:ser>
          <c:idx val="1"/>
          <c:order val="0"/>
          <c:tx>
            <c:v>WT</c:v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RF合成系!$W$34:$W$36</c:f>
                <c:numCache>
                  <c:formatCode>General</c:formatCode>
                  <c:ptCount val="3"/>
                  <c:pt idx="0">
                    <c:v>9.0564019329810841E-2</c:v>
                  </c:pt>
                  <c:pt idx="1">
                    <c:v>8.0407646344635805E-2</c:v>
                  </c:pt>
                  <c:pt idx="2">
                    <c:v>8.5182089175641018E-2</c:v>
                  </c:pt>
                </c:numCache>
              </c:numRef>
            </c:plus>
            <c:minus>
              <c:numRef>
                <c:f>RF合成系!$W$34:$W$36</c:f>
                <c:numCache>
                  <c:formatCode>General</c:formatCode>
                  <c:ptCount val="3"/>
                  <c:pt idx="0">
                    <c:v>9.0564019329810841E-2</c:v>
                  </c:pt>
                  <c:pt idx="1">
                    <c:v>8.0407646344635805E-2</c:v>
                  </c:pt>
                  <c:pt idx="2">
                    <c:v>8.5182089175641018E-2</c:v>
                  </c:pt>
                </c:numCache>
              </c:numRef>
            </c:minus>
            <c:spPr>
              <a:ln w="12700">
                <a:solidFill>
                  <a:schemeClr val="tx1"/>
                </a:solidFill>
              </a:ln>
            </c:spPr>
          </c:errBars>
          <c:cat>
            <c:strRef>
              <c:f>RF合成系!$B$10:$B$12</c:f>
              <c:strCache>
                <c:ptCount val="3"/>
                <c:pt idx="0">
                  <c:v>0h</c:v>
                </c:pt>
                <c:pt idx="1">
                  <c:v>3h</c:v>
                </c:pt>
                <c:pt idx="2">
                  <c:v>6h</c:v>
                </c:pt>
              </c:strCache>
            </c:strRef>
          </c:cat>
          <c:val>
            <c:numRef>
              <c:f>RF合成系!$V$10:$V$12</c:f>
              <c:numCache>
                <c:formatCode>General</c:formatCode>
                <c:ptCount val="3"/>
                <c:pt idx="0">
                  <c:v>1</c:v>
                </c:pt>
                <c:pt idx="1">
                  <c:v>0.83922094722468454</c:v>
                </c:pt>
                <c:pt idx="2">
                  <c:v>0.992336439642575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37F-5E43-9BF8-97A1F0B3B2F9}"/>
            </c:ext>
          </c:extLst>
        </c:ser>
        <c:ser>
          <c:idx val="0"/>
          <c:order val="1"/>
          <c:tx>
            <c:v>frtf19.1</c:v>
          </c:tx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F合成系!$W$37:$W$39</c:f>
                <c:numCache>
                  <c:formatCode>General</c:formatCode>
                  <c:ptCount val="3"/>
                  <c:pt idx="0">
                    <c:v>8.0549171101652203E-2</c:v>
                  </c:pt>
                  <c:pt idx="1">
                    <c:v>8.0169701082272574E-2</c:v>
                  </c:pt>
                  <c:pt idx="2">
                    <c:v>0.10390705360545464</c:v>
                  </c:pt>
                </c:numCache>
              </c:numRef>
            </c:plus>
            <c:minus>
              <c:numRef>
                <c:f>RF合成系!$W$37:$W$39</c:f>
                <c:numCache>
                  <c:formatCode>General</c:formatCode>
                  <c:ptCount val="3"/>
                  <c:pt idx="0">
                    <c:v>8.0549171101652203E-2</c:v>
                  </c:pt>
                  <c:pt idx="1">
                    <c:v>8.0169701082272574E-2</c:v>
                  </c:pt>
                  <c:pt idx="2">
                    <c:v>0.10390705360545464</c:v>
                  </c:pt>
                </c:numCache>
              </c:numRef>
            </c:minus>
            <c:spPr>
              <a:ln w="12700"/>
            </c:spPr>
          </c:errBars>
          <c:cat>
            <c:strRef>
              <c:f>RF合成系!$B$13:$B$15</c:f>
              <c:strCache>
                <c:ptCount val="3"/>
                <c:pt idx="0">
                  <c:v>0h</c:v>
                </c:pt>
                <c:pt idx="1">
                  <c:v>3h</c:v>
                </c:pt>
                <c:pt idx="2">
                  <c:v>6h</c:v>
                </c:pt>
              </c:strCache>
            </c:strRef>
          </c:cat>
          <c:val>
            <c:numRef>
              <c:f>RF合成系!$V$13:$V$15</c:f>
              <c:numCache>
                <c:formatCode>General</c:formatCode>
                <c:ptCount val="3"/>
                <c:pt idx="0">
                  <c:v>0.82706082456938868</c:v>
                </c:pt>
                <c:pt idx="1">
                  <c:v>0.95527393814531791</c:v>
                </c:pt>
                <c:pt idx="2">
                  <c:v>0.978995280645856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37F-5E43-9BF8-97A1F0B3B2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22182799"/>
        <c:axId val="1623785471"/>
      </c:barChart>
      <c:catAx>
        <c:axId val="162218279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23785471"/>
        <c:crosses val="autoZero"/>
        <c:auto val="1"/>
        <c:lblAlgn val="ctr"/>
        <c:lblOffset val="100"/>
        <c:noMultiLvlLbl val="0"/>
      </c:catAx>
      <c:valAx>
        <c:axId val="1623785471"/>
        <c:scaling>
          <c:orientation val="minMax"/>
          <c:max val="1.5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Meiryo" panose="020B0604030504040204" pitchFamily="34" charset="-128"/>
                <a:cs typeface="+mn-cs"/>
              </a:defRPr>
            </a:pPr>
            <a:endParaRPr lang="ja-JP"/>
          </a:p>
        </c:txPr>
        <c:crossAx val="1622182799"/>
        <c:crosses val="autoZero"/>
        <c:crossBetween val="between"/>
      </c:valAx>
      <c:spPr>
        <a:noFill/>
        <a:ln w="19050">
          <a:solidFill>
            <a:schemeClr val="tx1"/>
          </a:solidFill>
        </a:ln>
      </c:spPr>
    </c:plotArea>
    <c:plotVisOnly val="1"/>
    <c:dispBlanksAs val="gap"/>
    <c:showDLblsOverMax val="0"/>
    <c:extLst/>
  </c:chart>
  <c:spPr>
    <a:noFill/>
    <a:ln>
      <a:noFill/>
    </a:ln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1" u="none" strike="noStrike" kern="1200" spc="0" baseline="0">
                <a:solidFill>
                  <a:schemeClr val="tx1"/>
                </a:solidFill>
                <a:latin typeface="Helvetica" pitchFamily="2" charset="0"/>
                <a:ea typeface="Meiryo" panose="020B0604030504040204" pitchFamily="34" charset="-128"/>
                <a:cs typeface="+mn-cs"/>
              </a:defRPr>
            </a:pPr>
            <a:r>
              <a:rPr lang="en-US" altLang="ja-JP" sz="1100" i="1">
                <a:solidFill>
                  <a:schemeClr val="tx1"/>
                </a:solidFill>
                <a:latin typeface="Helvetica" pitchFamily="2" charset="0"/>
                <a:ea typeface="Meiryo" panose="020B0604030504040204" pitchFamily="34" charset="-128"/>
              </a:rPr>
              <a:t>PyrD</a:t>
            </a:r>
            <a:endParaRPr lang="ja-JP" altLang="en-US" sz="1100" i="1">
              <a:solidFill>
                <a:schemeClr val="tx1"/>
              </a:solidFill>
              <a:latin typeface="Helvetica" pitchFamily="2" charset="0"/>
              <a:ea typeface="Meiryo" panose="020B0604030504040204" pitchFamily="34" charset="-128"/>
            </a:endParaRPr>
          </a:p>
        </c:rich>
      </c:tx>
      <c:layout>
        <c:manualLayout>
          <c:xMode val="edge"/>
          <c:yMode val="edge"/>
          <c:x val="0.20291290558526043"/>
          <c:y val="6.6458595840632323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7664286463846507"/>
          <c:y val="6.1075410847972092E-2"/>
          <c:w val="0.75035605370558012"/>
          <c:h val="0.72366532467813338"/>
        </c:manualLayout>
      </c:layout>
      <c:barChart>
        <c:barDir val="col"/>
        <c:grouping val="clustered"/>
        <c:varyColors val="0"/>
        <c:ser>
          <c:idx val="1"/>
          <c:order val="0"/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RF合成系!$W$42:$W$44</c:f>
                <c:numCache>
                  <c:formatCode>General</c:formatCode>
                  <c:ptCount val="3"/>
                  <c:pt idx="0">
                    <c:v>6.3559581221433348E-2</c:v>
                  </c:pt>
                  <c:pt idx="1">
                    <c:v>6.0926990801667413E-2</c:v>
                  </c:pt>
                  <c:pt idx="2">
                    <c:v>6.9604984982429507E-2</c:v>
                  </c:pt>
                </c:numCache>
              </c:numRef>
            </c:plus>
            <c:minus>
              <c:numRef>
                <c:f>RF合成系!$W$42:$W$44</c:f>
                <c:numCache>
                  <c:formatCode>General</c:formatCode>
                  <c:ptCount val="3"/>
                  <c:pt idx="0">
                    <c:v>6.3559581221433348E-2</c:v>
                  </c:pt>
                  <c:pt idx="1">
                    <c:v>6.0926990801667413E-2</c:v>
                  </c:pt>
                  <c:pt idx="2">
                    <c:v>6.9604984982429507E-2</c:v>
                  </c:pt>
                </c:numCache>
              </c:numRef>
            </c:minus>
            <c:spPr>
              <a:ln w="12700"/>
            </c:spPr>
          </c:errBars>
          <c:cat>
            <c:strRef>
              <c:f>RF合成系!$B$18:$B$20</c:f>
              <c:strCache>
                <c:ptCount val="3"/>
                <c:pt idx="0">
                  <c:v>0h</c:v>
                </c:pt>
                <c:pt idx="1">
                  <c:v>3h</c:v>
                </c:pt>
                <c:pt idx="2">
                  <c:v>6h</c:v>
                </c:pt>
              </c:strCache>
            </c:strRef>
          </c:cat>
          <c:val>
            <c:numRef>
              <c:f>RF合成系!$V$18:$V$20</c:f>
              <c:numCache>
                <c:formatCode>General</c:formatCode>
                <c:ptCount val="3"/>
                <c:pt idx="0">
                  <c:v>1</c:v>
                </c:pt>
                <c:pt idx="1">
                  <c:v>0.75410004601842684</c:v>
                </c:pt>
                <c:pt idx="2">
                  <c:v>0.962401966063857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BA0-4249-9D98-5EED1AF80564}"/>
            </c:ext>
          </c:extLst>
        </c:ser>
        <c:ser>
          <c:idx val="0"/>
          <c:order val="1"/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F合成系!$W$45:$W$47</c:f>
                <c:numCache>
                  <c:formatCode>General</c:formatCode>
                  <c:ptCount val="3"/>
                  <c:pt idx="0">
                    <c:v>6.1384102974940929E-2</c:v>
                  </c:pt>
                  <c:pt idx="1">
                    <c:v>4.7302649876504073E-2</c:v>
                  </c:pt>
                  <c:pt idx="2">
                    <c:v>6.7106610568918645E-2</c:v>
                  </c:pt>
                </c:numCache>
              </c:numRef>
            </c:plus>
            <c:minus>
              <c:numRef>
                <c:f>RF合成系!$W$45:$W$47</c:f>
                <c:numCache>
                  <c:formatCode>General</c:formatCode>
                  <c:ptCount val="3"/>
                  <c:pt idx="0">
                    <c:v>6.1384102974940929E-2</c:v>
                  </c:pt>
                  <c:pt idx="1">
                    <c:v>4.7302649876504073E-2</c:v>
                  </c:pt>
                  <c:pt idx="2">
                    <c:v>6.7106610568918645E-2</c:v>
                  </c:pt>
                </c:numCache>
              </c:numRef>
            </c:minus>
            <c:spPr>
              <a:ln w="12700"/>
            </c:spPr>
          </c:errBars>
          <c:cat>
            <c:strRef>
              <c:f>RF合成系!$B$21:$B$23</c:f>
              <c:strCache>
                <c:ptCount val="3"/>
                <c:pt idx="0">
                  <c:v>0h</c:v>
                </c:pt>
                <c:pt idx="1">
                  <c:v>3h</c:v>
                </c:pt>
                <c:pt idx="2">
                  <c:v>6h</c:v>
                </c:pt>
              </c:strCache>
            </c:strRef>
          </c:cat>
          <c:val>
            <c:numRef>
              <c:f>RF合成系!$V$21:$V$23</c:f>
              <c:numCache>
                <c:formatCode>General</c:formatCode>
                <c:ptCount val="3"/>
                <c:pt idx="0">
                  <c:v>0.85009742198897509</c:v>
                </c:pt>
                <c:pt idx="1">
                  <c:v>0.74580400066579855</c:v>
                </c:pt>
                <c:pt idx="2">
                  <c:v>0.861523699489880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BA0-4249-9D98-5EED1AF805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23992015"/>
        <c:axId val="1620972799"/>
      </c:barChart>
      <c:catAx>
        <c:axId val="1623992015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20972799"/>
        <c:crosses val="autoZero"/>
        <c:auto val="1"/>
        <c:lblAlgn val="ctr"/>
        <c:lblOffset val="100"/>
        <c:noMultiLvlLbl val="0"/>
      </c:catAx>
      <c:valAx>
        <c:axId val="1620972799"/>
        <c:scaling>
          <c:orientation val="minMax"/>
          <c:max val="1.5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Meiryo" panose="020B0604030504040204" pitchFamily="34" charset="-128"/>
                <a:cs typeface="+mn-cs"/>
              </a:defRPr>
            </a:pPr>
            <a:endParaRPr lang="ja-JP"/>
          </a:p>
        </c:txPr>
        <c:crossAx val="1623992015"/>
        <c:crosses val="autoZero"/>
        <c:crossBetween val="between"/>
      </c:valAx>
      <c:spPr>
        <a:noFill/>
        <a:ln w="19050">
          <a:solidFill>
            <a:schemeClr val="tx1"/>
          </a:solidFill>
        </a:ln>
      </c:spPr>
    </c:plotArea>
    <c:plotVisOnly val="1"/>
    <c:dispBlanksAs val="gap"/>
    <c:showDLblsOverMax val="0"/>
    <c:extLst/>
  </c:chart>
  <c:spPr>
    <a:noFill/>
    <a:ln>
      <a:noFill/>
    </a:ln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1" u="none" strike="noStrike" kern="1200" spc="0" baseline="0">
                <a:solidFill>
                  <a:schemeClr val="tx1"/>
                </a:solidFill>
                <a:latin typeface="Helvetica" pitchFamily="2" charset="0"/>
                <a:ea typeface="Meiryo" panose="020B0604030504040204" pitchFamily="34" charset="-128"/>
                <a:cs typeface="+mn-cs"/>
              </a:defRPr>
            </a:pPr>
            <a:r>
              <a:rPr lang="en-US" altLang="ja-JP" sz="1100" i="1" dirty="0">
                <a:solidFill>
                  <a:schemeClr val="tx1"/>
                </a:solidFill>
                <a:latin typeface="Helvetica" pitchFamily="2" charset="0"/>
                <a:ea typeface="Meiryo" panose="020B0604030504040204" pitchFamily="34" charset="-128"/>
              </a:rPr>
              <a:t>LS</a:t>
            </a:r>
            <a:endParaRPr lang="ja-JP" altLang="en-US" sz="1100" i="1">
              <a:solidFill>
                <a:schemeClr val="tx1"/>
              </a:solidFill>
              <a:latin typeface="Helvetica" pitchFamily="2" charset="0"/>
              <a:ea typeface="Meiryo" panose="020B0604030504040204" pitchFamily="34" charset="-128"/>
            </a:endParaRPr>
          </a:p>
        </c:rich>
      </c:tx>
      <c:layout>
        <c:manualLayout>
          <c:xMode val="edge"/>
          <c:yMode val="edge"/>
          <c:x val="0.19973738597502755"/>
          <c:y val="7.3834997637370475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7393314895800654"/>
          <c:y val="5.2085456944491633E-2"/>
          <c:w val="0.79162199065619554"/>
          <c:h val="0.81457087481453794"/>
        </c:manualLayout>
      </c:layout>
      <c:barChart>
        <c:barDir val="col"/>
        <c:grouping val="clustered"/>
        <c:varyColors val="0"/>
        <c:ser>
          <c:idx val="1"/>
          <c:order val="0"/>
          <c:tx>
            <c:v>WT</c:v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RF合成系!$W$26:$W$28</c:f>
                <c:numCache>
                  <c:formatCode>General</c:formatCode>
                  <c:ptCount val="3"/>
                  <c:pt idx="0">
                    <c:v>6.1035163768197599E-2</c:v>
                  </c:pt>
                  <c:pt idx="1">
                    <c:v>7.1122757978394097E-2</c:v>
                  </c:pt>
                  <c:pt idx="2">
                    <c:v>0.12745516082516861</c:v>
                  </c:pt>
                </c:numCache>
              </c:numRef>
            </c:plus>
            <c:minus>
              <c:numRef>
                <c:f>RF合成系!$W$26:$W$28</c:f>
                <c:numCache>
                  <c:formatCode>General</c:formatCode>
                  <c:ptCount val="3"/>
                  <c:pt idx="0">
                    <c:v>6.1035163768197599E-2</c:v>
                  </c:pt>
                  <c:pt idx="1">
                    <c:v>7.1122757978394097E-2</c:v>
                  </c:pt>
                  <c:pt idx="2">
                    <c:v>0.12745516082516861</c:v>
                  </c:pt>
                </c:numCache>
              </c:numRef>
            </c:minus>
            <c:spPr>
              <a:ln w="12700"/>
            </c:spPr>
          </c:errBars>
          <c:cat>
            <c:strRef>
              <c:f>RF合成系!$B$2:$B$4</c:f>
              <c:strCache>
                <c:ptCount val="3"/>
                <c:pt idx="0">
                  <c:v>0h</c:v>
                </c:pt>
                <c:pt idx="1">
                  <c:v>3h</c:v>
                </c:pt>
                <c:pt idx="2">
                  <c:v>6h</c:v>
                </c:pt>
              </c:strCache>
            </c:strRef>
          </c:cat>
          <c:val>
            <c:numRef>
              <c:f>RF合成系!$V$2:$V$4</c:f>
              <c:numCache>
                <c:formatCode>General</c:formatCode>
                <c:ptCount val="3"/>
                <c:pt idx="0">
                  <c:v>1</c:v>
                </c:pt>
                <c:pt idx="1">
                  <c:v>1.6764308371259133</c:v>
                </c:pt>
                <c:pt idx="2">
                  <c:v>1.68252654806233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573-2E44-9D52-B0527FF4B2CE}"/>
            </c:ext>
          </c:extLst>
        </c:ser>
        <c:ser>
          <c:idx val="0"/>
          <c:order val="1"/>
          <c:tx>
            <c:v>frtf19.1</c:v>
          </c:tx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F合成系!$W$29:$W$31</c:f>
                <c:numCache>
                  <c:formatCode>General</c:formatCode>
                  <c:ptCount val="3"/>
                  <c:pt idx="0">
                    <c:v>9.8525229048429364E-2</c:v>
                  </c:pt>
                  <c:pt idx="1">
                    <c:v>0.11451668064409011</c:v>
                  </c:pt>
                  <c:pt idx="2">
                    <c:v>0.19773783709408241</c:v>
                  </c:pt>
                </c:numCache>
              </c:numRef>
            </c:plus>
            <c:minus>
              <c:numRef>
                <c:f>RF合成系!$W$29:$W$31</c:f>
                <c:numCache>
                  <c:formatCode>General</c:formatCode>
                  <c:ptCount val="3"/>
                  <c:pt idx="0">
                    <c:v>9.8525229048429364E-2</c:v>
                  </c:pt>
                  <c:pt idx="1">
                    <c:v>0.11451668064409011</c:v>
                  </c:pt>
                  <c:pt idx="2">
                    <c:v>0.19773783709408241</c:v>
                  </c:pt>
                </c:numCache>
              </c:numRef>
            </c:minus>
            <c:spPr>
              <a:ln w="12700"/>
            </c:spPr>
          </c:errBars>
          <c:cat>
            <c:strRef>
              <c:f>RF合成系!$B$5:$B$7</c:f>
              <c:strCache>
                <c:ptCount val="3"/>
                <c:pt idx="0">
                  <c:v>0h</c:v>
                </c:pt>
                <c:pt idx="1">
                  <c:v>3h</c:v>
                </c:pt>
                <c:pt idx="2">
                  <c:v>6h</c:v>
                </c:pt>
              </c:strCache>
            </c:strRef>
          </c:cat>
          <c:val>
            <c:numRef>
              <c:f>RF合成系!$V$5:$V$7</c:f>
              <c:numCache>
                <c:formatCode>General</c:formatCode>
                <c:ptCount val="3"/>
                <c:pt idx="0">
                  <c:v>0.98165770238587768</c:v>
                </c:pt>
                <c:pt idx="1">
                  <c:v>1.6330850917114879</c:v>
                </c:pt>
                <c:pt idx="2">
                  <c:v>1.96965935733002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573-2E44-9D52-B0527FF4B2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8751743"/>
        <c:axId val="1641386127"/>
      </c:barChart>
      <c:catAx>
        <c:axId val="1558751743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41386127"/>
        <c:crosses val="autoZero"/>
        <c:auto val="1"/>
        <c:lblAlgn val="ctr"/>
        <c:lblOffset val="100"/>
        <c:noMultiLvlLbl val="0"/>
      </c:catAx>
      <c:valAx>
        <c:axId val="1641386127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Meiryo" panose="020B0604030504040204" pitchFamily="34" charset="-128"/>
                <a:cs typeface="+mn-cs"/>
              </a:defRPr>
            </a:pPr>
            <a:endParaRPr lang="ja-JP"/>
          </a:p>
        </c:txPr>
        <c:crossAx val="1558751743"/>
        <c:crosses val="autoZero"/>
        <c:crossBetween val="between"/>
      </c:valAx>
      <c:spPr>
        <a:noFill/>
        <a:ln w="19050">
          <a:solidFill>
            <a:schemeClr val="tx1"/>
          </a:solidFill>
        </a:ln>
      </c:spPr>
    </c:plotArea>
    <c:plotVisOnly val="1"/>
    <c:dispBlanksAs val="gap"/>
    <c:showDLblsOverMax val="0"/>
    <c:extLst/>
  </c:chart>
  <c:spPr>
    <a:noFill/>
    <a:ln>
      <a:noFill/>
    </a:ln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735247279483322"/>
          <c:y val="3.6783245156158918E-2"/>
          <c:w val="0.82216949154794239"/>
          <c:h val="0.85780558516262062"/>
        </c:manualLayout>
      </c:layout>
      <c:barChart>
        <c:barDir val="col"/>
        <c:grouping val="clustered"/>
        <c:varyColors val="0"/>
        <c:ser>
          <c:idx val="1"/>
          <c:order val="0"/>
          <c:tx>
            <c:v>WT</c:v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AB$3:$AB$5</c:f>
                <c:numCache>
                  <c:formatCode>General</c:formatCode>
                  <c:ptCount val="3"/>
                  <c:pt idx="0">
                    <c:v>1.224365441876951E-2</c:v>
                  </c:pt>
                  <c:pt idx="1">
                    <c:v>1.0383120121851582E-2</c:v>
                  </c:pt>
                  <c:pt idx="2">
                    <c:v>7.0560372434438669E-3</c:v>
                  </c:pt>
                </c:numCache>
              </c:numRef>
            </c:plus>
            <c:minus>
              <c:numRef>
                <c:f>Sheet1!$AB$3:$AB$5</c:f>
                <c:numCache>
                  <c:formatCode>General</c:formatCode>
                  <c:ptCount val="3"/>
                  <c:pt idx="0">
                    <c:v>1.224365441876951E-2</c:v>
                  </c:pt>
                  <c:pt idx="1">
                    <c:v>1.0383120121851582E-2</c:v>
                  </c:pt>
                  <c:pt idx="2">
                    <c:v>7.0560372434438669E-3</c:v>
                  </c:pt>
                </c:numCache>
              </c:numRef>
            </c:minus>
            <c:spPr>
              <a:ln w="12700"/>
            </c:spPr>
          </c:errBars>
          <c:cat>
            <c:strRef>
              <c:f>Sheet1!$A$3:$A$5</c:f>
              <c:strCache>
                <c:ptCount val="3"/>
                <c:pt idx="0">
                  <c:v>0h</c:v>
                </c:pt>
                <c:pt idx="1">
                  <c:v>3h</c:v>
                </c:pt>
                <c:pt idx="2">
                  <c:v>6h</c:v>
                </c:pt>
              </c:strCache>
            </c:strRef>
          </c:cat>
          <c:val>
            <c:numRef>
              <c:f>Sheet1!$Z$3:$Z$5</c:f>
              <c:numCache>
                <c:formatCode>General</c:formatCode>
                <c:ptCount val="3"/>
                <c:pt idx="0">
                  <c:v>0.14699753465614768</c:v>
                </c:pt>
                <c:pt idx="1">
                  <c:v>0.12006069946285575</c:v>
                </c:pt>
                <c:pt idx="2">
                  <c:v>0.10657390515087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282-064F-8892-E53CD0E607E2}"/>
            </c:ext>
          </c:extLst>
        </c:ser>
        <c:ser>
          <c:idx val="0"/>
          <c:order val="1"/>
          <c:tx>
            <c:v>frtf19.1</c:v>
          </c:tx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B$7:$AB$9</c:f>
                <c:numCache>
                  <c:formatCode>General</c:formatCode>
                  <c:ptCount val="3"/>
                  <c:pt idx="0">
                    <c:v>1.0330181191398689E-2</c:v>
                  </c:pt>
                  <c:pt idx="1">
                    <c:v>1.0397559184625052E-2</c:v>
                  </c:pt>
                  <c:pt idx="2">
                    <c:v>8.1132307451438433E-3</c:v>
                  </c:pt>
                </c:numCache>
              </c:numRef>
            </c:plus>
            <c:minus>
              <c:numRef>
                <c:f>Sheet1!$AB$7:$AB$9</c:f>
                <c:numCache>
                  <c:formatCode>General</c:formatCode>
                  <c:ptCount val="3"/>
                  <c:pt idx="0">
                    <c:v>1.0330181191398689E-2</c:v>
                  </c:pt>
                  <c:pt idx="1">
                    <c:v>1.0397559184625052E-2</c:v>
                  </c:pt>
                  <c:pt idx="2">
                    <c:v>8.1132307451438433E-3</c:v>
                  </c:pt>
                </c:numCache>
              </c:numRef>
            </c:minus>
          </c:errBars>
          <c:cat>
            <c:strRef>
              <c:f>Sheet1!$A$7:$A$9</c:f>
              <c:strCache>
                <c:ptCount val="3"/>
                <c:pt idx="0">
                  <c:v>0h</c:v>
                </c:pt>
                <c:pt idx="1">
                  <c:v>3h</c:v>
                </c:pt>
                <c:pt idx="2">
                  <c:v>6h</c:v>
                </c:pt>
              </c:strCache>
            </c:strRef>
          </c:cat>
          <c:val>
            <c:numRef>
              <c:f>Sheet1!$Z$7:$Z$9</c:f>
              <c:numCache>
                <c:formatCode>General</c:formatCode>
                <c:ptCount val="3"/>
                <c:pt idx="0">
                  <c:v>8.4412856388177651E-2</c:v>
                </c:pt>
                <c:pt idx="1">
                  <c:v>7.2419068561199243E-2</c:v>
                </c:pt>
                <c:pt idx="2">
                  <c:v>6.526733370962918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282-064F-8892-E53CD0E607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0149231"/>
        <c:axId val="214554351"/>
      </c:barChart>
      <c:catAx>
        <c:axId val="160149231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14554351"/>
        <c:crosses val="autoZero"/>
        <c:auto val="1"/>
        <c:lblAlgn val="ctr"/>
        <c:lblOffset val="100"/>
        <c:noMultiLvlLbl val="0"/>
      </c:catAx>
      <c:valAx>
        <c:axId val="214554351"/>
        <c:scaling>
          <c:orientation val="minMax"/>
          <c:max val="0.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Meiryo" panose="020B0604030504040204" pitchFamily="34" charset="-128"/>
                <a:cs typeface="+mn-cs"/>
              </a:defRPr>
            </a:pPr>
            <a:endParaRPr lang="ja-JP"/>
          </a:p>
        </c:txPr>
        <c:crossAx val="160149231"/>
        <c:crosses val="autoZero"/>
        <c:crossBetween val="between"/>
        <c:majorUnit val="5.000000000000001E-2"/>
      </c:valAx>
      <c:spPr>
        <a:noFill/>
        <a:ln w="19050">
          <a:solidFill>
            <a:schemeClr val="tx1"/>
          </a:solidFill>
        </a:ln>
      </c:spPr>
    </c:plotArea>
    <c:plotVisOnly val="1"/>
    <c:dispBlanksAs val="gap"/>
    <c:showDLblsOverMax val="0"/>
    <c:extLst/>
  </c:chart>
  <c:spPr>
    <a:noFill/>
    <a:ln>
      <a:noFill/>
    </a:ln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3913053121880887E-2"/>
          <c:y val="2.4929621307776734E-2"/>
          <c:w val="0.82464121214608599"/>
          <c:h val="0.85907862477191355"/>
        </c:manualLayout>
      </c:layout>
      <c:barChart>
        <c:barDir val="col"/>
        <c:grouping val="clustered"/>
        <c:varyColors val="0"/>
        <c:ser>
          <c:idx val="1"/>
          <c:order val="0"/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AB$13:$AB$15</c:f>
                <c:numCache>
                  <c:formatCode>General</c:formatCode>
                  <c:ptCount val="3"/>
                  <c:pt idx="0">
                    <c:v>0.11038491228174867</c:v>
                  </c:pt>
                  <c:pt idx="1">
                    <c:v>8.6740722277351412E-2</c:v>
                  </c:pt>
                  <c:pt idx="2">
                    <c:v>7.6283332947327517E-2</c:v>
                  </c:pt>
                </c:numCache>
              </c:numRef>
            </c:plus>
            <c:minus>
              <c:numRef>
                <c:f>Sheet1!$AB$13:$AB$15</c:f>
                <c:numCache>
                  <c:formatCode>General</c:formatCode>
                  <c:ptCount val="3"/>
                  <c:pt idx="0">
                    <c:v>0.11038491228174867</c:v>
                  </c:pt>
                  <c:pt idx="1">
                    <c:v>8.6740722277351412E-2</c:v>
                  </c:pt>
                  <c:pt idx="2">
                    <c:v>7.6283332947327517E-2</c:v>
                  </c:pt>
                </c:numCache>
              </c:numRef>
            </c:minus>
            <c:spPr>
              <a:ln w="12700"/>
            </c:spPr>
          </c:errBars>
          <c:cat>
            <c:strRef>
              <c:f>Sheet1!$A$13:$A$15</c:f>
              <c:strCache>
                <c:ptCount val="3"/>
                <c:pt idx="0">
                  <c:v>0h</c:v>
                </c:pt>
                <c:pt idx="1">
                  <c:v>3h</c:v>
                </c:pt>
                <c:pt idx="2">
                  <c:v>6h</c:v>
                </c:pt>
              </c:strCache>
            </c:strRef>
          </c:cat>
          <c:val>
            <c:numRef>
              <c:f>Sheet1!$Z$13:$Z$15</c:f>
              <c:numCache>
                <c:formatCode>General</c:formatCode>
                <c:ptCount val="3"/>
                <c:pt idx="0">
                  <c:v>3.6233347707266894</c:v>
                </c:pt>
                <c:pt idx="1">
                  <c:v>3.4782339150182553</c:v>
                </c:pt>
                <c:pt idx="2">
                  <c:v>3.2625863994408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E00-8A46-9D44-4DFFCB2551DF}"/>
            </c:ext>
          </c:extLst>
        </c:ser>
        <c:ser>
          <c:idx val="0"/>
          <c:order val="1"/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B$7:$AB$9</c:f>
                <c:numCache>
                  <c:formatCode>General</c:formatCode>
                  <c:ptCount val="3"/>
                  <c:pt idx="0">
                    <c:v>1.0330181191398689E-2</c:v>
                  </c:pt>
                  <c:pt idx="1">
                    <c:v>1.0397559184625052E-2</c:v>
                  </c:pt>
                  <c:pt idx="2">
                    <c:v>8.1132307451438433E-3</c:v>
                  </c:pt>
                </c:numCache>
              </c:numRef>
            </c:plus>
            <c:minus>
              <c:numRef>
                <c:f>Sheet1!$AB$7:$AB$9</c:f>
                <c:numCache>
                  <c:formatCode>General</c:formatCode>
                  <c:ptCount val="3"/>
                  <c:pt idx="0">
                    <c:v>1.0330181191398689E-2</c:v>
                  </c:pt>
                  <c:pt idx="1">
                    <c:v>1.0397559184625052E-2</c:v>
                  </c:pt>
                  <c:pt idx="2">
                    <c:v>8.1132307451438433E-3</c:v>
                  </c:pt>
                </c:numCache>
              </c:numRef>
            </c:minus>
            <c:spPr>
              <a:ln w="12700"/>
            </c:spPr>
          </c:errBars>
          <c:cat>
            <c:strRef>
              <c:f>Sheet1!$A$17:$A$19</c:f>
              <c:strCache>
                <c:ptCount val="3"/>
                <c:pt idx="0">
                  <c:v>0h</c:v>
                </c:pt>
                <c:pt idx="1">
                  <c:v>3h</c:v>
                </c:pt>
                <c:pt idx="2">
                  <c:v>6h</c:v>
                </c:pt>
              </c:strCache>
            </c:strRef>
          </c:cat>
          <c:val>
            <c:numRef>
              <c:f>Sheet1!$Z$17:$Z$19</c:f>
              <c:numCache>
                <c:formatCode>General</c:formatCode>
                <c:ptCount val="3"/>
                <c:pt idx="0">
                  <c:v>2.2494953133598492</c:v>
                </c:pt>
                <c:pt idx="1">
                  <c:v>2.1962130616746234</c:v>
                </c:pt>
                <c:pt idx="2">
                  <c:v>2.28160008027970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E00-8A46-9D44-4DFFCB2551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55668927"/>
        <c:axId val="257479311"/>
      </c:barChart>
      <c:catAx>
        <c:axId val="255668927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57479311"/>
        <c:crosses val="autoZero"/>
        <c:auto val="1"/>
        <c:lblAlgn val="ctr"/>
        <c:lblOffset val="100"/>
        <c:noMultiLvlLbl val="0"/>
      </c:catAx>
      <c:valAx>
        <c:axId val="257479311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255668927"/>
        <c:crosses val="autoZero"/>
        <c:crossBetween val="between"/>
      </c:valAx>
      <c:spPr>
        <a:noFill/>
        <a:ln w="19050">
          <a:solidFill>
            <a:schemeClr val="tx1"/>
          </a:solidFill>
        </a:ln>
      </c:spPr>
    </c:plotArea>
    <c:plotVisOnly val="1"/>
    <c:dispBlanksAs val="gap"/>
    <c:showDLblsOverMax val="0"/>
    <c:extLst/>
  </c:chart>
  <c:spPr>
    <a:noFill/>
    <a:ln>
      <a:noFill/>
    </a:ln>
  </c:spPr>
  <c:txPr>
    <a:bodyPr/>
    <a:lstStyle/>
    <a:p>
      <a:pPr>
        <a:defRPr sz="900">
          <a:latin typeface="Helvetica" pitchFamily="2" charset="0"/>
        </a:defRPr>
      </a:pPr>
      <a:endParaRPr lang="ja-JP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2.8510773513656197E-2"/>
          <c:w val="0.88298053934200316"/>
          <c:h val="0.88936641231678404"/>
        </c:manualLayout>
      </c:layout>
      <c:barChart>
        <c:barDir val="col"/>
        <c:grouping val="clustered"/>
        <c:varyColors val="0"/>
        <c:ser>
          <c:idx val="1"/>
          <c:order val="0"/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AB$23:$AB$25</c:f>
                <c:numCache>
                  <c:formatCode>General</c:formatCode>
                  <c:ptCount val="3"/>
                  <c:pt idx="0">
                    <c:v>9.0640328996086053E-2</c:v>
                  </c:pt>
                  <c:pt idx="1">
                    <c:v>6.6256423536828007E-2</c:v>
                  </c:pt>
                  <c:pt idx="2">
                    <c:v>8.4392142621892458E-2</c:v>
                  </c:pt>
                </c:numCache>
              </c:numRef>
            </c:plus>
            <c:minus>
              <c:numRef>
                <c:f>Sheet1!$AB$23:$AB$25</c:f>
                <c:numCache>
                  <c:formatCode>General</c:formatCode>
                  <c:ptCount val="3"/>
                  <c:pt idx="0">
                    <c:v>9.0640328996086053E-2</c:v>
                  </c:pt>
                  <c:pt idx="1">
                    <c:v>6.6256423536828007E-2</c:v>
                  </c:pt>
                  <c:pt idx="2">
                    <c:v>8.4392142621892458E-2</c:v>
                  </c:pt>
                </c:numCache>
              </c:numRef>
            </c:minus>
            <c:spPr>
              <a:ln w="12700"/>
            </c:spPr>
          </c:errBars>
          <c:cat>
            <c:strRef>
              <c:f>Sheet1!$A$23:$A$25</c:f>
              <c:strCache>
                <c:ptCount val="3"/>
                <c:pt idx="0">
                  <c:v>0h</c:v>
                </c:pt>
                <c:pt idx="1">
                  <c:v>3h</c:v>
                </c:pt>
                <c:pt idx="2">
                  <c:v>6h</c:v>
                </c:pt>
              </c:strCache>
            </c:strRef>
          </c:cat>
          <c:val>
            <c:numRef>
              <c:f>Sheet1!$Z$23:$Z$25</c:f>
              <c:numCache>
                <c:formatCode>General</c:formatCode>
                <c:ptCount val="3"/>
                <c:pt idx="0">
                  <c:v>4.3308521493188783</c:v>
                </c:pt>
                <c:pt idx="1">
                  <c:v>3.8841208554796638</c:v>
                </c:pt>
                <c:pt idx="2">
                  <c:v>3.5474886729092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6AD-0F4E-B6CC-C8A95F43E2F2}"/>
            </c:ext>
          </c:extLst>
        </c:ser>
        <c:ser>
          <c:idx val="0"/>
          <c:order val="1"/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B$27:$AB$29</c:f>
                <c:numCache>
                  <c:formatCode>General</c:formatCode>
                  <c:ptCount val="3"/>
                  <c:pt idx="0">
                    <c:v>0.13550829173283233</c:v>
                  </c:pt>
                  <c:pt idx="1">
                    <c:v>8.6722669137025796E-2</c:v>
                  </c:pt>
                  <c:pt idx="2">
                    <c:v>9.5737441096684195E-2</c:v>
                  </c:pt>
                </c:numCache>
              </c:numRef>
            </c:plus>
            <c:minus>
              <c:numRef>
                <c:f>Sheet1!$AB$27:$AB$29</c:f>
                <c:numCache>
                  <c:formatCode>General</c:formatCode>
                  <c:ptCount val="3"/>
                  <c:pt idx="0">
                    <c:v>0.13550829173283233</c:v>
                  </c:pt>
                  <c:pt idx="1">
                    <c:v>8.6722669137025796E-2</c:v>
                  </c:pt>
                  <c:pt idx="2">
                    <c:v>9.5737441096684195E-2</c:v>
                  </c:pt>
                </c:numCache>
              </c:numRef>
            </c:minus>
            <c:spPr>
              <a:ln w="12700"/>
            </c:spPr>
          </c:errBars>
          <c:cat>
            <c:strRef>
              <c:f>Sheet1!$A$27:$A$29</c:f>
              <c:strCache>
                <c:ptCount val="3"/>
                <c:pt idx="0">
                  <c:v>0h</c:v>
                </c:pt>
                <c:pt idx="1">
                  <c:v>3h</c:v>
                </c:pt>
                <c:pt idx="2">
                  <c:v>6h</c:v>
                </c:pt>
              </c:strCache>
            </c:strRef>
          </c:cat>
          <c:val>
            <c:numRef>
              <c:f>Sheet1!$Z$27:$Z$29</c:f>
              <c:numCache>
                <c:formatCode>General</c:formatCode>
                <c:ptCount val="3"/>
                <c:pt idx="0">
                  <c:v>4.0612661430158825</c:v>
                </c:pt>
                <c:pt idx="1">
                  <c:v>3.9424115007498406</c:v>
                </c:pt>
                <c:pt idx="2">
                  <c:v>3.70662439060883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6AD-0F4E-B6CC-C8A95F43E2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52455887"/>
        <c:axId val="252192127"/>
      </c:barChart>
      <c:catAx>
        <c:axId val="252455887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52192127"/>
        <c:crosses val="autoZero"/>
        <c:auto val="1"/>
        <c:lblAlgn val="ctr"/>
        <c:lblOffset val="100"/>
        <c:noMultiLvlLbl val="0"/>
      </c:catAx>
      <c:valAx>
        <c:axId val="252192127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Meiryo" panose="020B0604030504040204" pitchFamily="34" charset="-128"/>
                <a:cs typeface="+mn-cs"/>
              </a:defRPr>
            </a:pPr>
            <a:endParaRPr lang="ja-JP"/>
          </a:p>
        </c:txPr>
        <c:crossAx val="252455887"/>
        <c:crosses val="autoZero"/>
        <c:crossBetween val="between"/>
      </c:valAx>
      <c:spPr>
        <a:noFill/>
        <a:ln w="19050">
          <a:solidFill>
            <a:schemeClr val="tx1"/>
          </a:solidFill>
        </a:ln>
      </c:spPr>
    </c:plotArea>
    <c:plotVisOnly val="1"/>
    <c:dispBlanksAs val="gap"/>
    <c:showDLblsOverMax val="0"/>
    <c:extLst/>
  </c:chart>
  <c:spPr>
    <a:noFill/>
    <a:ln>
      <a:noFill/>
    </a:ln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2EA9F-2D06-BB4B-9E82-6D80B0D2FA1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4249-94AD-F94F-B252-5E2125DEA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0980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2EA9F-2D06-BB4B-9E82-6D80B0D2FA1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4249-94AD-F94F-B252-5E2125DEA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1963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2EA9F-2D06-BB4B-9E82-6D80B0D2FA1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4249-94AD-F94F-B252-5E2125DEA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9384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2EA9F-2D06-BB4B-9E82-6D80B0D2FA1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4249-94AD-F94F-B252-5E2125DEA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1001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2EA9F-2D06-BB4B-9E82-6D80B0D2FA1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4249-94AD-F94F-B252-5E2125DEA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5181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2EA9F-2D06-BB4B-9E82-6D80B0D2FA1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4249-94AD-F94F-B252-5E2125DEA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3458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2EA9F-2D06-BB4B-9E82-6D80B0D2FA1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4249-94AD-F94F-B252-5E2125DEA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62848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2EA9F-2D06-BB4B-9E82-6D80B0D2FA1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4249-94AD-F94F-B252-5E2125DEA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57143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2EA9F-2D06-BB4B-9E82-6D80B0D2FA1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4249-94AD-F94F-B252-5E2125DEA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31461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2EA9F-2D06-BB4B-9E82-6D80B0D2FA1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4249-94AD-F94F-B252-5E2125DEA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88798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2EA9F-2D06-BB4B-9E82-6D80B0D2FA1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4249-94AD-F94F-B252-5E2125DEA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7382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32EA9F-2D06-BB4B-9E82-6D80B0D2FA11}" type="datetimeFigureOut">
              <a:rPr kumimoji="1" lang="ja-JP" altLang="en-US" smtClean="0"/>
              <a:t>2023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DC4249-94AD-F94F-B252-5E2125DEA6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4606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8.xml"/><Relationship Id="rId3" Type="http://schemas.openxmlformats.org/officeDocument/2006/relationships/chart" Target="../charts/chart3.xml"/><Relationship Id="rId7" Type="http://schemas.openxmlformats.org/officeDocument/2006/relationships/chart" Target="../charts/chart7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6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CFBA634-5E03-9D4A-BFD8-FA17870B802A}"/>
              </a:ext>
            </a:extLst>
          </p:cNvPr>
          <p:cNvSpPr txBox="1"/>
          <p:nvPr/>
        </p:nvSpPr>
        <p:spPr>
          <a:xfrm rot="16200000">
            <a:off x="-840076" y="1542055"/>
            <a:ext cx="2103461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dirty="0">
                <a:latin typeface="Helvetica" pitchFamily="2" charset="0"/>
              </a:rPr>
              <a:t>Flavin content (fold change %)</a:t>
            </a:r>
            <a:endParaRPr kumimoji="1" lang="ja-JP" altLang="en-US" sz="1108">
              <a:latin typeface="Helvetica" pitchFamily="2" charset="0"/>
            </a:endParaRPr>
          </a:p>
        </p:txBody>
      </p:sp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8DD107E9-0CA3-6542-AE59-F8EC856B394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18190" y="460595"/>
          <a:ext cx="7957146" cy="2820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0C5DC26-37AF-0445-BEC2-5140DCA1B2B2}"/>
              </a:ext>
            </a:extLst>
          </p:cNvPr>
          <p:cNvSpPr txBox="1"/>
          <p:nvPr/>
        </p:nvSpPr>
        <p:spPr>
          <a:xfrm>
            <a:off x="7989574" y="2017780"/>
            <a:ext cx="287258" cy="2485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15" dirty="0">
                <a:latin typeface="Helvetica" pitchFamily="2" charset="0"/>
              </a:rPr>
              <a:t>**</a:t>
            </a:r>
            <a:endParaRPr kumimoji="1" lang="ja-JP" altLang="en-US" sz="1015">
              <a:latin typeface="Helvetica" pitchFamily="2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583CE59-A6A6-9A41-9910-F472F44CC81A}"/>
              </a:ext>
            </a:extLst>
          </p:cNvPr>
          <p:cNvSpPr txBox="1"/>
          <p:nvPr/>
        </p:nvSpPr>
        <p:spPr>
          <a:xfrm>
            <a:off x="7902494" y="1942940"/>
            <a:ext cx="287258" cy="2485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15" dirty="0">
                <a:latin typeface="Helvetica" pitchFamily="2" charset="0"/>
              </a:rPr>
              <a:t>**</a:t>
            </a:r>
            <a:endParaRPr kumimoji="1" lang="ja-JP" altLang="en-US" sz="1015">
              <a:latin typeface="Helvetica" pitchFamily="2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9FFB43A-72AF-CE16-A476-42BFED36230A}"/>
              </a:ext>
            </a:extLst>
          </p:cNvPr>
          <p:cNvSpPr txBox="1"/>
          <p:nvPr/>
        </p:nvSpPr>
        <p:spPr>
          <a:xfrm>
            <a:off x="4965019" y="1707885"/>
            <a:ext cx="235962" cy="2485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15" dirty="0">
                <a:latin typeface="Helvetica" pitchFamily="2" charset="0"/>
              </a:rPr>
              <a:t>*</a:t>
            </a:r>
            <a:endParaRPr kumimoji="1" lang="ja-JP" altLang="en-US" sz="1015">
              <a:latin typeface="Helvetica" pitchFamily="2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46085FF-5CA5-7BBA-9CDE-6D554B7A337E}"/>
              </a:ext>
            </a:extLst>
          </p:cNvPr>
          <p:cNvSpPr txBox="1"/>
          <p:nvPr/>
        </p:nvSpPr>
        <p:spPr>
          <a:xfrm>
            <a:off x="6106788" y="1828934"/>
            <a:ext cx="235962" cy="2485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15" dirty="0">
                <a:latin typeface="Helvetica" pitchFamily="2" charset="0"/>
              </a:rPr>
              <a:t>*</a:t>
            </a:r>
            <a:endParaRPr kumimoji="1" lang="ja-JP" altLang="en-US" sz="1015">
              <a:latin typeface="Helvetica" pitchFamily="2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1838C16-4619-98E7-2450-AB9F1DBCB4E7}"/>
              </a:ext>
            </a:extLst>
          </p:cNvPr>
          <p:cNvSpPr txBox="1"/>
          <p:nvPr/>
        </p:nvSpPr>
        <p:spPr>
          <a:xfrm>
            <a:off x="4507001" y="1740089"/>
            <a:ext cx="235962" cy="2485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15" dirty="0">
                <a:latin typeface="Helvetica" pitchFamily="2" charset="0"/>
              </a:rPr>
              <a:t>*</a:t>
            </a:r>
            <a:endParaRPr kumimoji="1" lang="ja-JP" altLang="en-US" sz="1015">
              <a:latin typeface="Helvetica" pitchFamily="2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3B9A6AC-B3B7-D777-394F-8C7A1BA6E687}"/>
              </a:ext>
            </a:extLst>
          </p:cNvPr>
          <p:cNvSpPr txBox="1"/>
          <p:nvPr/>
        </p:nvSpPr>
        <p:spPr>
          <a:xfrm>
            <a:off x="600320" y="3148798"/>
            <a:ext cx="405880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dirty="0">
                <a:latin typeface="Helvetica" pitchFamily="2" charset="0"/>
              </a:rPr>
              <a:t>WT</a:t>
            </a:r>
            <a:endParaRPr kumimoji="1" lang="ja-JP" altLang="en-US" sz="1108">
              <a:latin typeface="Helvetica" pitchFamily="2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2D59DEE-1A9E-3B4D-6DC2-225245B2719E}"/>
              </a:ext>
            </a:extLst>
          </p:cNvPr>
          <p:cNvSpPr txBox="1"/>
          <p:nvPr/>
        </p:nvSpPr>
        <p:spPr>
          <a:xfrm rot="2803245">
            <a:off x="795136" y="3733557"/>
            <a:ext cx="2020105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latin typeface="Helvetica" pitchFamily="2" charset="0"/>
              </a:rPr>
              <a:t>At3g18650 </a:t>
            </a:r>
            <a:r>
              <a:rPr kumimoji="1" lang="en-US" altLang="ja-JP" sz="1108" dirty="0">
                <a:latin typeface="Helvetica" pitchFamily="2" charset="0"/>
              </a:rPr>
              <a:t>(SALK_037779C)</a:t>
            </a:r>
            <a:endParaRPr kumimoji="1" lang="ja-JP" altLang="en-US" sz="1108" i="1">
              <a:latin typeface="Helvetica" pitchFamily="2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DBEE9C2-BFDC-B8DB-2185-BA8EA1EA93DA}"/>
              </a:ext>
            </a:extLst>
          </p:cNvPr>
          <p:cNvSpPr txBox="1"/>
          <p:nvPr/>
        </p:nvSpPr>
        <p:spPr>
          <a:xfrm rot="2803245">
            <a:off x="1187770" y="3710934"/>
            <a:ext cx="1957587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latin typeface="Helvetica" pitchFamily="2" charset="0"/>
              </a:rPr>
              <a:t>At5g23420 </a:t>
            </a:r>
            <a:r>
              <a:rPr kumimoji="1" lang="en-US" altLang="ja-JP" sz="1108" dirty="0">
                <a:latin typeface="Helvetica" pitchFamily="2" charset="0"/>
              </a:rPr>
              <a:t>(SALK_138632 )</a:t>
            </a:r>
            <a:endParaRPr kumimoji="1" lang="ja-JP" altLang="en-US" sz="1108" i="1">
              <a:latin typeface="Helvetica" pitchFamily="2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2FE69F9-3AB8-1756-5ADE-794A5367C8FE}"/>
              </a:ext>
            </a:extLst>
          </p:cNvPr>
          <p:cNvSpPr txBox="1"/>
          <p:nvPr/>
        </p:nvSpPr>
        <p:spPr>
          <a:xfrm rot="2803245">
            <a:off x="1536235" y="3733557"/>
            <a:ext cx="2020105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latin typeface="Helvetica" pitchFamily="2" charset="0"/>
              </a:rPr>
              <a:t>At1g32240 </a:t>
            </a:r>
            <a:r>
              <a:rPr kumimoji="1" lang="en-US" altLang="ja-JP" sz="1108" dirty="0">
                <a:latin typeface="Helvetica" pitchFamily="2" charset="0"/>
              </a:rPr>
              <a:t>(SALK_095643C)</a:t>
            </a:r>
            <a:endParaRPr kumimoji="1" lang="ja-JP" altLang="en-US" sz="1108">
              <a:latin typeface="Helvetica" pitchFamily="2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CCABF5D-B7F7-4FD3-A42B-9A753763F552}"/>
              </a:ext>
            </a:extLst>
          </p:cNvPr>
          <p:cNvSpPr txBox="1"/>
          <p:nvPr/>
        </p:nvSpPr>
        <p:spPr>
          <a:xfrm rot="2803245">
            <a:off x="1906785" y="3733557"/>
            <a:ext cx="2020105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latin typeface="Helvetica" pitchFamily="2" charset="0"/>
              </a:rPr>
              <a:t>At5g24120 </a:t>
            </a:r>
            <a:r>
              <a:rPr kumimoji="1" lang="en-US" altLang="ja-JP" sz="1108" dirty="0">
                <a:latin typeface="Helvetica" pitchFamily="2" charset="0"/>
              </a:rPr>
              <a:t>(SALK_141383C)</a:t>
            </a:r>
            <a:endParaRPr kumimoji="1" lang="ja-JP" altLang="en-US" sz="1108">
              <a:latin typeface="Helvetica" pitchFamily="2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8A69859-C4DC-8445-45C6-9FF31786BA8B}"/>
              </a:ext>
            </a:extLst>
          </p:cNvPr>
          <p:cNvSpPr txBox="1"/>
          <p:nvPr/>
        </p:nvSpPr>
        <p:spPr>
          <a:xfrm rot="2803245">
            <a:off x="2310282" y="3696392"/>
            <a:ext cx="1917513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latin typeface="Helvetica" pitchFamily="2" charset="0"/>
              </a:rPr>
              <a:t>At5g17300 </a:t>
            </a:r>
            <a:r>
              <a:rPr kumimoji="1" lang="en-US" altLang="ja-JP" sz="1108" dirty="0">
                <a:latin typeface="Helvetica" pitchFamily="2" charset="0"/>
              </a:rPr>
              <a:t>(SALK_057420)</a:t>
            </a:r>
            <a:endParaRPr kumimoji="1" lang="ja-JP" altLang="en-US" sz="1108" i="1">
              <a:latin typeface="Helvetica" pitchFamily="2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B8A38AA-B039-AB17-A4B7-29057109D80D}"/>
              </a:ext>
            </a:extLst>
          </p:cNvPr>
          <p:cNvSpPr txBox="1"/>
          <p:nvPr/>
        </p:nvSpPr>
        <p:spPr>
          <a:xfrm rot="2803245">
            <a:off x="2666234" y="3733557"/>
            <a:ext cx="2020105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latin typeface="Helvetica" pitchFamily="2" charset="0"/>
              </a:rPr>
              <a:t>At5g37260 </a:t>
            </a:r>
            <a:r>
              <a:rPr kumimoji="1" lang="en-US" altLang="ja-JP" sz="1108" dirty="0">
                <a:latin typeface="Helvetica" pitchFamily="2" charset="0"/>
              </a:rPr>
              <a:t>(SALK_074896C)</a:t>
            </a:r>
            <a:endParaRPr kumimoji="1" lang="ja-JP" altLang="en-US" sz="1108" i="1">
              <a:latin typeface="Helvetica" pitchFamily="2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107E0AE-495D-753C-9C96-84D4A8867D6B}"/>
              </a:ext>
            </a:extLst>
          </p:cNvPr>
          <p:cNvSpPr txBox="1"/>
          <p:nvPr/>
        </p:nvSpPr>
        <p:spPr>
          <a:xfrm rot="2803245">
            <a:off x="3035096" y="3748100"/>
            <a:ext cx="2060179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latin typeface="Helvetica" pitchFamily="2" charset="0"/>
              </a:rPr>
              <a:t>At4g26150 </a:t>
            </a:r>
            <a:r>
              <a:rPr kumimoji="1" lang="en-US" altLang="ja-JP" sz="1108" dirty="0">
                <a:latin typeface="Helvetica" pitchFamily="2" charset="0"/>
              </a:rPr>
              <a:t>(SALK_003995C )</a:t>
            </a:r>
            <a:endParaRPr kumimoji="1" lang="ja-JP" altLang="en-US" sz="1108">
              <a:latin typeface="Helvetica" pitchFamily="2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08A0117-7BC9-E2BE-1068-E1EE5F596A3D}"/>
              </a:ext>
            </a:extLst>
          </p:cNvPr>
          <p:cNvSpPr txBox="1"/>
          <p:nvPr/>
        </p:nvSpPr>
        <p:spPr>
          <a:xfrm rot="2803245">
            <a:off x="3425682" y="3733557"/>
            <a:ext cx="2020105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latin typeface="Helvetica" pitchFamily="2" charset="0"/>
              </a:rPr>
              <a:t>At5g56860 </a:t>
            </a:r>
            <a:r>
              <a:rPr kumimoji="1" lang="en-US" altLang="ja-JP" sz="1108" dirty="0">
                <a:latin typeface="Helvetica" pitchFamily="2" charset="0"/>
              </a:rPr>
              <a:t>(SALK_001778C)</a:t>
            </a:r>
            <a:endParaRPr kumimoji="1" lang="ja-JP" altLang="en-US" sz="1108" i="1">
              <a:latin typeface="Helvetica" pitchFamily="2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DE2EAE3-8294-2EE5-EAEA-0385D52830E5}"/>
              </a:ext>
            </a:extLst>
          </p:cNvPr>
          <p:cNvSpPr txBox="1"/>
          <p:nvPr/>
        </p:nvSpPr>
        <p:spPr>
          <a:xfrm rot="2803245">
            <a:off x="3829179" y="3696392"/>
            <a:ext cx="1917513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latin typeface="Helvetica" pitchFamily="2" charset="0"/>
              </a:rPr>
              <a:t>At4g31630 </a:t>
            </a:r>
            <a:r>
              <a:rPr kumimoji="1" lang="en-US" altLang="ja-JP" sz="1108" dirty="0">
                <a:latin typeface="Helvetica" pitchFamily="2" charset="0"/>
              </a:rPr>
              <a:t>(SALK_066862)</a:t>
            </a:r>
            <a:endParaRPr kumimoji="1" lang="ja-JP" altLang="en-US" sz="1108" i="1">
              <a:latin typeface="Helvetica" pitchFamily="2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09557EC-FB31-6EFA-D5E5-D417B1FFB455}"/>
              </a:ext>
            </a:extLst>
          </p:cNvPr>
          <p:cNvSpPr txBox="1"/>
          <p:nvPr/>
        </p:nvSpPr>
        <p:spPr>
          <a:xfrm rot="2803245">
            <a:off x="4175957" y="3733557"/>
            <a:ext cx="2020105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latin typeface="Helvetica" pitchFamily="2" charset="0"/>
              </a:rPr>
              <a:t>At5g24470 </a:t>
            </a:r>
            <a:r>
              <a:rPr kumimoji="1" lang="en-US" altLang="ja-JP" sz="1108" dirty="0">
                <a:latin typeface="Helvetica" pitchFamily="2" charset="0"/>
              </a:rPr>
              <a:t>(SALK_053198C)</a:t>
            </a:r>
            <a:endParaRPr kumimoji="1" lang="ja-JP" altLang="en-US" sz="1108" i="1">
              <a:latin typeface="Helvetica" pitchFamily="2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F8B3199-2B4B-283B-B236-BBBA406DE0AA}"/>
              </a:ext>
            </a:extLst>
          </p:cNvPr>
          <p:cNvSpPr txBox="1"/>
          <p:nvPr/>
        </p:nvSpPr>
        <p:spPr>
          <a:xfrm rot="2803245">
            <a:off x="4588628" y="3696392"/>
            <a:ext cx="1917513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latin typeface="Helvetica" pitchFamily="2" charset="0"/>
              </a:rPr>
              <a:t>At1g26260 </a:t>
            </a:r>
            <a:r>
              <a:rPr kumimoji="1" lang="en-US" altLang="ja-JP" sz="1108" dirty="0">
                <a:latin typeface="Helvetica" pitchFamily="2" charset="0"/>
              </a:rPr>
              <a:t>(SALK_090179)</a:t>
            </a:r>
            <a:endParaRPr kumimoji="1" lang="ja-JP" altLang="en-US" sz="1108" i="1">
              <a:latin typeface="Helvetica" pitchFamily="2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B1DD01AE-3679-6E8E-1579-05449FE16C9E}"/>
              </a:ext>
            </a:extLst>
          </p:cNvPr>
          <p:cNvSpPr txBox="1"/>
          <p:nvPr/>
        </p:nvSpPr>
        <p:spPr>
          <a:xfrm rot="2803245">
            <a:off x="5044308" y="3603705"/>
            <a:ext cx="1673856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latin typeface="Helvetica" pitchFamily="2" charset="0"/>
              </a:rPr>
              <a:t>At3g61120 </a:t>
            </a:r>
            <a:r>
              <a:rPr kumimoji="1" lang="en-US" altLang="ja-JP" sz="1108" dirty="0">
                <a:latin typeface="Helvetica" pitchFamily="2" charset="0"/>
              </a:rPr>
              <a:t>(CS362699)</a:t>
            </a:r>
            <a:endParaRPr kumimoji="1" lang="ja-JP" altLang="en-US" sz="1108" i="1">
              <a:latin typeface="Helvetica" pitchFamily="2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A4BB715-8025-0982-DCFE-E2134418552D}"/>
              </a:ext>
            </a:extLst>
          </p:cNvPr>
          <p:cNvSpPr txBox="1"/>
          <p:nvPr/>
        </p:nvSpPr>
        <p:spPr>
          <a:xfrm rot="2803245">
            <a:off x="5414857" y="3607518"/>
            <a:ext cx="1673856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latin typeface="Helvetica" pitchFamily="2" charset="0"/>
              </a:rPr>
              <a:t>At1g18570 </a:t>
            </a:r>
            <a:r>
              <a:rPr kumimoji="1" lang="en-US" altLang="ja-JP" sz="1108" dirty="0">
                <a:latin typeface="Helvetica" pitchFamily="2" charset="0"/>
              </a:rPr>
              <a:t>(CS421816)</a:t>
            </a:r>
            <a:endParaRPr kumimoji="1" lang="ja-JP" altLang="en-US" sz="1108">
              <a:latin typeface="Helvetica" pitchFamily="2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5FFDD904-2BB7-5C73-F256-E586A3260A42}"/>
              </a:ext>
            </a:extLst>
          </p:cNvPr>
          <p:cNvSpPr txBox="1"/>
          <p:nvPr/>
        </p:nvSpPr>
        <p:spPr>
          <a:xfrm rot="2803245">
            <a:off x="5736975" y="3696392"/>
            <a:ext cx="1917513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latin typeface="Helvetica" pitchFamily="2" charset="0"/>
              </a:rPr>
              <a:t>At2g40200 </a:t>
            </a:r>
            <a:r>
              <a:rPr kumimoji="1" lang="en-US" altLang="ja-JP" sz="1108" dirty="0">
                <a:latin typeface="Helvetica" pitchFamily="2" charset="0"/>
              </a:rPr>
              <a:t>(SALK_039015)</a:t>
            </a:r>
            <a:endParaRPr kumimoji="1" lang="ja-JP" altLang="en-US" sz="1108" i="1">
              <a:latin typeface="Helvetica" pitchFamily="2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B2C0EB9-D3A1-1E1A-FB41-050E09934D8D}"/>
              </a:ext>
            </a:extLst>
          </p:cNvPr>
          <p:cNvSpPr txBox="1"/>
          <p:nvPr/>
        </p:nvSpPr>
        <p:spPr>
          <a:xfrm rot="2803245">
            <a:off x="6155957" y="3607518"/>
            <a:ext cx="1673856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latin typeface="Helvetica" pitchFamily="2" charset="0"/>
              </a:rPr>
              <a:t>At1g68130 </a:t>
            </a:r>
            <a:r>
              <a:rPr kumimoji="1" lang="en-US" altLang="ja-JP" sz="1108" dirty="0">
                <a:latin typeface="Helvetica" pitchFamily="2" charset="0"/>
              </a:rPr>
              <a:t>(CS462837)</a:t>
            </a:r>
            <a:endParaRPr kumimoji="1" lang="ja-JP" altLang="en-US" sz="1108" i="1">
              <a:latin typeface="Helvetica" pitchFamily="2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F51D46CC-3877-9DF2-D9F7-BDBC61D12537}"/>
              </a:ext>
            </a:extLst>
          </p:cNvPr>
          <p:cNvSpPr txBox="1"/>
          <p:nvPr/>
        </p:nvSpPr>
        <p:spPr>
          <a:xfrm rot="2803245">
            <a:off x="6505598" y="3696392"/>
            <a:ext cx="1917513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latin typeface="Helvetica" pitchFamily="2" charset="0"/>
              </a:rPr>
              <a:t>At1g69570 </a:t>
            </a:r>
            <a:r>
              <a:rPr kumimoji="1" lang="en-US" altLang="ja-JP" sz="1108" dirty="0">
                <a:latin typeface="Helvetica" pitchFamily="2" charset="0"/>
              </a:rPr>
              <a:t>(SALK_076153)</a:t>
            </a:r>
            <a:endParaRPr kumimoji="1" lang="ja-JP" altLang="en-US" sz="1108" i="1">
              <a:latin typeface="Helvetica" pitchFamily="2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C910285-D596-7547-C967-93AB08206903}"/>
              </a:ext>
            </a:extLst>
          </p:cNvPr>
          <p:cNvSpPr txBox="1"/>
          <p:nvPr/>
        </p:nvSpPr>
        <p:spPr>
          <a:xfrm rot="2803245">
            <a:off x="6957254" y="3550424"/>
            <a:ext cx="1516762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latin typeface="Helvetica" pitchFamily="2" charset="0"/>
              </a:rPr>
              <a:t>At2g46790 </a:t>
            </a:r>
            <a:r>
              <a:rPr kumimoji="1" lang="en-US" altLang="ja-JP" sz="1108" dirty="0">
                <a:latin typeface="Helvetica" pitchFamily="2" charset="0"/>
              </a:rPr>
              <a:t>(CS9386)</a:t>
            </a:r>
            <a:endParaRPr kumimoji="1" lang="ja-JP" altLang="en-US" sz="1108">
              <a:latin typeface="Helvetica" pitchFamily="2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BE9C761-9F81-76A4-7C61-C3A103B6378C}"/>
              </a:ext>
            </a:extLst>
          </p:cNvPr>
          <p:cNvSpPr txBox="1"/>
          <p:nvPr/>
        </p:nvSpPr>
        <p:spPr>
          <a:xfrm rot="2803245">
            <a:off x="7241274" y="3733557"/>
            <a:ext cx="2020105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latin typeface="Helvetica" pitchFamily="2" charset="0"/>
              </a:rPr>
              <a:t>At4g38960 </a:t>
            </a:r>
            <a:r>
              <a:rPr kumimoji="1" lang="en-US" altLang="ja-JP" sz="1108" dirty="0">
                <a:latin typeface="Helvetica" pitchFamily="2" charset="0"/>
              </a:rPr>
              <a:t>(SALK_087493C)</a:t>
            </a:r>
            <a:endParaRPr kumimoji="1" lang="ja-JP" altLang="en-US" sz="1108">
              <a:latin typeface="Helvetica" pitchFamily="2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A4B5BCB-750C-A9FD-8793-6201E1A74F32}"/>
              </a:ext>
            </a:extLst>
          </p:cNvPr>
          <p:cNvSpPr txBox="1"/>
          <p:nvPr/>
        </p:nvSpPr>
        <p:spPr>
          <a:xfrm rot="2803245">
            <a:off x="7696669" y="3564429"/>
            <a:ext cx="1556836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8" i="1" dirty="0">
                <a:solidFill>
                  <a:srgbClr val="FF0000"/>
                </a:solidFill>
                <a:latin typeface="Helvetica" pitchFamily="2" charset="0"/>
              </a:rPr>
              <a:t>dreb2g-1 </a:t>
            </a:r>
            <a:r>
              <a:rPr kumimoji="1" lang="en-US" altLang="ja-JP" sz="1108" dirty="0">
                <a:solidFill>
                  <a:srgbClr val="FF0000"/>
                </a:solidFill>
                <a:latin typeface="Helvetica" pitchFamily="2" charset="0"/>
              </a:rPr>
              <a:t>(CS452041)</a:t>
            </a:r>
            <a:endParaRPr kumimoji="1" lang="ja-JP" altLang="en-US" sz="1108">
              <a:solidFill>
                <a:srgbClr val="FF0000"/>
              </a:solidFill>
              <a:latin typeface="Helvetica" pitchFamily="2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6135DEC5-DAC2-D4E5-E6CF-02E5C5C72B97}"/>
              </a:ext>
            </a:extLst>
          </p:cNvPr>
          <p:cNvSpPr txBox="1"/>
          <p:nvPr/>
        </p:nvSpPr>
        <p:spPr>
          <a:xfrm>
            <a:off x="44750" y="4899767"/>
            <a:ext cx="906376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4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Supplemental Fig. S1 Cellular flavin levels in the wild-type and T-DNA insertion lines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The wild-type and T-DNA insertion lines were grown on 1/2 MS medium with 1% sucrose for 2 weeks under normal conditions, and then leaves were harvested at 4 hours after illumination. Data represent means ± standard error (SE) from at least three individual experiments (n ≥ 3) using independently grown plants. Asterisks denote significant differences compared to the values of the wild-type plants (</a:t>
            </a:r>
            <a:r>
              <a:rPr lang="en-US" altLang="ja-JP" sz="14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*</a:t>
            </a:r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P &lt; 0.05 and </a:t>
            </a:r>
            <a:r>
              <a:rPr lang="en-US" altLang="ja-JP" sz="14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**</a:t>
            </a:r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P &lt; 0.01, Dunnett’s test). 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sz="1400"/>
          </a:p>
        </p:txBody>
      </p:sp>
    </p:spTree>
    <p:extLst>
      <p:ext uri="{BB962C8B-B14F-4D97-AF65-F5344CB8AC3E}">
        <p14:creationId xmlns:p14="http://schemas.microsoft.com/office/powerpoint/2010/main" val="19054347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">
            <a:extLst>
              <a:ext uri="{FF2B5EF4-FFF2-40B4-BE49-F238E27FC236}">
                <a16:creationId xmlns:a16="http://schemas.microsoft.com/office/drawing/2014/main" id="{3D41AD3C-EF9C-93E1-5D3C-0A00B912AB70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25002" y="149550"/>
            <a:ext cx="8838991" cy="6558899"/>
            <a:chOff x="1107" y="132"/>
            <a:chExt cx="5466" cy="4056"/>
          </a:xfrm>
        </p:grpSpPr>
        <p:sp>
          <p:nvSpPr>
            <p:cNvPr id="3" name="AutoShape 3">
              <a:extLst>
                <a:ext uri="{FF2B5EF4-FFF2-40B4-BE49-F238E27FC236}">
                  <a16:creationId xmlns:a16="http://schemas.microsoft.com/office/drawing/2014/main" id="{6EA839DF-5B97-C0DD-73FE-FB4AE57406F2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107" y="132"/>
              <a:ext cx="5466" cy="40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4" name="Rectangle 5">
              <a:extLst>
                <a:ext uri="{FF2B5EF4-FFF2-40B4-BE49-F238E27FC236}">
                  <a16:creationId xmlns:a16="http://schemas.microsoft.com/office/drawing/2014/main" id="{47A20943-20B3-7834-EC54-B5E9D0B17A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7" y="132"/>
              <a:ext cx="4373" cy="324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 dirty="0"/>
            </a:p>
          </p:txBody>
        </p:sp>
        <p:sp>
          <p:nvSpPr>
            <p:cNvPr id="5" name="Rectangle 6">
              <a:extLst>
                <a:ext uri="{FF2B5EF4-FFF2-40B4-BE49-F238E27FC236}">
                  <a16:creationId xmlns:a16="http://schemas.microsoft.com/office/drawing/2014/main" id="{216B938E-F0EB-EF41-48F2-4DE028A619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13" y="132"/>
              <a:ext cx="247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02928"/>
              <a:r>
                <a:rPr lang="ja-JP" altLang="ja-JP" sz="726">
                  <a:solidFill>
                    <a:srgbClr val="000000"/>
                  </a:solidFill>
                </a:rPr>
                <a:t> DREB2A</a:t>
              </a:r>
              <a:endParaRPr lang="ja-JP" altLang="ja-JP" sz="1187"/>
            </a:p>
          </p:txBody>
        </p:sp>
        <p:sp>
          <p:nvSpPr>
            <p:cNvPr id="6" name="Freeform 7">
              <a:extLst>
                <a:ext uri="{FF2B5EF4-FFF2-40B4-BE49-F238E27FC236}">
                  <a16:creationId xmlns:a16="http://schemas.microsoft.com/office/drawing/2014/main" id="{92ED1D52-65DF-D629-D0CB-0F5F4DC76356}"/>
                </a:ext>
              </a:extLst>
            </p:cNvPr>
            <p:cNvSpPr>
              <a:spLocks/>
            </p:cNvSpPr>
            <p:nvPr/>
          </p:nvSpPr>
          <p:spPr bwMode="auto">
            <a:xfrm>
              <a:off x="3804" y="180"/>
              <a:ext cx="697" cy="78"/>
            </a:xfrm>
            <a:custGeom>
              <a:avLst/>
              <a:gdLst>
                <a:gd name="T0" fmla="*/ 0 w 697"/>
                <a:gd name="T1" fmla="*/ 78 h 78"/>
                <a:gd name="T2" fmla="*/ 0 w 697"/>
                <a:gd name="T3" fmla="*/ 0 h 78"/>
                <a:gd name="T4" fmla="*/ 697 w 697"/>
                <a:gd name="T5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7" h="78">
                  <a:moveTo>
                    <a:pt x="0" y="78"/>
                  </a:moveTo>
                  <a:lnTo>
                    <a:pt x="0" y="0"/>
                  </a:lnTo>
                  <a:lnTo>
                    <a:pt x="697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7" name="Rectangle 8">
              <a:extLst>
                <a:ext uri="{FF2B5EF4-FFF2-40B4-BE49-F238E27FC236}">
                  <a16:creationId xmlns:a16="http://schemas.microsoft.com/office/drawing/2014/main" id="{7950F1DB-0EB9-1016-F451-5676446414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75" y="294"/>
              <a:ext cx="247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02928"/>
              <a:r>
                <a:rPr lang="ja-JP" altLang="ja-JP" sz="726">
                  <a:solidFill>
                    <a:srgbClr val="000000"/>
                  </a:solidFill>
                </a:rPr>
                <a:t> DREB2B</a:t>
              </a:r>
              <a:endParaRPr lang="ja-JP" altLang="ja-JP" sz="1187"/>
            </a:p>
          </p:txBody>
        </p:sp>
        <p:sp>
          <p:nvSpPr>
            <p:cNvPr id="8" name="Freeform 9">
              <a:extLst>
                <a:ext uri="{FF2B5EF4-FFF2-40B4-BE49-F238E27FC236}">
                  <a16:creationId xmlns:a16="http://schemas.microsoft.com/office/drawing/2014/main" id="{E2F569CD-FB05-D303-3473-6E0DD0B6B179}"/>
                </a:ext>
              </a:extLst>
            </p:cNvPr>
            <p:cNvSpPr>
              <a:spLocks/>
            </p:cNvSpPr>
            <p:nvPr/>
          </p:nvSpPr>
          <p:spPr bwMode="auto">
            <a:xfrm>
              <a:off x="3804" y="264"/>
              <a:ext cx="859" cy="78"/>
            </a:xfrm>
            <a:custGeom>
              <a:avLst/>
              <a:gdLst>
                <a:gd name="T0" fmla="*/ 0 w 859"/>
                <a:gd name="T1" fmla="*/ 0 h 78"/>
                <a:gd name="T2" fmla="*/ 0 w 859"/>
                <a:gd name="T3" fmla="*/ 78 h 78"/>
                <a:gd name="T4" fmla="*/ 859 w 859"/>
                <a:gd name="T5" fmla="*/ 78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59" h="78">
                  <a:moveTo>
                    <a:pt x="0" y="0"/>
                  </a:moveTo>
                  <a:lnTo>
                    <a:pt x="0" y="78"/>
                  </a:lnTo>
                  <a:lnTo>
                    <a:pt x="859" y="7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9" name="Freeform 10">
              <a:extLst>
                <a:ext uri="{FF2B5EF4-FFF2-40B4-BE49-F238E27FC236}">
                  <a16:creationId xmlns:a16="http://schemas.microsoft.com/office/drawing/2014/main" id="{376D4C06-FDC0-3D00-96E9-BC34147496CA}"/>
                </a:ext>
              </a:extLst>
            </p:cNvPr>
            <p:cNvSpPr>
              <a:spLocks/>
            </p:cNvSpPr>
            <p:nvPr/>
          </p:nvSpPr>
          <p:spPr bwMode="auto">
            <a:xfrm>
              <a:off x="3185" y="258"/>
              <a:ext cx="619" cy="120"/>
            </a:xfrm>
            <a:custGeom>
              <a:avLst/>
              <a:gdLst>
                <a:gd name="T0" fmla="*/ 0 w 619"/>
                <a:gd name="T1" fmla="*/ 120 h 120"/>
                <a:gd name="T2" fmla="*/ 0 w 619"/>
                <a:gd name="T3" fmla="*/ 0 h 120"/>
                <a:gd name="T4" fmla="*/ 619 w 619"/>
                <a:gd name="T5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9" h="120">
                  <a:moveTo>
                    <a:pt x="0" y="120"/>
                  </a:moveTo>
                  <a:lnTo>
                    <a:pt x="0" y="0"/>
                  </a:lnTo>
                  <a:lnTo>
                    <a:pt x="61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10" name="Rectangle 11">
              <a:extLst>
                <a:ext uri="{FF2B5EF4-FFF2-40B4-BE49-F238E27FC236}">
                  <a16:creationId xmlns:a16="http://schemas.microsoft.com/office/drawing/2014/main" id="{75298A51-BC1E-A604-F3A3-06FE89D196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7" y="456"/>
              <a:ext cx="247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02928"/>
              <a:r>
                <a:rPr lang="ja-JP" altLang="ja-JP" sz="726">
                  <a:solidFill>
                    <a:srgbClr val="000000"/>
                  </a:solidFill>
                </a:rPr>
                <a:t> DREB2E</a:t>
              </a:r>
              <a:endParaRPr lang="ja-JP" altLang="ja-JP" sz="1187"/>
            </a:p>
          </p:txBody>
        </p:sp>
        <p:sp>
          <p:nvSpPr>
            <p:cNvPr id="11" name="Freeform 12">
              <a:extLst>
                <a:ext uri="{FF2B5EF4-FFF2-40B4-BE49-F238E27FC236}">
                  <a16:creationId xmlns:a16="http://schemas.microsoft.com/office/drawing/2014/main" id="{C8D52E54-6D43-BFE0-660A-520F85915B47}"/>
                </a:ext>
              </a:extLst>
            </p:cNvPr>
            <p:cNvSpPr>
              <a:spLocks/>
            </p:cNvSpPr>
            <p:nvPr/>
          </p:nvSpPr>
          <p:spPr bwMode="auto">
            <a:xfrm>
              <a:off x="3185" y="384"/>
              <a:ext cx="1490" cy="121"/>
            </a:xfrm>
            <a:custGeom>
              <a:avLst/>
              <a:gdLst>
                <a:gd name="T0" fmla="*/ 0 w 1490"/>
                <a:gd name="T1" fmla="*/ 0 h 121"/>
                <a:gd name="T2" fmla="*/ 0 w 1490"/>
                <a:gd name="T3" fmla="*/ 121 h 121"/>
                <a:gd name="T4" fmla="*/ 1490 w 1490"/>
                <a:gd name="T5" fmla="*/ 121 h 1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90" h="121">
                  <a:moveTo>
                    <a:pt x="0" y="0"/>
                  </a:moveTo>
                  <a:lnTo>
                    <a:pt x="0" y="121"/>
                  </a:lnTo>
                  <a:lnTo>
                    <a:pt x="1490" y="121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12" name="Freeform 13">
              <a:extLst>
                <a:ext uri="{FF2B5EF4-FFF2-40B4-BE49-F238E27FC236}">
                  <a16:creationId xmlns:a16="http://schemas.microsoft.com/office/drawing/2014/main" id="{1CED016A-C15E-B0FA-C082-57CF7DDB74E6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3" y="378"/>
              <a:ext cx="192" cy="181"/>
            </a:xfrm>
            <a:custGeom>
              <a:avLst/>
              <a:gdLst>
                <a:gd name="T0" fmla="*/ 0 w 192"/>
                <a:gd name="T1" fmla="*/ 181 h 181"/>
                <a:gd name="T2" fmla="*/ 0 w 192"/>
                <a:gd name="T3" fmla="*/ 0 h 181"/>
                <a:gd name="T4" fmla="*/ 192 w 192"/>
                <a:gd name="T5" fmla="*/ 0 h 1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2" h="181">
                  <a:moveTo>
                    <a:pt x="0" y="181"/>
                  </a:moveTo>
                  <a:lnTo>
                    <a:pt x="0" y="0"/>
                  </a:lnTo>
                  <a:lnTo>
                    <a:pt x="192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13" name="Rectangle 14">
              <a:extLst>
                <a:ext uri="{FF2B5EF4-FFF2-40B4-BE49-F238E27FC236}">
                  <a16:creationId xmlns:a16="http://schemas.microsoft.com/office/drawing/2014/main" id="{10223C18-140F-7F22-3ABC-4A416E54C7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75" y="619"/>
              <a:ext cx="250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02928"/>
              <a:r>
                <a:rPr lang="ja-JP" altLang="ja-JP" sz="726" dirty="0">
                  <a:solidFill>
                    <a:srgbClr val="000000"/>
                  </a:solidFill>
                </a:rPr>
                <a:t> DREB2C</a:t>
              </a:r>
              <a:endParaRPr lang="ja-JP" altLang="ja-JP" sz="1187" dirty="0"/>
            </a:p>
          </p:txBody>
        </p:sp>
        <p:sp>
          <p:nvSpPr>
            <p:cNvPr id="14" name="Freeform 15">
              <a:extLst>
                <a:ext uri="{FF2B5EF4-FFF2-40B4-BE49-F238E27FC236}">
                  <a16:creationId xmlns:a16="http://schemas.microsoft.com/office/drawing/2014/main" id="{9348F79B-068F-41FD-B4F0-00D6A799D4E7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0" y="667"/>
              <a:ext cx="823" cy="78"/>
            </a:xfrm>
            <a:custGeom>
              <a:avLst/>
              <a:gdLst>
                <a:gd name="T0" fmla="*/ 0 w 823"/>
                <a:gd name="T1" fmla="*/ 78 h 78"/>
                <a:gd name="T2" fmla="*/ 0 w 823"/>
                <a:gd name="T3" fmla="*/ 0 h 78"/>
                <a:gd name="T4" fmla="*/ 823 w 823"/>
                <a:gd name="T5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23" h="78">
                  <a:moveTo>
                    <a:pt x="0" y="78"/>
                  </a:moveTo>
                  <a:lnTo>
                    <a:pt x="0" y="0"/>
                  </a:lnTo>
                  <a:lnTo>
                    <a:pt x="823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15" name="Rectangle 16">
              <a:extLst>
                <a:ext uri="{FF2B5EF4-FFF2-40B4-BE49-F238E27FC236}">
                  <a16:creationId xmlns:a16="http://schemas.microsoft.com/office/drawing/2014/main" id="{92FB4D25-EB54-A31A-D12E-EFB632C6F4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35" y="781"/>
              <a:ext cx="250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02928"/>
              <a:r>
                <a:rPr lang="ja-JP" altLang="ja-JP" sz="726">
                  <a:solidFill>
                    <a:srgbClr val="000000"/>
                  </a:solidFill>
                </a:rPr>
                <a:t> DREB2H</a:t>
              </a:r>
              <a:endParaRPr lang="ja-JP" altLang="ja-JP" sz="1187"/>
            </a:p>
          </p:txBody>
        </p:sp>
        <p:sp>
          <p:nvSpPr>
            <p:cNvPr id="16" name="Freeform 17">
              <a:extLst>
                <a:ext uri="{FF2B5EF4-FFF2-40B4-BE49-F238E27FC236}">
                  <a16:creationId xmlns:a16="http://schemas.microsoft.com/office/drawing/2014/main" id="{D9E9C6A9-3625-FD35-E28A-BE806132D292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0" y="751"/>
              <a:ext cx="883" cy="78"/>
            </a:xfrm>
            <a:custGeom>
              <a:avLst/>
              <a:gdLst>
                <a:gd name="T0" fmla="*/ 0 w 883"/>
                <a:gd name="T1" fmla="*/ 0 h 78"/>
                <a:gd name="T2" fmla="*/ 0 w 883"/>
                <a:gd name="T3" fmla="*/ 78 h 78"/>
                <a:gd name="T4" fmla="*/ 883 w 883"/>
                <a:gd name="T5" fmla="*/ 78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3" h="78">
                  <a:moveTo>
                    <a:pt x="0" y="0"/>
                  </a:moveTo>
                  <a:lnTo>
                    <a:pt x="0" y="78"/>
                  </a:lnTo>
                  <a:lnTo>
                    <a:pt x="883" y="7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17" name="Freeform 18">
              <a:extLst>
                <a:ext uri="{FF2B5EF4-FFF2-40B4-BE49-F238E27FC236}">
                  <a16:creationId xmlns:a16="http://schemas.microsoft.com/office/drawing/2014/main" id="{FEEFE4E4-C543-4B44-4094-68F028F8409F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3" y="565"/>
              <a:ext cx="847" cy="180"/>
            </a:xfrm>
            <a:custGeom>
              <a:avLst/>
              <a:gdLst>
                <a:gd name="T0" fmla="*/ 0 w 847"/>
                <a:gd name="T1" fmla="*/ 0 h 180"/>
                <a:gd name="T2" fmla="*/ 0 w 847"/>
                <a:gd name="T3" fmla="*/ 180 h 180"/>
                <a:gd name="T4" fmla="*/ 847 w 847"/>
                <a:gd name="T5" fmla="*/ 180 h 1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7" h="180">
                  <a:moveTo>
                    <a:pt x="0" y="0"/>
                  </a:moveTo>
                  <a:lnTo>
                    <a:pt x="0" y="180"/>
                  </a:lnTo>
                  <a:lnTo>
                    <a:pt x="847" y="18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18" name="Freeform 19">
              <a:extLst>
                <a:ext uri="{FF2B5EF4-FFF2-40B4-BE49-F238E27FC236}">
                  <a16:creationId xmlns:a16="http://schemas.microsoft.com/office/drawing/2014/main" id="{10EA98A4-1983-14EF-2906-CD5EA9630341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1" y="559"/>
              <a:ext cx="42" cy="252"/>
            </a:xfrm>
            <a:custGeom>
              <a:avLst/>
              <a:gdLst>
                <a:gd name="T0" fmla="*/ 0 w 42"/>
                <a:gd name="T1" fmla="*/ 252 h 252"/>
                <a:gd name="T2" fmla="*/ 0 w 42"/>
                <a:gd name="T3" fmla="*/ 0 h 252"/>
                <a:gd name="T4" fmla="*/ 42 w 42"/>
                <a:gd name="T5" fmla="*/ 0 h 2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252">
                  <a:moveTo>
                    <a:pt x="0" y="252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19" name="Rectangle 20">
              <a:extLst>
                <a:ext uri="{FF2B5EF4-FFF2-40B4-BE49-F238E27FC236}">
                  <a16:creationId xmlns:a16="http://schemas.microsoft.com/office/drawing/2014/main" id="{EC10E013-314B-B62C-13CC-73F085F001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43" y="943"/>
              <a:ext cx="250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02928"/>
              <a:r>
                <a:rPr lang="ja-JP" altLang="ja-JP" sz="726">
                  <a:solidFill>
                    <a:srgbClr val="000000"/>
                  </a:solidFill>
                </a:rPr>
                <a:t> DREB2D</a:t>
              </a:r>
              <a:endParaRPr lang="ja-JP" altLang="ja-JP" sz="1187"/>
            </a:p>
          </p:txBody>
        </p:sp>
        <p:sp>
          <p:nvSpPr>
            <p:cNvPr id="20" name="Freeform 21">
              <a:extLst>
                <a:ext uri="{FF2B5EF4-FFF2-40B4-BE49-F238E27FC236}">
                  <a16:creationId xmlns:a16="http://schemas.microsoft.com/office/drawing/2014/main" id="{3864F789-F882-8D94-7EA7-A9135A3E12C0}"/>
                </a:ext>
              </a:extLst>
            </p:cNvPr>
            <p:cNvSpPr>
              <a:spLocks/>
            </p:cNvSpPr>
            <p:nvPr/>
          </p:nvSpPr>
          <p:spPr bwMode="auto">
            <a:xfrm>
              <a:off x="3107" y="991"/>
              <a:ext cx="1424" cy="78"/>
            </a:xfrm>
            <a:custGeom>
              <a:avLst/>
              <a:gdLst>
                <a:gd name="T0" fmla="*/ 0 w 1424"/>
                <a:gd name="T1" fmla="*/ 78 h 78"/>
                <a:gd name="T2" fmla="*/ 0 w 1424"/>
                <a:gd name="T3" fmla="*/ 0 h 78"/>
                <a:gd name="T4" fmla="*/ 1424 w 1424"/>
                <a:gd name="T5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24" h="78">
                  <a:moveTo>
                    <a:pt x="0" y="78"/>
                  </a:moveTo>
                  <a:lnTo>
                    <a:pt x="0" y="0"/>
                  </a:lnTo>
                  <a:lnTo>
                    <a:pt x="1424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21" name="Rectangle 22">
              <a:extLst>
                <a:ext uri="{FF2B5EF4-FFF2-40B4-BE49-F238E27FC236}">
                  <a16:creationId xmlns:a16="http://schemas.microsoft.com/office/drawing/2014/main" id="{4E286D0A-5AC7-25AF-0A65-6ABCD124CC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9" y="1105"/>
              <a:ext cx="253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02928"/>
              <a:r>
                <a:rPr lang="ja-JP" altLang="ja-JP" sz="726">
                  <a:solidFill>
                    <a:srgbClr val="000000"/>
                  </a:solidFill>
                </a:rPr>
                <a:t> DREB2G</a:t>
              </a:r>
              <a:endParaRPr lang="ja-JP" altLang="ja-JP" sz="1187"/>
            </a:p>
          </p:txBody>
        </p:sp>
        <p:sp>
          <p:nvSpPr>
            <p:cNvPr id="22" name="Freeform 23">
              <a:extLst>
                <a:ext uri="{FF2B5EF4-FFF2-40B4-BE49-F238E27FC236}">
                  <a16:creationId xmlns:a16="http://schemas.microsoft.com/office/drawing/2014/main" id="{3AFCBADC-E248-E39E-2789-CA447736EA14}"/>
                </a:ext>
              </a:extLst>
            </p:cNvPr>
            <p:cNvSpPr>
              <a:spLocks/>
            </p:cNvSpPr>
            <p:nvPr/>
          </p:nvSpPr>
          <p:spPr bwMode="auto">
            <a:xfrm>
              <a:off x="3107" y="1075"/>
              <a:ext cx="1460" cy="79"/>
            </a:xfrm>
            <a:custGeom>
              <a:avLst/>
              <a:gdLst>
                <a:gd name="T0" fmla="*/ 0 w 1460"/>
                <a:gd name="T1" fmla="*/ 0 h 79"/>
                <a:gd name="T2" fmla="*/ 0 w 1460"/>
                <a:gd name="T3" fmla="*/ 79 h 79"/>
                <a:gd name="T4" fmla="*/ 1460 w 1460"/>
                <a:gd name="T5" fmla="*/ 79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60" h="79">
                  <a:moveTo>
                    <a:pt x="0" y="0"/>
                  </a:moveTo>
                  <a:lnTo>
                    <a:pt x="0" y="79"/>
                  </a:lnTo>
                  <a:lnTo>
                    <a:pt x="1460" y="79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23" name="Freeform 24">
              <a:extLst>
                <a:ext uri="{FF2B5EF4-FFF2-40B4-BE49-F238E27FC236}">
                  <a16:creationId xmlns:a16="http://schemas.microsoft.com/office/drawing/2014/main" id="{71396B31-076C-92F1-3196-CEA3E01A637B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1" y="817"/>
              <a:ext cx="156" cy="252"/>
            </a:xfrm>
            <a:custGeom>
              <a:avLst/>
              <a:gdLst>
                <a:gd name="T0" fmla="*/ 0 w 156"/>
                <a:gd name="T1" fmla="*/ 0 h 252"/>
                <a:gd name="T2" fmla="*/ 0 w 156"/>
                <a:gd name="T3" fmla="*/ 252 h 252"/>
                <a:gd name="T4" fmla="*/ 156 w 156"/>
                <a:gd name="T5" fmla="*/ 252 h 2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6" h="252">
                  <a:moveTo>
                    <a:pt x="0" y="0"/>
                  </a:moveTo>
                  <a:lnTo>
                    <a:pt x="0" y="252"/>
                  </a:lnTo>
                  <a:lnTo>
                    <a:pt x="156" y="252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24" name="Freeform 25">
              <a:extLst>
                <a:ext uri="{FF2B5EF4-FFF2-40B4-BE49-F238E27FC236}">
                  <a16:creationId xmlns:a16="http://schemas.microsoft.com/office/drawing/2014/main" id="{0B88A84F-A824-B60C-1C3B-E4D6948C11DB}"/>
                </a:ext>
              </a:extLst>
            </p:cNvPr>
            <p:cNvSpPr>
              <a:spLocks/>
            </p:cNvSpPr>
            <p:nvPr/>
          </p:nvSpPr>
          <p:spPr bwMode="auto">
            <a:xfrm>
              <a:off x="2819" y="811"/>
              <a:ext cx="132" cy="252"/>
            </a:xfrm>
            <a:custGeom>
              <a:avLst/>
              <a:gdLst>
                <a:gd name="T0" fmla="*/ 0 w 132"/>
                <a:gd name="T1" fmla="*/ 252 h 252"/>
                <a:gd name="T2" fmla="*/ 0 w 132"/>
                <a:gd name="T3" fmla="*/ 0 h 252"/>
                <a:gd name="T4" fmla="*/ 132 w 132"/>
                <a:gd name="T5" fmla="*/ 0 h 2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2" h="252">
                  <a:moveTo>
                    <a:pt x="0" y="252"/>
                  </a:moveTo>
                  <a:lnTo>
                    <a:pt x="0" y="0"/>
                  </a:lnTo>
                  <a:lnTo>
                    <a:pt x="132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25" name="Rectangle 26">
              <a:extLst>
                <a:ext uri="{FF2B5EF4-FFF2-40B4-BE49-F238E27FC236}">
                  <a16:creationId xmlns:a16="http://schemas.microsoft.com/office/drawing/2014/main" id="{F1B07210-B9F6-AE97-EE54-A5A551EA48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49" y="1268"/>
              <a:ext cx="243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02928"/>
              <a:r>
                <a:rPr lang="ja-JP" altLang="ja-JP" sz="726">
                  <a:solidFill>
                    <a:srgbClr val="000000"/>
                  </a:solidFill>
                </a:rPr>
                <a:t> DREB2F</a:t>
              </a:r>
              <a:endParaRPr lang="ja-JP" altLang="ja-JP" sz="1187"/>
            </a:p>
          </p:txBody>
        </p:sp>
        <p:sp>
          <p:nvSpPr>
            <p:cNvPr id="26" name="Freeform 27">
              <a:extLst>
                <a:ext uri="{FF2B5EF4-FFF2-40B4-BE49-F238E27FC236}">
                  <a16:creationId xmlns:a16="http://schemas.microsoft.com/office/drawing/2014/main" id="{7A87C881-9871-1A94-115C-EF18E1BE60F0}"/>
                </a:ext>
              </a:extLst>
            </p:cNvPr>
            <p:cNvSpPr>
              <a:spLocks/>
            </p:cNvSpPr>
            <p:nvPr/>
          </p:nvSpPr>
          <p:spPr bwMode="auto">
            <a:xfrm>
              <a:off x="2819" y="1069"/>
              <a:ext cx="1718" cy="247"/>
            </a:xfrm>
            <a:custGeom>
              <a:avLst/>
              <a:gdLst>
                <a:gd name="T0" fmla="*/ 0 w 1718"/>
                <a:gd name="T1" fmla="*/ 0 h 247"/>
                <a:gd name="T2" fmla="*/ 0 w 1718"/>
                <a:gd name="T3" fmla="*/ 247 h 247"/>
                <a:gd name="T4" fmla="*/ 1718 w 1718"/>
                <a:gd name="T5" fmla="*/ 247 h 2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18" h="247">
                  <a:moveTo>
                    <a:pt x="0" y="0"/>
                  </a:moveTo>
                  <a:lnTo>
                    <a:pt x="0" y="247"/>
                  </a:lnTo>
                  <a:lnTo>
                    <a:pt x="1718" y="247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27" name="Freeform 28">
              <a:extLst>
                <a:ext uri="{FF2B5EF4-FFF2-40B4-BE49-F238E27FC236}">
                  <a16:creationId xmlns:a16="http://schemas.microsoft.com/office/drawing/2014/main" id="{2F1E6DC8-9C37-167D-6C34-3BB8D9406A8A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2" y="1063"/>
              <a:ext cx="607" cy="343"/>
            </a:xfrm>
            <a:custGeom>
              <a:avLst/>
              <a:gdLst>
                <a:gd name="T0" fmla="*/ 0 w 607"/>
                <a:gd name="T1" fmla="*/ 343 h 343"/>
                <a:gd name="T2" fmla="*/ 0 w 607"/>
                <a:gd name="T3" fmla="*/ 0 h 343"/>
                <a:gd name="T4" fmla="*/ 607 w 607"/>
                <a:gd name="T5" fmla="*/ 0 h 3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7" h="343">
                  <a:moveTo>
                    <a:pt x="0" y="343"/>
                  </a:moveTo>
                  <a:lnTo>
                    <a:pt x="0" y="0"/>
                  </a:lnTo>
                  <a:lnTo>
                    <a:pt x="607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28" name="Rectangle 29">
              <a:extLst>
                <a:ext uri="{FF2B5EF4-FFF2-40B4-BE49-F238E27FC236}">
                  <a16:creationId xmlns:a16="http://schemas.microsoft.com/office/drawing/2014/main" id="{AC9A39E1-95E0-7334-77EF-B98BA79496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77" y="1430"/>
              <a:ext cx="247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02928"/>
              <a:r>
                <a:rPr lang="ja-JP" altLang="ja-JP" sz="726">
                  <a:solidFill>
                    <a:srgbClr val="000000"/>
                  </a:solidFill>
                </a:rPr>
                <a:t> DREB1E</a:t>
              </a:r>
              <a:endParaRPr lang="ja-JP" altLang="ja-JP" sz="1187"/>
            </a:p>
          </p:txBody>
        </p:sp>
        <p:sp>
          <p:nvSpPr>
            <p:cNvPr id="29" name="Freeform 30">
              <a:extLst>
                <a:ext uri="{FF2B5EF4-FFF2-40B4-BE49-F238E27FC236}">
                  <a16:creationId xmlns:a16="http://schemas.microsoft.com/office/drawing/2014/main" id="{C580923E-E301-A487-80E0-01F109A2B59B}"/>
                </a:ext>
              </a:extLst>
            </p:cNvPr>
            <p:cNvSpPr>
              <a:spLocks/>
            </p:cNvSpPr>
            <p:nvPr/>
          </p:nvSpPr>
          <p:spPr bwMode="auto">
            <a:xfrm>
              <a:off x="4326" y="1478"/>
              <a:ext cx="439" cy="78"/>
            </a:xfrm>
            <a:custGeom>
              <a:avLst/>
              <a:gdLst>
                <a:gd name="T0" fmla="*/ 0 w 439"/>
                <a:gd name="T1" fmla="*/ 78 h 78"/>
                <a:gd name="T2" fmla="*/ 0 w 439"/>
                <a:gd name="T3" fmla="*/ 0 h 78"/>
                <a:gd name="T4" fmla="*/ 439 w 439"/>
                <a:gd name="T5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78">
                  <a:moveTo>
                    <a:pt x="0" y="78"/>
                  </a:moveTo>
                  <a:lnTo>
                    <a:pt x="0" y="0"/>
                  </a:lnTo>
                  <a:lnTo>
                    <a:pt x="43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30" name="Rectangle 31">
              <a:extLst>
                <a:ext uri="{FF2B5EF4-FFF2-40B4-BE49-F238E27FC236}">
                  <a16:creationId xmlns:a16="http://schemas.microsoft.com/office/drawing/2014/main" id="{2BA33119-B421-B63D-806C-59E1E44CA7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89" y="1592"/>
              <a:ext cx="243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02928"/>
              <a:r>
                <a:rPr lang="ja-JP" altLang="ja-JP" sz="726">
                  <a:solidFill>
                    <a:srgbClr val="000000"/>
                  </a:solidFill>
                </a:rPr>
                <a:t> DREB1F</a:t>
              </a:r>
              <a:endParaRPr lang="ja-JP" altLang="ja-JP" sz="1187"/>
            </a:p>
          </p:txBody>
        </p:sp>
        <p:sp>
          <p:nvSpPr>
            <p:cNvPr id="31" name="Freeform 32">
              <a:extLst>
                <a:ext uri="{FF2B5EF4-FFF2-40B4-BE49-F238E27FC236}">
                  <a16:creationId xmlns:a16="http://schemas.microsoft.com/office/drawing/2014/main" id="{937F5204-B971-9355-F6E9-13B0E1F6E2B3}"/>
                </a:ext>
              </a:extLst>
            </p:cNvPr>
            <p:cNvSpPr>
              <a:spLocks/>
            </p:cNvSpPr>
            <p:nvPr/>
          </p:nvSpPr>
          <p:spPr bwMode="auto">
            <a:xfrm>
              <a:off x="4326" y="1562"/>
              <a:ext cx="451" cy="78"/>
            </a:xfrm>
            <a:custGeom>
              <a:avLst/>
              <a:gdLst>
                <a:gd name="T0" fmla="*/ 0 w 451"/>
                <a:gd name="T1" fmla="*/ 0 h 78"/>
                <a:gd name="T2" fmla="*/ 0 w 451"/>
                <a:gd name="T3" fmla="*/ 78 h 78"/>
                <a:gd name="T4" fmla="*/ 451 w 451"/>
                <a:gd name="T5" fmla="*/ 78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1" h="78">
                  <a:moveTo>
                    <a:pt x="0" y="0"/>
                  </a:moveTo>
                  <a:lnTo>
                    <a:pt x="0" y="78"/>
                  </a:lnTo>
                  <a:lnTo>
                    <a:pt x="451" y="7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32" name="Freeform 33">
              <a:extLst>
                <a:ext uri="{FF2B5EF4-FFF2-40B4-BE49-F238E27FC236}">
                  <a16:creationId xmlns:a16="http://schemas.microsoft.com/office/drawing/2014/main" id="{88B34E94-7E0F-8375-8E2F-3E279AD37FB9}"/>
                </a:ext>
              </a:extLst>
            </p:cNvPr>
            <p:cNvSpPr>
              <a:spLocks/>
            </p:cNvSpPr>
            <p:nvPr/>
          </p:nvSpPr>
          <p:spPr bwMode="auto">
            <a:xfrm>
              <a:off x="3492" y="1556"/>
              <a:ext cx="834" cy="192"/>
            </a:xfrm>
            <a:custGeom>
              <a:avLst/>
              <a:gdLst>
                <a:gd name="T0" fmla="*/ 0 w 834"/>
                <a:gd name="T1" fmla="*/ 192 h 192"/>
                <a:gd name="T2" fmla="*/ 0 w 834"/>
                <a:gd name="T3" fmla="*/ 0 h 192"/>
                <a:gd name="T4" fmla="*/ 834 w 834"/>
                <a:gd name="T5" fmla="*/ 0 h 1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34" h="192">
                  <a:moveTo>
                    <a:pt x="0" y="192"/>
                  </a:moveTo>
                  <a:lnTo>
                    <a:pt x="0" y="0"/>
                  </a:lnTo>
                  <a:lnTo>
                    <a:pt x="834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33" name="Rectangle 34">
              <a:extLst>
                <a:ext uri="{FF2B5EF4-FFF2-40B4-BE49-F238E27FC236}">
                  <a16:creationId xmlns:a16="http://schemas.microsoft.com/office/drawing/2014/main" id="{A0E79EB2-2BD0-9B89-9107-498AC93422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3" y="1754"/>
              <a:ext cx="247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02928"/>
              <a:r>
                <a:rPr lang="ja-JP" altLang="ja-JP" sz="726">
                  <a:solidFill>
                    <a:srgbClr val="000000"/>
                  </a:solidFill>
                </a:rPr>
                <a:t> DREB1B</a:t>
              </a:r>
              <a:endParaRPr lang="ja-JP" altLang="ja-JP" sz="1187"/>
            </a:p>
          </p:txBody>
        </p:sp>
        <p:sp>
          <p:nvSpPr>
            <p:cNvPr id="34" name="Freeform 35">
              <a:extLst>
                <a:ext uri="{FF2B5EF4-FFF2-40B4-BE49-F238E27FC236}">
                  <a16:creationId xmlns:a16="http://schemas.microsoft.com/office/drawing/2014/main" id="{368D8BAC-59EC-1DEB-51B4-B0B73DC37914}"/>
                </a:ext>
              </a:extLst>
            </p:cNvPr>
            <p:cNvSpPr>
              <a:spLocks/>
            </p:cNvSpPr>
            <p:nvPr/>
          </p:nvSpPr>
          <p:spPr bwMode="auto">
            <a:xfrm>
              <a:off x="3582" y="1802"/>
              <a:ext cx="1009" cy="139"/>
            </a:xfrm>
            <a:custGeom>
              <a:avLst/>
              <a:gdLst>
                <a:gd name="T0" fmla="*/ 0 w 1009"/>
                <a:gd name="T1" fmla="*/ 139 h 139"/>
                <a:gd name="T2" fmla="*/ 0 w 1009"/>
                <a:gd name="T3" fmla="*/ 0 h 139"/>
                <a:gd name="T4" fmla="*/ 1009 w 1009"/>
                <a:gd name="T5" fmla="*/ 0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09" h="139">
                  <a:moveTo>
                    <a:pt x="0" y="139"/>
                  </a:moveTo>
                  <a:lnTo>
                    <a:pt x="0" y="0"/>
                  </a:lnTo>
                  <a:lnTo>
                    <a:pt x="100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35" name="Rectangle 36">
              <a:extLst>
                <a:ext uri="{FF2B5EF4-FFF2-40B4-BE49-F238E27FC236}">
                  <a16:creationId xmlns:a16="http://schemas.microsoft.com/office/drawing/2014/main" id="{008FC2B5-2AA1-0B4B-7E47-DB780EA13E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47" y="1917"/>
              <a:ext cx="250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02928"/>
              <a:r>
                <a:rPr lang="ja-JP" altLang="ja-JP" sz="726">
                  <a:solidFill>
                    <a:srgbClr val="000000"/>
                  </a:solidFill>
                </a:rPr>
                <a:t> DREB1D</a:t>
              </a:r>
              <a:endParaRPr lang="ja-JP" altLang="ja-JP" sz="1187"/>
            </a:p>
          </p:txBody>
        </p:sp>
        <p:sp>
          <p:nvSpPr>
            <p:cNvPr id="36" name="Freeform 37">
              <a:extLst>
                <a:ext uri="{FF2B5EF4-FFF2-40B4-BE49-F238E27FC236}">
                  <a16:creationId xmlns:a16="http://schemas.microsoft.com/office/drawing/2014/main" id="{703FEA43-7C16-AE07-C644-F4F866E1F20F}"/>
                </a:ext>
              </a:extLst>
            </p:cNvPr>
            <p:cNvSpPr>
              <a:spLocks/>
            </p:cNvSpPr>
            <p:nvPr/>
          </p:nvSpPr>
          <p:spPr bwMode="auto">
            <a:xfrm>
              <a:off x="3810" y="1965"/>
              <a:ext cx="625" cy="120"/>
            </a:xfrm>
            <a:custGeom>
              <a:avLst/>
              <a:gdLst>
                <a:gd name="T0" fmla="*/ 0 w 625"/>
                <a:gd name="T1" fmla="*/ 120 h 120"/>
                <a:gd name="T2" fmla="*/ 0 w 625"/>
                <a:gd name="T3" fmla="*/ 0 h 120"/>
                <a:gd name="T4" fmla="*/ 625 w 625"/>
                <a:gd name="T5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5" h="120">
                  <a:moveTo>
                    <a:pt x="0" y="120"/>
                  </a:moveTo>
                  <a:lnTo>
                    <a:pt x="0" y="0"/>
                  </a:lnTo>
                  <a:lnTo>
                    <a:pt x="625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37" name="Rectangle 38">
              <a:extLst>
                <a:ext uri="{FF2B5EF4-FFF2-40B4-BE49-F238E27FC236}">
                  <a16:creationId xmlns:a16="http://schemas.microsoft.com/office/drawing/2014/main" id="{2E822591-84E2-91FA-9269-48D193E038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65" y="2079"/>
              <a:ext cx="247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02928"/>
              <a:r>
                <a:rPr lang="ja-JP" altLang="ja-JP" sz="726">
                  <a:solidFill>
                    <a:srgbClr val="000000"/>
                  </a:solidFill>
                </a:rPr>
                <a:t> DREB1A</a:t>
              </a:r>
              <a:endParaRPr lang="ja-JP" altLang="ja-JP" sz="1187"/>
            </a:p>
          </p:txBody>
        </p:sp>
        <p:sp>
          <p:nvSpPr>
            <p:cNvPr id="38" name="Freeform 39">
              <a:extLst>
                <a:ext uri="{FF2B5EF4-FFF2-40B4-BE49-F238E27FC236}">
                  <a16:creationId xmlns:a16="http://schemas.microsoft.com/office/drawing/2014/main" id="{58F5F8E4-6B71-F8E2-22FE-F539D8D4554A}"/>
                </a:ext>
              </a:extLst>
            </p:cNvPr>
            <p:cNvSpPr>
              <a:spLocks/>
            </p:cNvSpPr>
            <p:nvPr/>
          </p:nvSpPr>
          <p:spPr bwMode="auto">
            <a:xfrm>
              <a:off x="4182" y="2127"/>
              <a:ext cx="271" cy="78"/>
            </a:xfrm>
            <a:custGeom>
              <a:avLst/>
              <a:gdLst>
                <a:gd name="T0" fmla="*/ 0 w 271"/>
                <a:gd name="T1" fmla="*/ 78 h 78"/>
                <a:gd name="T2" fmla="*/ 0 w 271"/>
                <a:gd name="T3" fmla="*/ 0 h 78"/>
                <a:gd name="T4" fmla="*/ 271 w 271"/>
                <a:gd name="T5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1" h="78">
                  <a:moveTo>
                    <a:pt x="0" y="78"/>
                  </a:moveTo>
                  <a:lnTo>
                    <a:pt x="0" y="0"/>
                  </a:lnTo>
                  <a:lnTo>
                    <a:pt x="271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39" name="Rectangle 40">
              <a:extLst>
                <a:ext uri="{FF2B5EF4-FFF2-40B4-BE49-F238E27FC236}">
                  <a16:creationId xmlns:a16="http://schemas.microsoft.com/office/drawing/2014/main" id="{DBBF8916-B047-DAE1-0055-098BDB8688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41" y="2241"/>
              <a:ext cx="250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02928"/>
              <a:r>
                <a:rPr lang="ja-JP" altLang="ja-JP" sz="726">
                  <a:solidFill>
                    <a:srgbClr val="000000"/>
                  </a:solidFill>
                </a:rPr>
                <a:t> DREB1C</a:t>
              </a:r>
              <a:endParaRPr lang="ja-JP" altLang="ja-JP" sz="1187"/>
            </a:p>
          </p:txBody>
        </p:sp>
        <p:sp>
          <p:nvSpPr>
            <p:cNvPr id="40" name="Freeform 41">
              <a:extLst>
                <a:ext uri="{FF2B5EF4-FFF2-40B4-BE49-F238E27FC236}">
                  <a16:creationId xmlns:a16="http://schemas.microsoft.com/office/drawing/2014/main" id="{B01AD6E7-A8FC-C087-64A3-20B7414268ED}"/>
                </a:ext>
              </a:extLst>
            </p:cNvPr>
            <p:cNvSpPr>
              <a:spLocks/>
            </p:cNvSpPr>
            <p:nvPr/>
          </p:nvSpPr>
          <p:spPr bwMode="auto">
            <a:xfrm>
              <a:off x="4182" y="2211"/>
              <a:ext cx="247" cy="78"/>
            </a:xfrm>
            <a:custGeom>
              <a:avLst/>
              <a:gdLst>
                <a:gd name="T0" fmla="*/ 0 w 247"/>
                <a:gd name="T1" fmla="*/ 0 h 78"/>
                <a:gd name="T2" fmla="*/ 0 w 247"/>
                <a:gd name="T3" fmla="*/ 78 h 78"/>
                <a:gd name="T4" fmla="*/ 247 w 247"/>
                <a:gd name="T5" fmla="*/ 78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7" h="78">
                  <a:moveTo>
                    <a:pt x="0" y="0"/>
                  </a:moveTo>
                  <a:lnTo>
                    <a:pt x="0" y="78"/>
                  </a:lnTo>
                  <a:lnTo>
                    <a:pt x="247" y="7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41" name="Freeform 42">
              <a:extLst>
                <a:ext uri="{FF2B5EF4-FFF2-40B4-BE49-F238E27FC236}">
                  <a16:creationId xmlns:a16="http://schemas.microsoft.com/office/drawing/2014/main" id="{848B8E46-CDAD-E76A-308D-8E45BED95A32}"/>
                </a:ext>
              </a:extLst>
            </p:cNvPr>
            <p:cNvSpPr>
              <a:spLocks/>
            </p:cNvSpPr>
            <p:nvPr/>
          </p:nvSpPr>
          <p:spPr bwMode="auto">
            <a:xfrm>
              <a:off x="3810" y="2091"/>
              <a:ext cx="372" cy="114"/>
            </a:xfrm>
            <a:custGeom>
              <a:avLst/>
              <a:gdLst>
                <a:gd name="T0" fmla="*/ 0 w 372"/>
                <a:gd name="T1" fmla="*/ 0 h 114"/>
                <a:gd name="T2" fmla="*/ 0 w 372"/>
                <a:gd name="T3" fmla="*/ 114 h 114"/>
                <a:gd name="T4" fmla="*/ 372 w 372"/>
                <a:gd name="T5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2" h="114">
                  <a:moveTo>
                    <a:pt x="0" y="0"/>
                  </a:moveTo>
                  <a:lnTo>
                    <a:pt x="0" y="114"/>
                  </a:lnTo>
                  <a:lnTo>
                    <a:pt x="372" y="114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42" name="Freeform 43">
              <a:extLst>
                <a:ext uri="{FF2B5EF4-FFF2-40B4-BE49-F238E27FC236}">
                  <a16:creationId xmlns:a16="http://schemas.microsoft.com/office/drawing/2014/main" id="{422D67DF-7AE6-12FD-F9E5-AAC5780C5260}"/>
                </a:ext>
              </a:extLst>
            </p:cNvPr>
            <p:cNvSpPr>
              <a:spLocks/>
            </p:cNvSpPr>
            <p:nvPr/>
          </p:nvSpPr>
          <p:spPr bwMode="auto">
            <a:xfrm>
              <a:off x="3582" y="1947"/>
              <a:ext cx="228" cy="138"/>
            </a:xfrm>
            <a:custGeom>
              <a:avLst/>
              <a:gdLst>
                <a:gd name="T0" fmla="*/ 0 w 228"/>
                <a:gd name="T1" fmla="*/ 0 h 138"/>
                <a:gd name="T2" fmla="*/ 0 w 228"/>
                <a:gd name="T3" fmla="*/ 138 h 138"/>
                <a:gd name="T4" fmla="*/ 228 w 228"/>
                <a:gd name="T5" fmla="*/ 138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8" h="138">
                  <a:moveTo>
                    <a:pt x="0" y="0"/>
                  </a:moveTo>
                  <a:lnTo>
                    <a:pt x="0" y="138"/>
                  </a:lnTo>
                  <a:lnTo>
                    <a:pt x="228" y="13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43" name="Freeform 44">
              <a:extLst>
                <a:ext uri="{FF2B5EF4-FFF2-40B4-BE49-F238E27FC236}">
                  <a16:creationId xmlns:a16="http://schemas.microsoft.com/office/drawing/2014/main" id="{D2535FFB-BC28-0D33-59BD-707F622CDEEE}"/>
                </a:ext>
              </a:extLst>
            </p:cNvPr>
            <p:cNvSpPr>
              <a:spLocks/>
            </p:cNvSpPr>
            <p:nvPr/>
          </p:nvSpPr>
          <p:spPr bwMode="auto">
            <a:xfrm>
              <a:off x="3492" y="1754"/>
              <a:ext cx="90" cy="187"/>
            </a:xfrm>
            <a:custGeom>
              <a:avLst/>
              <a:gdLst>
                <a:gd name="T0" fmla="*/ 0 w 90"/>
                <a:gd name="T1" fmla="*/ 0 h 187"/>
                <a:gd name="T2" fmla="*/ 0 w 90"/>
                <a:gd name="T3" fmla="*/ 187 h 187"/>
                <a:gd name="T4" fmla="*/ 90 w 90"/>
                <a:gd name="T5" fmla="*/ 187 h 1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0" h="187">
                  <a:moveTo>
                    <a:pt x="0" y="0"/>
                  </a:moveTo>
                  <a:lnTo>
                    <a:pt x="0" y="187"/>
                  </a:lnTo>
                  <a:lnTo>
                    <a:pt x="90" y="187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44" name="Freeform 45">
              <a:extLst>
                <a:ext uri="{FF2B5EF4-FFF2-40B4-BE49-F238E27FC236}">
                  <a16:creationId xmlns:a16="http://schemas.microsoft.com/office/drawing/2014/main" id="{48BBEF0D-7D7B-C766-9EAE-35BE4140C072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2" y="1412"/>
              <a:ext cx="1280" cy="336"/>
            </a:xfrm>
            <a:custGeom>
              <a:avLst/>
              <a:gdLst>
                <a:gd name="T0" fmla="*/ 0 w 1280"/>
                <a:gd name="T1" fmla="*/ 0 h 336"/>
                <a:gd name="T2" fmla="*/ 0 w 1280"/>
                <a:gd name="T3" fmla="*/ 336 h 336"/>
                <a:gd name="T4" fmla="*/ 1280 w 1280"/>
                <a:gd name="T5" fmla="*/ 336 h 3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80" h="336">
                  <a:moveTo>
                    <a:pt x="0" y="0"/>
                  </a:moveTo>
                  <a:lnTo>
                    <a:pt x="0" y="336"/>
                  </a:lnTo>
                  <a:lnTo>
                    <a:pt x="1280" y="33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45" name="Freeform 46">
              <a:extLst>
                <a:ext uri="{FF2B5EF4-FFF2-40B4-BE49-F238E27FC236}">
                  <a16:creationId xmlns:a16="http://schemas.microsoft.com/office/drawing/2014/main" id="{4A0DBDF7-0780-CD57-A2EA-3ECA602B3BBE}"/>
                </a:ext>
              </a:extLst>
            </p:cNvPr>
            <p:cNvSpPr>
              <a:spLocks/>
            </p:cNvSpPr>
            <p:nvPr/>
          </p:nvSpPr>
          <p:spPr bwMode="auto">
            <a:xfrm>
              <a:off x="1347" y="1406"/>
              <a:ext cx="865" cy="523"/>
            </a:xfrm>
            <a:custGeom>
              <a:avLst/>
              <a:gdLst>
                <a:gd name="T0" fmla="*/ 0 w 865"/>
                <a:gd name="T1" fmla="*/ 523 h 523"/>
                <a:gd name="T2" fmla="*/ 0 w 865"/>
                <a:gd name="T3" fmla="*/ 0 h 523"/>
                <a:gd name="T4" fmla="*/ 865 w 865"/>
                <a:gd name="T5" fmla="*/ 0 h 5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65" h="523">
                  <a:moveTo>
                    <a:pt x="0" y="523"/>
                  </a:moveTo>
                  <a:lnTo>
                    <a:pt x="0" y="0"/>
                  </a:lnTo>
                  <a:lnTo>
                    <a:pt x="865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46" name="Rectangle 47">
              <a:extLst>
                <a:ext uri="{FF2B5EF4-FFF2-40B4-BE49-F238E27FC236}">
                  <a16:creationId xmlns:a16="http://schemas.microsoft.com/office/drawing/2014/main" id="{E2916BD2-4E37-598D-FE07-85D607935B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5" y="2403"/>
              <a:ext cx="307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02928"/>
              <a:r>
                <a:rPr lang="ja-JP" altLang="ja-JP" sz="726">
                  <a:solidFill>
                    <a:srgbClr val="000000"/>
                  </a:solidFill>
                </a:rPr>
                <a:t> APETALA2</a:t>
              </a:r>
              <a:endParaRPr lang="ja-JP" altLang="ja-JP" sz="1187"/>
            </a:p>
          </p:txBody>
        </p:sp>
        <p:sp>
          <p:nvSpPr>
            <p:cNvPr id="47" name="Freeform 48">
              <a:extLst>
                <a:ext uri="{FF2B5EF4-FFF2-40B4-BE49-F238E27FC236}">
                  <a16:creationId xmlns:a16="http://schemas.microsoft.com/office/drawing/2014/main" id="{EBD1D590-C529-0131-D85D-9E24AD72E1F1}"/>
                </a:ext>
              </a:extLst>
            </p:cNvPr>
            <p:cNvSpPr>
              <a:spLocks/>
            </p:cNvSpPr>
            <p:nvPr/>
          </p:nvSpPr>
          <p:spPr bwMode="auto">
            <a:xfrm>
              <a:off x="1347" y="1935"/>
              <a:ext cx="3436" cy="516"/>
            </a:xfrm>
            <a:custGeom>
              <a:avLst/>
              <a:gdLst>
                <a:gd name="T0" fmla="*/ 0 w 3436"/>
                <a:gd name="T1" fmla="*/ 0 h 516"/>
                <a:gd name="T2" fmla="*/ 0 w 3436"/>
                <a:gd name="T3" fmla="*/ 516 h 516"/>
                <a:gd name="T4" fmla="*/ 3436 w 3436"/>
                <a:gd name="T5" fmla="*/ 516 h 5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36" h="516">
                  <a:moveTo>
                    <a:pt x="0" y="0"/>
                  </a:moveTo>
                  <a:lnTo>
                    <a:pt x="0" y="516"/>
                  </a:lnTo>
                  <a:lnTo>
                    <a:pt x="3436" y="51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48" name="Line 49">
              <a:extLst>
                <a:ext uri="{FF2B5EF4-FFF2-40B4-BE49-F238E27FC236}">
                  <a16:creationId xmlns:a16="http://schemas.microsoft.com/office/drawing/2014/main" id="{54141874-5BC6-0916-4E6F-BE0AF699E1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67" y="2722"/>
              <a:ext cx="73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49" name="Line 50">
              <a:extLst>
                <a:ext uri="{FF2B5EF4-FFF2-40B4-BE49-F238E27FC236}">
                  <a16:creationId xmlns:a16="http://schemas.microsoft.com/office/drawing/2014/main" id="{BE31101D-D48B-0E5F-59B9-9FCFEDC85C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67" y="2698"/>
              <a:ext cx="0" cy="4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50" name="Line 51">
              <a:extLst>
                <a:ext uri="{FF2B5EF4-FFF2-40B4-BE49-F238E27FC236}">
                  <a16:creationId xmlns:a16="http://schemas.microsoft.com/office/drawing/2014/main" id="{9DCE68B7-B039-ED80-B23A-6EABC829AAD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00" y="2698"/>
              <a:ext cx="0" cy="4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0290" tIns="30145" rIns="60290" bIns="30145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888"/>
            </a:p>
          </p:txBody>
        </p:sp>
        <p:sp>
          <p:nvSpPr>
            <p:cNvPr id="51" name="Rectangle 52">
              <a:extLst>
                <a:ext uri="{FF2B5EF4-FFF2-40B4-BE49-F238E27FC236}">
                  <a16:creationId xmlns:a16="http://schemas.microsoft.com/office/drawing/2014/main" id="{724F0FE8-6C04-0796-FB27-E02D2EF264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8" y="2836"/>
              <a:ext cx="80" cy="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02928"/>
              <a:r>
                <a:rPr lang="ja-JP" altLang="ja-JP" sz="527">
                  <a:solidFill>
                    <a:srgbClr val="000000"/>
                  </a:solidFill>
                  <a:latin typeface="MS Sans Serif"/>
                </a:rPr>
                <a:t>0.10</a:t>
              </a:r>
              <a:endParaRPr lang="ja-JP" altLang="ja-JP" sz="1187"/>
            </a:p>
          </p:txBody>
        </p:sp>
      </p:grp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7691A928-F085-C6CD-9CDB-CDB8DF02F7DE}"/>
              </a:ext>
            </a:extLst>
          </p:cNvPr>
          <p:cNvSpPr txBox="1"/>
          <p:nvPr/>
        </p:nvSpPr>
        <p:spPr>
          <a:xfrm>
            <a:off x="-17479" y="4840806"/>
            <a:ext cx="914399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4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Supplemental Fig. S2 Phylogenetic tree of the Arabidopsis DREB proteins 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A phylogenetic tree was constructed using full-length amino acid sequences of Arabidopsis DREB proteins, including DREB1A-1F (At4g25480, At4g25490, At4g25470, At5g51990, At1g63030, At1g12610), DREB2A-2H (At5g05410, At3g11020, At2g40340, At1g75490, At2g38340, At3g57600, At5g18450, At2g40350), and APETALA2 (At4g36920). The neighbor-joining method with 1000 bootstrap replicates was employed for tree construction using MEGA7 software. 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sz="1400"/>
          </a:p>
        </p:txBody>
      </p:sp>
    </p:spTree>
    <p:extLst>
      <p:ext uri="{BB962C8B-B14F-4D97-AF65-F5344CB8AC3E}">
        <p14:creationId xmlns:p14="http://schemas.microsoft.com/office/powerpoint/2010/main" val="31404650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C59E668E-08C7-3D0A-9295-0376ED8D6F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5348" y="270862"/>
            <a:ext cx="4101426" cy="6330462"/>
          </a:xfrm>
          <a:prstGeom prst="rect">
            <a:avLst/>
          </a:prstGeom>
        </p:spPr>
      </p:pic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A3BDDAA2-6C74-0036-198F-93E0B68E5BF4}"/>
              </a:ext>
            </a:extLst>
          </p:cNvPr>
          <p:cNvSpPr/>
          <p:nvPr/>
        </p:nvSpPr>
        <p:spPr>
          <a:xfrm>
            <a:off x="2315425" y="2177409"/>
            <a:ext cx="1765560" cy="107212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62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514C8BD9-AC24-289B-E1E6-B9FE114618A1}"/>
              </a:ext>
            </a:extLst>
          </p:cNvPr>
          <p:cNvSpPr/>
          <p:nvPr/>
        </p:nvSpPr>
        <p:spPr>
          <a:xfrm>
            <a:off x="1054715" y="2972774"/>
            <a:ext cx="714780" cy="89794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62"/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AC65A7EE-DA56-E934-4957-6CC1279D0B31}"/>
              </a:ext>
            </a:extLst>
          </p:cNvPr>
          <p:cNvCxnSpPr/>
          <p:nvPr/>
        </p:nvCxnSpPr>
        <p:spPr>
          <a:xfrm>
            <a:off x="2365758" y="1777009"/>
            <a:ext cx="168425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233C8B9C-0AD5-A9BB-9448-33D6B283F196}"/>
              </a:ext>
            </a:extLst>
          </p:cNvPr>
          <p:cNvCxnSpPr>
            <a:cxnSpLocks/>
          </p:cNvCxnSpPr>
          <p:nvPr/>
        </p:nvCxnSpPr>
        <p:spPr>
          <a:xfrm>
            <a:off x="1054715" y="2572027"/>
            <a:ext cx="126071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4F63D43-B6CE-6B16-6B5B-FCE106B1BD85}"/>
              </a:ext>
            </a:extLst>
          </p:cNvPr>
          <p:cNvSpPr txBox="1"/>
          <p:nvPr/>
        </p:nvSpPr>
        <p:spPr>
          <a:xfrm>
            <a:off x="2770560" y="1730612"/>
            <a:ext cx="1101584" cy="1776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54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2/ERF DNA-binding domain</a:t>
            </a:r>
            <a:endParaRPr kumimoji="1" lang="ja-JP" altLang="en-US" sz="55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A3F6B6D9-49F9-9A28-BAD6-1EB72D62E571}"/>
              </a:ext>
            </a:extLst>
          </p:cNvPr>
          <p:cNvSpPr/>
          <p:nvPr/>
        </p:nvSpPr>
        <p:spPr>
          <a:xfrm>
            <a:off x="2316323" y="2056213"/>
            <a:ext cx="1765560" cy="107212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62"/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A366AAA9-4673-7C67-B1ED-F2D3466A496D}"/>
              </a:ext>
            </a:extLst>
          </p:cNvPr>
          <p:cNvSpPr/>
          <p:nvPr/>
        </p:nvSpPr>
        <p:spPr>
          <a:xfrm>
            <a:off x="1055613" y="2863085"/>
            <a:ext cx="714780" cy="89794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62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3CADE0C-FEE7-3C06-9FF5-AED088611588}"/>
              </a:ext>
            </a:extLst>
          </p:cNvPr>
          <p:cNvSpPr txBox="1"/>
          <p:nvPr/>
        </p:nvSpPr>
        <p:spPr>
          <a:xfrm>
            <a:off x="273307" y="270862"/>
            <a:ext cx="575799" cy="80483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OsDREB2A</a:t>
            </a:r>
            <a:endParaRPr kumimoji="1" lang="ja-JP" altLang="en-US" sz="554">
              <a:latin typeface="+mn-ea"/>
              <a:cs typeface="Times New Roman" panose="02020603050405020304" pitchFamily="18" charset="0"/>
            </a:endParaRP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Zm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Gm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B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C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G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1A39DDB-6DB0-901A-70ED-383E95C19BEA}"/>
              </a:ext>
            </a:extLst>
          </p:cNvPr>
          <p:cNvSpPr txBox="1"/>
          <p:nvPr/>
        </p:nvSpPr>
        <p:spPr>
          <a:xfrm>
            <a:off x="273307" y="1062386"/>
            <a:ext cx="575799" cy="80483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OsDREB2A</a:t>
            </a:r>
            <a:endParaRPr kumimoji="1" lang="ja-JP" altLang="en-US" sz="554">
              <a:latin typeface="+mn-ea"/>
              <a:cs typeface="Times New Roman" panose="02020603050405020304" pitchFamily="18" charset="0"/>
            </a:endParaRP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Zm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Gm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B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C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G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FE15C5A-B8CA-9F0A-542C-A7827BB861E9}"/>
              </a:ext>
            </a:extLst>
          </p:cNvPr>
          <p:cNvSpPr txBox="1"/>
          <p:nvPr/>
        </p:nvSpPr>
        <p:spPr>
          <a:xfrm>
            <a:off x="273307" y="1853909"/>
            <a:ext cx="575799" cy="80483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OsDREB2A</a:t>
            </a:r>
            <a:endParaRPr kumimoji="1" lang="ja-JP" altLang="en-US" sz="554">
              <a:latin typeface="+mn-ea"/>
              <a:cs typeface="Times New Roman" panose="02020603050405020304" pitchFamily="18" charset="0"/>
            </a:endParaRP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Zm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Gm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B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C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G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CD89ACE-3834-0D4F-3AFB-3CAFDC3E97A1}"/>
              </a:ext>
            </a:extLst>
          </p:cNvPr>
          <p:cNvSpPr txBox="1"/>
          <p:nvPr/>
        </p:nvSpPr>
        <p:spPr>
          <a:xfrm>
            <a:off x="273307" y="2636947"/>
            <a:ext cx="575799" cy="80483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OsDREB2A</a:t>
            </a:r>
            <a:endParaRPr kumimoji="1" lang="ja-JP" altLang="en-US" sz="554">
              <a:latin typeface="+mn-ea"/>
              <a:cs typeface="Times New Roman" panose="02020603050405020304" pitchFamily="18" charset="0"/>
            </a:endParaRP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Zm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Gm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B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C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G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F650ED1-C404-CDB6-866D-D40EC8ADD449}"/>
              </a:ext>
            </a:extLst>
          </p:cNvPr>
          <p:cNvSpPr txBox="1"/>
          <p:nvPr/>
        </p:nvSpPr>
        <p:spPr>
          <a:xfrm>
            <a:off x="273307" y="3436093"/>
            <a:ext cx="575799" cy="80483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OsDREB2A</a:t>
            </a:r>
            <a:endParaRPr kumimoji="1" lang="ja-JP" altLang="en-US" sz="554">
              <a:latin typeface="+mn-ea"/>
              <a:cs typeface="Times New Roman" panose="02020603050405020304" pitchFamily="18" charset="0"/>
            </a:endParaRP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Zm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Gm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B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C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G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7ADDC2F-62E2-CFE0-FCAC-1DA36824C789}"/>
              </a:ext>
            </a:extLst>
          </p:cNvPr>
          <p:cNvSpPr txBox="1"/>
          <p:nvPr/>
        </p:nvSpPr>
        <p:spPr>
          <a:xfrm>
            <a:off x="273307" y="4236508"/>
            <a:ext cx="575799" cy="80483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OsDREB2A</a:t>
            </a:r>
            <a:endParaRPr kumimoji="1" lang="ja-JP" altLang="en-US" sz="554">
              <a:latin typeface="+mn-ea"/>
              <a:cs typeface="Times New Roman" panose="02020603050405020304" pitchFamily="18" charset="0"/>
            </a:endParaRP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Zm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Gm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B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C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G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C8D260F-E3FA-A022-746C-75208069CFBA}"/>
              </a:ext>
            </a:extLst>
          </p:cNvPr>
          <p:cNvSpPr txBox="1"/>
          <p:nvPr/>
        </p:nvSpPr>
        <p:spPr>
          <a:xfrm>
            <a:off x="273307" y="5018276"/>
            <a:ext cx="575799" cy="80483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OsDREB2A</a:t>
            </a:r>
            <a:endParaRPr kumimoji="1" lang="ja-JP" altLang="en-US" sz="554">
              <a:latin typeface="+mn-ea"/>
              <a:cs typeface="Times New Roman" panose="02020603050405020304" pitchFamily="18" charset="0"/>
            </a:endParaRP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Zm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Gm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B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C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G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FD6908C-13EF-6718-D831-5F839D376C66}"/>
              </a:ext>
            </a:extLst>
          </p:cNvPr>
          <p:cNvSpPr txBox="1"/>
          <p:nvPr/>
        </p:nvSpPr>
        <p:spPr>
          <a:xfrm>
            <a:off x="273307" y="5797525"/>
            <a:ext cx="575799" cy="80483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OsDREB2A</a:t>
            </a:r>
            <a:endParaRPr kumimoji="1" lang="ja-JP" altLang="en-US" sz="554">
              <a:latin typeface="+mn-ea"/>
              <a:cs typeface="Times New Roman" panose="02020603050405020304" pitchFamily="18" charset="0"/>
            </a:endParaRP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Zm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Gm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A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B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C</a:t>
            </a:r>
          </a:p>
          <a:p>
            <a:pPr>
              <a:lnSpc>
                <a:spcPts val="775"/>
              </a:lnSpc>
            </a:pPr>
            <a:r>
              <a:rPr kumimoji="1" lang="en-US" altLang="ja-JP" sz="554" dirty="0">
                <a:latin typeface="+mn-ea"/>
                <a:cs typeface="Times New Roman" panose="02020603050405020304" pitchFamily="18" charset="0"/>
              </a:rPr>
              <a:t>AtDREB2G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45A06A3-6B24-3971-D97F-1653BA67A193}"/>
              </a:ext>
            </a:extLst>
          </p:cNvPr>
          <p:cNvSpPr txBox="1"/>
          <p:nvPr/>
        </p:nvSpPr>
        <p:spPr>
          <a:xfrm>
            <a:off x="4437841" y="2114928"/>
            <a:ext cx="4432852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4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Supplemental Fig. S3 Amino acid sequence alignment of DREB2 proteins from</a:t>
            </a:r>
            <a:r>
              <a:rPr lang="en-US" altLang="ja-JP" sz="1400" b="1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altLang="ja-JP" sz="14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Arabidopsis, rice, maize, and soybean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Underlines indicate the AP2/ERF DNA binding domain, while red boxes indicate the negative regulatory domain. The sequences used in this analysis are as follows: OsDREB2A (AF300971); ZmDREB2A (AB218832); GmDREB2A (NP_001240942); AtDREB2A-C (At5g05410, At3g11020, At2g40340); and AtDREB2G (At5g18450). 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sz="1400"/>
          </a:p>
        </p:txBody>
      </p:sp>
    </p:spTree>
    <p:extLst>
      <p:ext uri="{BB962C8B-B14F-4D97-AF65-F5344CB8AC3E}">
        <p14:creationId xmlns:p14="http://schemas.microsoft.com/office/powerpoint/2010/main" val="30197850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0280660-AEB4-C543-9B0E-5FA4EDC03C1F}"/>
              </a:ext>
            </a:extLst>
          </p:cNvPr>
          <p:cNvSpPr txBox="1"/>
          <p:nvPr/>
        </p:nvSpPr>
        <p:spPr>
          <a:xfrm>
            <a:off x="1179676" y="1904731"/>
            <a:ext cx="243978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dirty="0">
                <a:latin typeface="Helvetica" pitchFamily="2" charset="0"/>
              </a:rPr>
              <a:t>0</a:t>
            </a:r>
            <a:endParaRPr kumimoji="1" lang="ja-JP" altLang="en-US" sz="831">
              <a:latin typeface="Helvetica" pitchFamily="2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9D57340-9D9E-3741-A3A9-B35DDB6B3FD6}"/>
              </a:ext>
            </a:extLst>
          </p:cNvPr>
          <p:cNvSpPr txBox="1"/>
          <p:nvPr/>
        </p:nvSpPr>
        <p:spPr>
          <a:xfrm>
            <a:off x="1724113" y="1904731"/>
            <a:ext cx="243978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dirty="0">
                <a:latin typeface="Helvetica" pitchFamily="2" charset="0"/>
              </a:rPr>
              <a:t>3</a:t>
            </a:r>
            <a:endParaRPr kumimoji="1" lang="ja-JP" altLang="en-US" sz="831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75C5C5D-86C2-934F-A186-E20DB928F9D0}"/>
              </a:ext>
            </a:extLst>
          </p:cNvPr>
          <p:cNvSpPr txBox="1"/>
          <p:nvPr/>
        </p:nvSpPr>
        <p:spPr>
          <a:xfrm>
            <a:off x="2275826" y="1904731"/>
            <a:ext cx="243978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dirty="0">
                <a:latin typeface="Helvetica" pitchFamily="2" charset="0"/>
              </a:rPr>
              <a:t>6</a:t>
            </a:r>
            <a:endParaRPr kumimoji="1" lang="ja-JP" altLang="en-US" sz="831">
              <a:latin typeface="Helvetica" pitchFamily="2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F44AB9C-C0BF-3E46-92BF-36B7E45E5937}"/>
              </a:ext>
            </a:extLst>
          </p:cNvPr>
          <p:cNvSpPr txBox="1"/>
          <p:nvPr/>
        </p:nvSpPr>
        <p:spPr>
          <a:xfrm>
            <a:off x="2439083" y="1904731"/>
            <a:ext cx="407662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31" dirty="0">
                <a:latin typeface="Helvetica" pitchFamily="2" charset="0"/>
              </a:rPr>
              <a:t>(h)</a:t>
            </a:r>
            <a:endParaRPr kumimoji="1" lang="ja-JP" altLang="en-US" sz="831">
              <a:latin typeface="Helvetica" pitchFamily="2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A90C9C7-215E-CA45-AACE-D4BE312CE804}"/>
              </a:ext>
            </a:extLst>
          </p:cNvPr>
          <p:cNvSpPr txBox="1"/>
          <p:nvPr/>
        </p:nvSpPr>
        <p:spPr>
          <a:xfrm rot="16200000">
            <a:off x="164099" y="1191984"/>
            <a:ext cx="1168910" cy="2140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91" dirty="0">
                <a:latin typeface="Helvetica" pitchFamily="2" charset="0"/>
              </a:rPr>
              <a:t>Relative mRNA levels</a:t>
            </a:r>
            <a:endParaRPr kumimoji="1" lang="ja-JP" altLang="en-US" sz="791">
              <a:latin typeface="Helvetica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735AB41-95F6-CD44-BD99-0DC4485B2970}"/>
              </a:ext>
            </a:extLst>
          </p:cNvPr>
          <p:cNvSpPr txBox="1"/>
          <p:nvPr/>
        </p:nvSpPr>
        <p:spPr>
          <a:xfrm>
            <a:off x="1751569" y="1004648"/>
            <a:ext cx="218994" cy="193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b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E48F0CB-E2A8-AB43-8F74-BD23292F2613}"/>
              </a:ext>
            </a:extLst>
          </p:cNvPr>
          <p:cNvSpPr txBox="1"/>
          <p:nvPr/>
        </p:nvSpPr>
        <p:spPr>
          <a:xfrm>
            <a:off x="2293350" y="781839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CBB56E5-882A-9449-BFCD-B7FD8EB9B080}"/>
              </a:ext>
            </a:extLst>
          </p:cNvPr>
          <p:cNvSpPr txBox="1"/>
          <p:nvPr/>
        </p:nvSpPr>
        <p:spPr>
          <a:xfrm>
            <a:off x="1179676" y="6324842"/>
            <a:ext cx="243978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dirty="0">
                <a:latin typeface="Helvetica" pitchFamily="2" charset="0"/>
              </a:rPr>
              <a:t>0</a:t>
            </a:r>
            <a:endParaRPr kumimoji="1" lang="ja-JP" altLang="en-US" sz="831">
              <a:latin typeface="Helvetica" pitchFamily="2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A4CF072-00E4-C041-8AA0-79DF99D88C87}"/>
              </a:ext>
            </a:extLst>
          </p:cNvPr>
          <p:cNvSpPr txBox="1"/>
          <p:nvPr/>
        </p:nvSpPr>
        <p:spPr>
          <a:xfrm>
            <a:off x="1724113" y="6324842"/>
            <a:ext cx="243978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dirty="0">
                <a:latin typeface="Helvetica" pitchFamily="2" charset="0"/>
              </a:rPr>
              <a:t>3</a:t>
            </a:r>
            <a:endParaRPr kumimoji="1" lang="ja-JP" altLang="en-US" sz="831">
              <a:latin typeface="Helvetica" pitchFamily="2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69C46F7-6547-E84F-8C38-BD9198696FE4}"/>
              </a:ext>
            </a:extLst>
          </p:cNvPr>
          <p:cNvSpPr txBox="1"/>
          <p:nvPr/>
        </p:nvSpPr>
        <p:spPr>
          <a:xfrm>
            <a:off x="2275826" y="6324842"/>
            <a:ext cx="243978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dirty="0">
                <a:latin typeface="Helvetica" pitchFamily="2" charset="0"/>
              </a:rPr>
              <a:t>6</a:t>
            </a:r>
            <a:endParaRPr kumimoji="1" lang="ja-JP" altLang="en-US" sz="831">
              <a:latin typeface="Helvetica" pitchFamily="2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3F4B967-0BDC-9241-946E-0469D4F9E074}"/>
              </a:ext>
            </a:extLst>
          </p:cNvPr>
          <p:cNvSpPr txBox="1"/>
          <p:nvPr/>
        </p:nvSpPr>
        <p:spPr>
          <a:xfrm>
            <a:off x="2439083" y="6324842"/>
            <a:ext cx="407662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31" dirty="0">
                <a:latin typeface="Helvetica" pitchFamily="2" charset="0"/>
              </a:rPr>
              <a:t>(h)</a:t>
            </a:r>
            <a:endParaRPr kumimoji="1" lang="ja-JP" altLang="en-US" sz="831">
              <a:latin typeface="Helvetica" pitchFamily="2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CFB3EABE-B05F-3F45-9255-1E1D657ADA82}"/>
              </a:ext>
            </a:extLst>
          </p:cNvPr>
          <p:cNvSpPr txBox="1"/>
          <p:nvPr/>
        </p:nvSpPr>
        <p:spPr>
          <a:xfrm rot="16200000">
            <a:off x="3199775" y="4122684"/>
            <a:ext cx="1075936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dirty="0">
                <a:latin typeface="Helvetica" pitchFamily="2" charset="0"/>
              </a:rPr>
              <a:t>FAD (nmol g</a:t>
            </a:r>
            <a:r>
              <a:rPr kumimoji="1" lang="en-US" altLang="ja-JP" sz="831" baseline="30000" dirty="0">
                <a:latin typeface="Helvetica" pitchFamily="2" charset="0"/>
              </a:rPr>
              <a:t>-1</a:t>
            </a:r>
            <a:r>
              <a:rPr kumimoji="1" lang="en-US" altLang="ja-JP" sz="831" dirty="0">
                <a:latin typeface="Helvetica" pitchFamily="2" charset="0"/>
              </a:rPr>
              <a:t> FW)</a:t>
            </a:r>
            <a:endParaRPr kumimoji="1" lang="ja-JP" altLang="en-US" sz="831">
              <a:latin typeface="Helvetica" pitchFamily="2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6CE95F40-4229-9C42-B3AD-B94CC1AAFBCC}"/>
              </a:ext>
            </a:extLst>
          </p:cNvPr>
          <p:cNvSpPr txBox="1"/>
          <p:nvPr/>
        </p:nvSpPr>
        <p:spPr>
          <a:xfrm rot="16200000">
            <a:off x="3183682" y="2586251"/>
            <a:ext cx="1093569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dirty="0">
                <a:latin typeface="Helvetica" pitchFamily="2" charset="0"/>
              </a:rPr>
              <a:t>FMN (nmol g</a:t>
            </a:r>
            <a:r>
              <a:rPr kumimoji="1" lang="en-US" altLang="ja-JP" sz="831" baseline="30000" dirty="0">
                <a:latin typeface="Helvetica" pitchFamily="2" charset="0"/>
              </a:rPr>
              <a:t>-1</a:t>
            </a:r>
            <a:r>
              <a:rPr kumimoji="1" lang="en-US" altLang="ja-JP" sz="831" dirty="0">
                <a:latin typeface="Helvetica" pitchFamily="2" charset="0"/>
              </a:rPr>
              <a:t> FW)</a:t>
            </a:r>
            <a:endParaRPr kumimoji="1" lang="ja-JP" altLang="en-US" sz="831">
              <a:latin typeface="Helvetica" pitchFamily="2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0F698BF2-3B7D-E44A-AB30-7A88F94576E5}"/>
              </a:ext>
            </a:extLst>
          </p:cNvPr>
          <p:cNvSpPr txBox="1"/>
          <p:nvPr/>
        </p:nvSpPr>
        <p:spPr>
          <a:xfrm rot="16200000">
            <a:off x="3227765" y="1237407"/>
            <a:ext cx="1005403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dirty="0">
                <a:latin typeface="Helvetica" pitchFamily="2" charset="0"/>
              </a:rPr>
              <a:t>RF (nmol g</a:t>
            </a:r>
            <a:r>
              <a:rPr kumimoji="1" lang="en-US" altLang="ja-JP" sz="831" baseline="30000" dirty="0">
                <a:latin typeface="Helvetica" pitchFamily="2" charset="0"/>
              </a:rPr>
              <a:t>-1</a:t>
            </a:r>
            <a:r>
              <a:rPr kumimoji="1" lang="en-US" altLang="ja-JP" sz="831" dirty="0">
                <a:latin typeface="Helvetica" pitchFamily="2" charset="0"/>
              </a:rPr>
              <a:t> FW)</a:t>
            </a:r>
            <a:endParaRPr kumimoji="1" lang="ja-JP" altLang="en-US" sz="831">
              <a:latin typeface="Helvetica" pitchFamily="2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0917F051-EB0D-4C44-B8C4-7010AA3D9DA6}"/>
              </a:ext>
            </a:extLst>
          </p:cNvPr>
          <p:cNvSpPr txBox="1"/>
          <p:nvPr/>
        </p:nvSpPr>
        <p:spPr>
          <a:xfrm>
            <a:off x="12030" y="526767"/>
            <a:ext cx="311304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77" dirty="0">
                <a:latin typeface="Helvetica" pitchFamily="2" charset="0"/>
              </a:rPr>
              <a:t>A</a:t>
            </a:r>
            <a:endParaRPr kumimoji="1" lang="ja-JP" altLang="en-US" sz="1477">
              <a:latin typeface="Helvetica" pitchFamily="2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8E377B7D-C22D-5E44-A5DC-C1EB24FF85F1}"/>
              </a:ext>
            </a:extLst>
          </p:cNvPr>
          <p:cNvSpPr txBox="1"/>
          <p:nvPr/>
        </p:nvSpPr>
        <p:spPr>
          <a:xfrm>
            <a:off x="3317335" y="526767"/>
            <a:ext cx="320922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77" dirty="0">
                <a:latin typeface="Helvetica" pitchFamily="2" charset="0"/>
              </a:rPr>
              <a:t>C</a:t>
            </a:r>
            <a:endParaRPr kumimoji="1" lang="ja-JP" altLang="en-US" sz="1477">
              <a:latin typeface="Helvetica" pitchFamily="2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5C3AFE9B-F81F-514E-AAAE-0B9A2C16737A}"/>
              </a:ext>
            </a:extLst>
          </p:cNvPr>
          <p:cNvSpPr txBox="1"/>
          <p:nvPr/>
        </p:nvSpPr>
        <p:spPr>
          <a:xfrm>
            <a:off x="0" y="2017439"/>
            <a:ext cx="311304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77" dirty="0">
                <a:latin typeface="Helvetica" pitchFamily="2" charset="0"/>
              </a:rPr>
              <a:t>B</a:t>
            </a:r>
            <a:endParaRPr kumimoji="1" lang="ja-JP" altLang="en-US" sz="1477">
              <a:latin typeface="Helvetica" pitchFamily="2" charset="0"/>
            </a:endParaRPr>
          </a:p>
        </p:txBody>
      </p:sp>
      <p:graphicFrame>
        <p:nvGraphicFramePr>
          <p:cNvPr id="43" name="グラフ 42">
            <a:extLst>
              <a:ext uri="{FF2B5EF4-FFF2-40B4-BE49-F238E27FC236}">
                <a16:creationId xmlns:a16="http://schemas.microsoft.com/office/drawing/2014/main" id="{D7666326-8912-8249-B778-567B903900C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96134166"/>
              </p:ext>
            </p:extLst>
          </p:nvPr>
        </p:nvGraphicFramePr>
        <p:xfrm>
          <a:off x="826720" y="552831"/>
          <a:ext cx="1979228" cy="15723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5280A44-A507-1B4B-B3B1-3B5530979FDC}"/>
              </a:ext>
            </a:extLst>
          </p:cNvPr>
          <p:cNvSpPr txBox="1"/>
          <p:nvPr/>
        </p:nvSpPr>
        <p:spPr>
          <a:xfrm>
            <a:off x="1207126" y="1631995"/>
            <a:ext cx="218994" cy="193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b</a:t>
            </a:r>
            <a:endParaRPr kumimoji="1" lang="ja-JP" altLang="en-US" sz="659">
              <a:latin typeface="Helvetica" pitchFamily="2" charset="0"/>
            </a:endParaRPr>
          </a:p>
        </p:txBody>
      </p:sp>
      <p:graphicFrame>
        <p:nvGraphicFramePr>
          <p:cNvPr id="72" name="グラフ 71">
            <a:extLst>
              <a:ext uri="{FF2B5EF4-FFF2-40B4-BE49-F238E27FC236}">
                <a16:creationId xmlns:a16="http://schemas.microsoft.com/office/drawing/2014/main" id="{C0C037EF-BF47-F447-BFD3-41822FA89DE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10667148"/>
              </p:ext>
            </p:extLst>
          </p:nvPr>
        </p:nvGraphicFramePr>
        <p:xfrm>
          <a:off x="696445" y="2227089"/>
          <a:ext cx="2077842" cy="1518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3" name="グラフ 72">
            <a:extLst>
              <a:ext uri="{FF2B5EF4-FFF2-40B4-BE49-F238E27FC236}">
                <a16:creationId xmlns:a16="http://schemas.microsoft.com/office/drawing/2014/main" id="{7FD62C29-6589-454A-B8A4-ADFDF01EE64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58257675"/>
              </p:ext>
            </p:extLst>
          </p:nvPr>
        </p:nvGraphicFramePr>
        <p:xfrm>
          <a:off x="650576" y="3592212"/>
          <a:ext cx="2191399" cy="17377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4" name="グラフ 73">
            <a:extLst>
              <a:ext uri="{FF2B5EF4-FFF2-40B4-BE49-F238E27FC236}">
                <a16:creationId xmlns:a16="http://schemas.microsoft.com/office/drawing/2014/main" id="{109DC768-5A3F-714F-B8CE-FCC6CC6903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38262276"/>
              </p:ext>
            </p:extLst>
          </p:nvPr>
        </p:nvGraphicFramePr>
        <p:xfrm>
          <a:off x="677731" y="4986704"/>
          <a:ext cx="2077842" cy="1575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0EC87D49-B28F-2039-B19C-1CAA9CDEAC70}"/>
              </a:ext>
            </a:extLst>
          </p:cNvPr>
          <p:cNvSpPr txBox="1"/>
          <p:nvPr/>
        </p:nvSpPr>
        <p:spPr>
          <a:xfrm>
            <a:off x="2369506" y="2489120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2F6DBE63-4DB3-1201-B53C-A75282AA2D4A}"/>
              </a:ext>
            </a:extLst>
          </p:cNvPr>
          <p:cNvSpPr txBox="1"/>
          <p:nvPr/>
        </p:nvSpPr>
        <p:spPr>
          <a:xfrm>
            <a:off x="2218780" y="2505867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B0036744-C0D0-F1FB-E4AB-59548AFE9135}"/>
              </a:ext>
            </a:extLst>
          </p:cNvPr>
          <p:cNvSpPr txBox="1"/>
          <p:nvPr/>
        </p:nvSpPr>
        <p:spPr>
          <a:xfrm>
            <a:off x="1816846" y="2556108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0AAC3A41-D2C4-934A-DBAA-6BE8C1CF0A08}"/>
              </a:ext>
            </a:extLst>
          </p:cNvPr>
          <p:cNvSpPr txBox="1"/>
          <p:nvPr/>
        </p:nvSpPr>
        <p:spPr>
          <a:xfrm>
            <a:off x="1666121" y="2648218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7D75394C-5DD2-42B7-F7DD-640B2C3BD319}"/>
              </a:ext>
            </a:extLst>
          </p:cNvPr>
          <p:cNvSpPr txBox="1"/>
          <p:nvPr/>
        </p:nvSpPr>
        <p:spPr>
          <a:xfrm>
            <a:off x="1272561" y="2656592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168161F1-7309-943C-E222-68D5D8980648}"/>
              </a:ext>
            </a:extLst>
          </p:cNvPr>
          <p:cNvSpPr txBox="1"/>
          <p:nvPr/>
        </p:nvSpPr>
        <p:spPr>
          <a:xfrm>
            <a:off x="1113462" y="2514240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E05BC911-13B6-44A2-A54E-91495941114F}"/>
              </a:ext>
            </a:extLst>
          </p:cNvPr>
          <p:cNvSpPr txBox="1"/>
          <p:nvPr/>
        </p:nvSpPr>
        <p:spPr>
          <a:xfrm>
            <a:off x="2369506" y="4013120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DF76F5B7-CAAB-B570-BE28-07F4A033DE7E}"/>
              </a:ext>
            </a:extLst>
          </p:cNvPr>
          <p:cNvSpPr txBox="1"/>
          <p:nvPr/>
        </p:nvSpPr>
        <p:spPr>
          <a:xfrm>
            <a:off x="2218780" y="3946130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5416426F-7371-64DE-FA98-535B6B6CC8F0}"/>
              </a:ext>
            </a:extLst>
          </p:cNvPr>
          <p:cNvSpPr txBox="1"/>
          <p:nvPr/>
        </p:nvSpPr>
        <p:spPr>
          <a:xfrm>
            <a:off x="1825220" y="4138724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E05227EF-0F25-8F50-F945-E8EAF367CCAC}"/>
              </a:ext>
            </a:extLst>
          </p:cNvPr>
          <p:cNvSpPr txBox="1"/>
          <p:nvPr/>
        </p:nvSpPr>
        <p:spPr>
          <a:xfrm>
            <a:off x="1674494" y="4113603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7C739E31-5B87-32F2-475F-471CABE10D23}"/>
              </a:ext>
            </a:extLst>
          </p:cNvPr>
          <p:cNvSpPr txBox="1"/>
          <p:nvPr/>
        </p:nvSpPr>
        <p:spPr>
          <a:xfrm>
            <a:off x="1280934" y="4054988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90C170D7-000A-E666-E8A8-5682B9798E33}"/>
              </a:ext>
            </a:extLst>
          </p:cNvPr>
          <p:cNvSpPr txBox="1"/>
          <p:nvPr/>
        </p:nvSpPr>
        <p:spPr>
          <a:xfrm>
            <a:off x="1121835" y="3912636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7622F690-3CDD-9798-0240-F8F9E69AB7C6}"/>
              </a:ext>
            </a:extLst>
          </p:cNvPr>
          <p:cNvSpPr txBox="1"/>
          <p:nvPr/>
        </p:nvSpPr>
        <p:spPr>
          <a:xfrm>
            <a:off x="2376782" y="5084944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5A532DDB-9BEC-67B2-F51A-38145A0E381A}"/>
              </a:ext>
            </a:extLst>
          </p:cNvPr>
          <p:cNvSpPr txBox="1"/>
          <p:nvPr/>
        </p:nvSpPr>
        <p:spPr>
          <a:xfrm>
            <a:off x="2226057" y="5277537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8764BB55-664E-23BC-7E73-0A4C0DFCAD5C}"/>
              </a:ext>
            </a:extLst>
          </p:cNvPr>
          <p:cNvSpPr txBox="1"/>
          <p:nvPr/>
        </p:nvSpPr>
        <p:spPr>
          <a:xfrm>
            <a:off x="1832496" y="5302658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C286189F-98D3-841A-1117-25621A6B75A4}"/>
              </a:ext>
            </a:extLst>
          </p:cNvPr>
          <p:cNvSpPr txBox="1"/>
          <p:nvPr/>
        </p:nvSpPr>
        <p:spPr>
          <a:xfrm>
            <a:off x="1673398" y="5311031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D600330A-60E7-DAFD-638A-E973E3881510}"/>
              </a:ext>
            </a:extLst>
          </p:cNvPr>
          <p:cNvSpPr txBox="1"/>
          <p:nvPr/>
        </p:nvSpPr>
        <p:spPr>
          <a:xfrm>
            <a:off x="1288210" y="5620856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b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061311C5-E2BA-2B55-5920-38D8930DA038}"/>
              </a:ext>
            </a:extLst>
          </p:cNvPr>
          <p:cNvSpPr txBox="1"/>
          <p:nvPr/>
        </p:nvSpPr>
        <p:spPr>
          <a:xfrm>
            <a:off x="1129112" y="5629229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b</a:t>
            </a:r>
            <a:endParaRPr kumimoji="1" lang="ja-JP" altLang="en-US" sz="659">
              <a:latin typeface="Helvetica" pitchFamily="2" charset="0"/>
            </a:endParaRPr>
          </a:p>
        </p:txBody>
      </p:sp>
      <p:graphicFrame>
        <p:nvGraphicFramePr>
          <p:cNvPr id="94" name="グラフ 93">
            <a:extLst>
              <a:ext uri="{FF2B5EF4-FFF2-40B4-BE49-F238E27FC236}">
                <a16:creationId xmlns:a16="http://schemas.microsoft.com/office/drawing/2014/main" id="{49A57E89-1687-ED41-AF55-52CE4A7EFA7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54228288"/>
              </p:ext>
            </p:extLst>
          </p:nvPr>
        </p:nvGraphicFramePr>
        <p:xfrm>
          <a:off x="3782261" y="653090"/>
          <a:ext cx="1985069" cy="14721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5" name="グラフ 94">
            <a:extLst>
              <a:ext uri="{FF2B5EF4-FFF2-40B4-BE49-F238E27FC236}">
                <a16:creationId xmlns:a16="http://schemas.microsoft.com/office/drawing/2014/main" id="{93460A62-3BC0-3A40-8908-131415E9EF7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34405866"/>
              </p:ext>
            </p:extLst>
          </p:nvPr>
        </p:nvGraphicFramePr>
        <p:xfrm>
          <a:off x="3840524" y="2112033"/>
          <a:ext cx="1979228" cy="14721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6" name="グラフ 95">
            <a:extLst>
              <a:ext uri="{FF2B5EF4-FFF2-40B4-BE49-F238E27FC236}">
                <a16:creationId xmlns:a16="http://schemas.microsoft.com/office/drawing/2014/main" id="{5C80BA02-00F3-BE41-ABAD-1E9215D62C0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3080003"/>
              </p:ext>
            </p:extLst>
          </p:nvPr>
        </p:nvGraphicFramePr>
        <p:xfrm>
          <a:off x="3931912" y="3575658"/>
          <a:ext cx="1850191" cy="14164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37E3E27A-33A8-A439-2840-0530FEEA9B92}"/>
              </a:ext>
            </a:extLst>
          </p:cNvPr>
          <p:cNvSpPr txBox="1"/>
          <p:nvPr/>
        </p:nvSpPr>
        <p:spPr>
          <a:xfrm>
            <a:off x="4252196" y="4883437"/>
            <a:ext cx="243978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dirty="0">
                <a:latin typeface="Helvetica" pitchFamily="2" charset="0"/>
              </a:rPr>
              <a:t>0</a:t>
            </a:r>
            <a:endParaRPr kumimoji="1" lang="ja-JP" altLang="en-US" sz="831">
              <a:latin typeface="Helvetica" pitchFamily="2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0D56D943-8DA7-95C0-3776-D89A16210FED}"/>
              </a:ext>
            </a:extLst>
          </p:cNvPr>
          <p:cNvSpPr txBox="1"/>
          <p:nvPr/>
        </p:nvSpPr>
        <p:spPr>
          <a:xfrm>
            <a:off x="4796633" y="4883437"/>
            <a:ext cx="243978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dirty="0">
                <a:latin typeface="Helvetica" pitchFamily="2" charset="0"/>
              </a:rPr>
              <a:t>3</a:t>
            </a:r>
            <a:endParaRPr kumimoji="1" lang="ja-JP" altLang="en-US" sz="831">
              <a:latin typeface="Helvetica" pitchFamily="2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9161BF66-06AA-4C0F-BFEB-D212A2149C74}"/>
              </a:ext>
            </a:extLst>
          </p:cNvPr>
          <p:cNvSpPr txBox="1"/>
          <p:nvPr/>
        </p:nvSpPr>
        <p:spPr>
          <a:xfrm>
            <a:off x="5348347" y="4883437"/>
            <a:ext cx="243978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dirty="0">
                <a:latin typeface="Helvetica" pitchFamily="2" charset="0"/>
              </a:rPr>
              <a:t>6</a:t>
            </a:r>
            <a:endParaRPr kumimoji="1" lang="ja-JP" altLang="en-US" sz="831">
              <a:latin typeface="Helvetica" pitchFamily="2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7F19F0B4-93E1-1F97-2E36-DADFD4F62E1E}"/>
              </a:ext>
            </a:extLst>
          </p:cNvPr>
          <p:cNvSpPr txBox="1"/>
          <p:nvPr/>
        </p:nvSpPr>
        <p:spPr>
          <a:xfrm>
            <a:off x="5511604" y="4883437"/>
            <a:ext cx="407662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31" dirty="0">
                <a:latin typeface="Helvetica" pitchFamily="2" charset="0"/>
              </a:rPr>
              <a:t>(h)</a:t>
            </a:r>
            <a:endParaRPr kumimoji="1" lang="ja-JP" altLang="en-US" sz="831">
              <a:latin typeface="Helvetica" pitchFamily="2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A0A497D8-900D-5C65-3BC1-0CF4FE6AA69B}"/>
              </a:ext>
            </a:extLst>
          </p:cNvPr>
          <p:cNvSpPr txBox="1"/>
          <p:nvPr/>
        </p:nvSpPr>
        <p:spPr>
          <a:xfrm>
            <a:off x="4159655" y="828741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A03C66F2-B01A-179F-D301-E6CCBB8FD8BA}"/>
              </a:ext>
            </a:extLst>
          </p:cNvPr>
          <p:cNvSpPr txBox="1"/>
          <p:nvPr/>
        </p:nvSpPr>
        <p:spPr>
          <a:xfrm>
            <a:off x="4676426" y="1008177"/>
            <a:ext cx="277640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b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694CD0ED-26D1-CAD4-7EA0-61D9938B6DE8}"/>
              </a:ext>
            </a:extLst>
          </p:cNvPr>
          <p:cNvSpPr txBox="1"/>
          <p:nvPr/>
        </p:nvSpPr>
        <p:spPr>
          <a:xfrm>
            <a:off x="5207553" y="1115839"/>
            <a:ext cx="319318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 err="1">
                <a:latin typeface="Helvetica" pitchFamily="2" charset="0"/>
              </a:rPr>
              <a:t>abc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BFC94EC7-C21A-D68F-6CEB-7A6AB23FEF9D}"/>
              </a:ext>
            </a:extLst>
          </p:cNvPr>
          <p:cNvSpPr txBox="1"/>
          <p:nvPr/>
        </p:nvSpPr>
        <p:spPr>
          <a:xfrm>
            <a:off x="5401345" y="1374228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d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A9EB0E29-F4FB-DE68-EECB-00BEB72D628F}"/>
              </a:ext>
            </a:extLst>
          </p:cNvPr>
          <p:cNvSpPr txBox="1"/>
          <p:nvPr/>
        </p:nvSpPr>
        <p:spPr>
          <a:xfrm>
            <a:off x="4855865" y="1316808"/>
            <a:ext cx="272832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cd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08A59452-8BD6-083D-C420-BF39AD04A413}"/>
              </a:ext>
            </a:extLst>
          </p:cNvPr>
          <p:cNvSpPr txBox="1"/>
          <p:nvPr/>
        </p:nvSpPr>
        <p:spPr>
          <a:xfrm>
            <a:off x="4277675" y="1211885"/>
            <a:ext cx="319318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 err="1">
                <a:latin typeface="Helvetica" pitchFamily="2" charset="0"/>
              </a:rPr>
              <a:t>bcd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D448A306-BDC2-ED8F-08CD-C78CA247E912}"/>
              </a:ext>
            </a:extLst>
          </p:cNvPr>
          <p:cNvSpPr txBox="1"/>
          <p:nvPr/>
        </p:nvSpPr>
        <p:spPr>
          <a:xfrm>
            <a:off x="4174106" y="2107311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AB1A430B-B59C-55C2-B52A-72B2487B96B3}"/>
              </a:ext>
            </a:extLst>
          </p:cNvPr>
          <p:cNvSpPr txBox="1"/>
          <p:nvPr/>
        </p:nvSpPr>
        <p:spPr>
          <a:xfrm>
            <a:off x="4719591" y="2157551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D94E8AE4-F167-C7EB-2594-1755408C3123}"/>
              </a:ext>
            </a:extLst>
          </p:cNvPr>
          <p:cNvSpPr txBox="1"/>
          <p:nvPr/>
        </p:nvSpPr>
        <p:spPr>
          <a:xfrm>
            <a:off x="5265071" y="2222146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8BD2D8C5-974B-C030-FED3-19E0BE5CFE40}"/>
              </a:ext>
            </a:extLst>
          </p:cNvPr>
          <p:cNvSpPr txBox="1"/>
          <p:nvPr/>
        </p:nvSpPr>
        <p:spPr>
          <a:xfrm>
            <a:off x="5415797" y="2537953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b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6BCDD4CB-E9E9-7C5A-268D-009AB1C8AAC8}"/>
              </a:ext>
            </a:extLst>
          </p:cNvPr>
          <p:cNvSpPr txBox="1"/>
          <p:nvPr/>
        </p:nvSpPr>
        <p:spPr>
          <a:xfrm>
            <a:off x="4863142" y="2573194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b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0D80BED0-17C3-0D0B-018A-012508969D0B}"/>
              </a:ext>
            </a:extLst>
          </p:cNvPr>
          <p:cNvSpPr txBox="1"/>
          <p:nvPr/>
        </p:nvSpPr>
        <p:spPr>
          <a:xfrm>
            <a:off x="4327180" y="2564336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b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C8F3F65D-2DC1-394D-3CB6-18AE8DF70EC8}"/>
              </a:ext>
            </a:extLst>
          </p:cNvPr>
          <p:cNvSpPr txBox="1"/>
          <p:nvPr/>
        </p:nvSpPr>
        <p:spPr>
          <a:xfrm>
            <a:off x="4173048" y="3618927"/>
            <a:ext cx="23115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6423E201-9BB6-FA1C-5A51-F8CE515E05FA}"/>
              </a:ext>
            </a:extLst>
          </p:cNvPr>
          <p:cNvSpPr txBox="1"/>
          <p:nvPr/>
        </p:nvSpPr>
        <p:spPr>
          <a:xfrm>
            <a:off x="4302242" y="3676345"/>
            <a:ext cx="277640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b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719DBFF8-3E32-0B02-EE69-DE037A0E461D}"/>
              </a:ext>
            </a:extLst>
          </p:cNvPr>
          <p:cNvSpPr txBox="1"/>
          <p:nvPr/>
        </p:nvSpPr>
        <p:spPr>
          <a:xfrm>
            <a:off x="4854902" y="3719409"/>
            <a:ext cx="277640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ab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06333202-7FAB-A125-0963-5C8D468DE948}"/>
              </a:ext>
            </a:extLst>
          </p:cNvPr>
          <p:cNvSpPr txBox="1"/>
          <p:nvPr/>
        </p:nvSpPr>
        <p:spPr>
          <a:xfrm>
            <a:off x="4689818" y="3733761"/>
            <a:ext cx="272832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 err="1">
                <a:latin typeface="Helvetica" pitchFamily="2" charset="0"/>
              </a:rPr>
              <a:t>bc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928C6AC5-557E-718D-4209-FBDFF2D37A9C}"/>
              </a:ext>
            </a:extLst>
          </p:cNvPr>
          <p:cNvSpPr txBox="1"/>
          <p:nvPr/>
        </p:nvSpPr>
        <p:spPr>
          <a:xfrm>
            <a:off x="5400480" y="3747817"/>
            <a:ext cx="272832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 err="1">
                <a:latin typeface="Helvetica" pitchFamily="2" charset="0"/>
              </a:rPr>
              <a:t>bc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062160C8-5049-DA21-E887-7103CF61DA50}"/>
              </a:ext>
            </a:extLst>
          </p:cNvPr>
          <p:cNvSpPr txBox="1"/>
          <p:nvPr/>
        </p:nvSpPr>
        <p:spPr>
          <a:xfrm>
            <a:off x="5271286" y="3798057"/>
            <a:ext cx="226344" cy="193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59" dirty="0">
                <a:latin typeface="Helvetica" pitchFamily="2" charset="0"/>
              </a:rPr>
              <a:t>c</a:t>
            </a:r>
            <a:endParaRPr kumimoji="1" lang="ja-JP" altLang="en-US" sz="659">
              <a:latin typeface="Helvetica" pitchFamily="2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851FCE0-F5CB-BD48-9200-593B8D2D6220}"/>
              </a:ext>
            </a:extLst>
          </p:cNvPr>
          <p:cNvSpPr txBox="1"/>
          <p:nvPr/>
        </p:nvSpPr>
        <p:spPr>
          <a:xfrm rot="16200000">
            <a:off x="138008" y="2776903"/>
            <a:ext cx="1212191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dirty="0">
                <a:latin typeface="Helvetica" pitchFamily="2" charset="0"/>
              </a:rPr>
              <a:t>Relative mRNA levels</a:t>
            </a:r>
            <a:endParaRPr kumimoji="1" lang="ja-JP" altLang="en-US" sz="831">
              <a:latin typeface="Helvetica" pitchFamily="2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60FDB47-4A18-0F41-8BB0-845C7BEAAD95}"/>
              </a:ext>
            </a:extLst>
          </p:cNvPr>
          <p:cNvSpPr txBox="1"/>
          <p:nvPr/>
        </p:nvSpPr>
        <p:spPr>
          <a:xfrm rot="16200000">
            <a:off x="138008" y="5560728"/>
            <a:ext cx="1212191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dirty="0">
                <a:latin typeface="Helvetica" pitchFamily="2" charset="0"/>
              </a:rPr>
              <a:t>Relative mRNA levels</a:t>
            </a:r>
            <a:endParaRPr kumimoji="1" lang="ja-JP" altLang="en-US" sz="831">
              <a:latin typeface="Helvetica" pitchFamily="2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6ECE8B57-3237-B747-B80F-D5ED02128F5B}"/>
              </a:ext>
            </a:extLst>
          </p:cNvPr>
          <p:cNvSpPr txBox="1"/>
          <p:nvPr/>
        </p:nvSpPr>
        <p:spPr>
          <a:xfrm rot="16200000">
            <a:off x="138008" y="4156950"/>
            <a:ext cx="1212191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dirty="0">
                <a:latin typeface="Helvetica" pitchFamily="2" charset="0"/>
              </a:rPr>
              <a:t>Relative mRNA levels</a:t>
            </a:r>
            <a:endParaRPr kumimoji="1" lang="ja-JP" altLang="en-US" sz="831">
              <a:latin typeface="Helvetica" pitchFamily="2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4B6FA63-596D-AC89-696F-38BB6BDCC0B8}"/>
              </a:ext>
            </a:extLst>
          </p:cNvPr>
          <p:cNvSpPr txBox="1"/>
          <p:nvPr/>
        </p:nvSpPr>
        <p:spPr>
          <a:xfrm>
            <a:off x="4848550" y="697880"/>
            <a:ext cx="330540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dirty="0"/>
              <a:t>WT</a:t>
            </a:r>
            <a:endParaRPr kumimoji="1" lang="ja-JP" altLang="en-US" sz="831"/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3C245C1B-2D9D-BA32-A81E-D352B7419EDB}"/>
              </a:ext>
            </a:extLst>
          </p:cNvPr>
          <p:cNvSpPr/>
          <p:nvPr/>
        </p:nvSpPr>
        <p:spPr>
          <a:xfrm>
            <a:off x="4804895" y="762879"/>
            <a:ext cx="83077" cy="83077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62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714DCD02-E6F6-6E3D-4C70-9503D723CBC9}"/>
              </a:ext>
            </a:extLst>
          </p:cNvPr>
          <p:cNvSpPr/>
          <p:nvPr/>
        </p:nvSpPr>
        <p:spPr>
          <a:xfrm>
            <a:off x="5165761" y="762879"/>
            <a:ext cx="83077" cy="83077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62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23E76C1-C8B3-265B-9F38-3701ACEAAFF3}"/>
              </a:ext>
            </a:extLst>
          </p:cNvPr>
          <p:cNvSpPr txBox="1"/>
          <p:nvPr/>
        </p:nvSpPr>
        <p:spPr>
          <a:xfrm>
            <a:off x="5192533" y="697880"/>
            <a:ext cx="577402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i="1" dirty="0"/>
              <a:t>dreb2g-1</a:t>
            </a:r>
            <a:endParaRPr kumimoji="1" lang="ja-JP" altLang="en-US" sz="831" i="1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0F0C91B0-971D-B869-F45A-637C8587A4B3}"/>
              </a:ext>
            </a:extLst>
          </p:cNvPr>
          <p:cNvSpPr txBox="1"/>
          <p:nvPr/>
        </p:nvSpPr>
        <p:spPr>
          <a:xfrm>
            <a:off x="1810033" y="2282758"/>
            <a:ext cx="330540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dirty="0"/>
              <a:t>WT</a:t>
            </a:r>
            <a:endParaRPr kumimoji="1" lang="ja-JP" altLang="en-US" sz="831"/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74DD2046-5975-783F-D8D6-FEF2E29B4CDE}"/>
              </a:ext>
            </a:extLst>
          </p:cNvPr>
          <p:cNvSpPr/>
          <p:nvPr/>
        </p:nvSpPr>
        <p:spPr>
          <a:xfrm>
            <a:off x="1766378" y="2347758"/>
            <a:ext cx="83077" cy="83077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62"/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D4C570F5-7952-895A-F84D-7C4D2E129C82}"/>
              </a:ext>
            </a:extLst>
          </p:cNvPr>
          <p:cNvSpPr/>
          <p:nvPr/>
        </p:nvSpPr>
        <p:spPr>
          <a:xfrm>
            <a:off x="2127244" y="2347758"/>
            <a:ext cx="83077" cy="83077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62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C32CA014-D9C8-8A39-DA90-4A685FB44447}"/>
              </a:ext>
            </a:extLst>
          </p:cNvPr>
          <p:cNvSpPr txBox="1"/>
          <p:nvPr/>
        </p:nvSpPr>
        <p:spPr>
          <a:xfrm>
            <a:off x="2154015" y="2282758"/>
            <a:ext cx="577402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31" i="1" dirty="0"/>
              <a:t>dreb2g-1</a:t>
            </a:r>
            <a:endParaRPr kumimoji="1" lang="ja-JP" altLang="en-US" sz="831" i="1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F5F7DAE-DFB5-4C9C-741A-B3E7246EC640}"/>
              </a:ext>
            </a:extLst>
          </p:cNvPr>
          <p:cNvSpPr txBox="1"/>
          <p:nvPr/>
        </p:nvSpPr>
        <p:spPr>
          <a:xfrm>
            <a:off x="6004392" y="854660"/>
            <a:ext cx="3015612" cy="4616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4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Supplemental Fig. S4 Transcription of </a:t>
            </a:r>
            <a:r>
              <a:rPr lang="en-US" altLang="ja-JP" sz="1400" b="1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AtDREB2G </a:t>
            </a:r>
            <a:r>
              <a:rPr lang="en-US" altLang="ja-JP" sz="14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and RF biosynthetic genes and cellular flavin levels in the wild type and </a:t>
            </a:r>
            <a:r>
              <a:rPr lang="en-US" altLang="ja-JP" sz="1400" b="1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dreb2g-1</a:t>
            </a:r>
            <a:r>
              <a:rPr lang="en-US" altLang="ja-JP" sz="14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under high-temperature stress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Wild-type and </a:t>
            </a:r>
            <a:r>
              <a:rPr lang="en-US" altLang="ja-JP" sz="14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dreb2g-1</a:t>
            </a:r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plants were cultivated on 1/2 MS medium with 1% sucrose for two weeks under standard conditions. Subsequently, seedlings were transferred to 37</a:t>
            </a:r>
            <a:r>
              <a:rPr lang="ja-JP" altLang="ja-JP" sz="1400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℃</a:t>
            </a:r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(100 µmol photons/m</a:t>
            </a:r>
            <a:r>
              <a:rPr lang="en-US" altLang="ja-JP" sz="14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2</a:t>
            </a:r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/s) for 6 h. The transcript levels of (A) </a:t>
            </a:r>
            <a:r>
              <a:rPr lang="en-US" altLang="ja-JP" sz="14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AtDREB2G</a:t>
            </a:r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and (B) RF biosynthetic genes. (C) Cellular flavin levels. The presented data represent means ± SE from a minimum of three individual experiments (n ≥ 3) involving independently grown plants. Different letters indicate significant differences (P &lt; 0.05, Tukey-Kramer test).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sz="1400"/>
          </a:p>
        </p:txBody>
      </p:sp>
    </p:spTree>
    <p:extLst>
      <p:ext uri="{BB962C8B-B14F-4D97-AF65-F5344CB8AC3E}">
        <p14:creationId xmlns:p14="http://schemas.microsoft.com/office/powerpoint/2010/main" val="9094208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B76BFC2B-96E5-D397-2AC9-28CB8858DC24}"/>
              </a:ext>
            </a:extLst>
          </p:cNvPr>
          <p:cNvGrpSpPr>
            <a:grpSpLocks noChangeAspect="1"/>
          </p:cNvGrpSpPr>
          <p:nvPr/>
        </p:nvGrpSpPr>
        <p:grpSpPr>
          <a:xfrm>
            <a:off x="1157825" y="1258161"/>
            <a:ext cx="6828350" cy="3312403"/>
            <a:chOff x="2402281" y="1940212"/>
            <a:chExt cx="4931586" cy="2392291"/>
          </a:xfrm>
        </p:grpSpPr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2215EAE1-B566-5E56-89C9-5CC8229D0E78}"/>
                </a:ext>
              </a:extLst>
            </p:cNvPr>
            <p:cNvCxnSpPr>
              <a:cxnSpLocks/>
            </p:cNvCxnSpPr>
            <p:nvPr/>
          </p:nvCxnSpPr>
          <p:spPr>
            <a:xfrm>
              <a:off x="3564244" y="1940212"/>
              <a:ext cx="0" cy="2351696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F35CE74D-9D06-91F9-365B-F5A21EF45041}"/>
                </a:ext>
              </a:extLst>
            </p:cNvPr>
            <p:cNvCxnSpPr>
              <a:cxnSpLocks/>
            </p:cNvCxnSpPr>
            <p:nvPr/>
          </p:nvCxnSpPr>
          <p:spPr>
            <a:xfrm>
              <a:off x="6142132" y="1971874"/>
              <a:ext cx="0" cy="2351696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線コネクタ 28">
              <a:extLst>
                <a:ext uri="{FF2B5EF4-FFF2-40B4-BE49-F238E27FC236}">
                  <a16:creationId xmlns:a16="http://schemas.microsoft.com/office/drawing/2014/main" id="{CADB7075-7E03-6EDC-6037-B1BF4B6966EE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6132867" y="1955660"/>
              <a:ext cx="0" cy="2351696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D9C81B7F-92C5-3A6E-13A1-EA1E26F40FC3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3578129" y="1918602"/>
              <a:ext cx="0" cy="2351696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1" name="図 30">
              <a:extLst>
                <a:ext uri="{FF2B5EF4-FFF2-40B4-BE49-F238E27FC236}">
                  <a16:creationId xmlns:a16="http://schemas.microsoft.com/office/drawing/2014/main" id="{DBFA0C57-3B61-9DBB-E547-7E07553D043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70768" y="1948923"/>
              <a:ext cx="2362875" cy="2331620"/>
            </a:xfrm>
            <a:prstGeom prst="rect">
              <a:avLst/>
            </a:prstGeom>
          </p:spPr>
        </p:pic>
        <p:pic>
          <p:nvPicPr>
            <p:cNvPr id="32" name="図 31">
              <a:extLst>
                <a:ext uri="{FF2B5EF4-FFF2-40B4-BE49-F238E27FC236}">
                  <a16:creationId xmlns:a16="http://schemas.microsoft.com/office/drawing/2014/main" id="{82BA29F2-A80B-000C-A9AC-49D707ED078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953000" y="1940212"/>
              <a:ext cx="2355715" cy="2345740"/>
            </a:xfrm>
            <a:prstGeom prst="rect">
              <a:avLst/>
            </a:prstGeom>
          </p:spPr>
        </p:pic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FEA6D098-4D07-89A6-A977-D8C701CF41E9}"/>
                </a:ext>
              </a:extLst>
            </p:cNvPr>
            <p:cNvCxnSpPr>
              <a:cxnSpLocks/>
            </p:cNvCxnSpPr>
            <p:nvPr/>
          </p:nvCxnSpPr>
          <p:spPr>
            <a:xfrm>
              <a:off x="3650961" y="1945749"/>
              <a:ext cx="0" cy="2351696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89D9D36A-E727-0585-9447-03C3BDB7614D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3664846" y="1924139"/>
              <a:ext cx="0" cy="2351696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4734B86D-B327-CC88-72F1-85F005FC0F08}"/>
                </a:ext>
              </a:extLst>
            </p:cNvPr>
            <p:cNvCxnSpPr>
              <a:cxnSpLocks/>
            </p:cNvCxnSpPr>
            <p:nvPr/>
          </p:nvCxnSpPr>
          <p:spPr>
            <a:xfrm>
              <a:off x="6144134" y="1980807"/>
              <a:ext cx="0" cy="2351696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659F5FAA-DCC5-4B5F-BF5D-27484CA60824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6158019" y="1959197"/>
              <a:ext cx="0" cy="2351696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352D07A-EEC7-3415-81A7-BE74DE758463}"/>
              </a:ext>
            </a:extLst>
          </p:cNvPr>
          <p:cNvSpPr txBox="1"/>
          <p:nvPr/>
        </p:nvSpPr>
        <p:spPr>
          <a:xfrm>
            <a:off x="5372577" y="671222"/>
            <a:ext cx="1911101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92" dirty="0">
                <a:latin typeface="Helvetica" pitchFamily="2" charset="0"/>
              </a:rPr>
              <a:t>After freezing treatment</a:t>
            </a:r>
            <a:endParaRPr kumimoji="1" lang="ja-JP" altLang="en-US" sz="1292">
              <a:latin typeface="Helvetica" pitchFamily="2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8908B91-6E62-F07F-25D1-6F8B9FA9137D}"/>
              </a:ext>
            </a:extLst>
          </p:cNvPr>
          <p:cNvSpPr txBox="1"/>
          <p:nvPr/>
        </p:nvSpPr>
        <p:spPr>
          <a:xfrm>
            <a:off x="1958099" y="671222"/>
            <a:ext cx="1965603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92" dirty="0">
                <a:latin typeface="Helvetica" pitchFamily="2" charset="0"/>
              </a:rPr>
              <a:t>Normal growth condition</a:t>
            </a:r>
            <a:endParaRPr kumimoji="1" lang="ja-JP" altLang="en-US" sz="1292">
              <a:latin typeface="Helvetica" pitchFamily="2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303C685-BA1B-F02C-A617-93C7B4268D82}"/>
              </a:ext>
            </a:extLst>
          </p:cNvPr>
          <p:cNvSpPr txBox="1"/>
          <p:nvPr/>
        </p:nvSpPr>
        <p:spPr>
          <a:xfrm>
            <a:off x="1804897" y="1009368"/>
            <a:ext cx="679994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92" dirty="0">
                <a:latin typeface="Helvetica" pitchFamily="2" charset="0"/>
              </a:rPr>
              <a:t>control</a:t>
            </a:r>
            <a:endParaRPr kumimoji="1" lang="ja-JP" altLang="en-US" sz="1292">
              <a:latin typeface="Helvetica" pitchFamily="2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8F1A58F-041A-F7A5-9630-8A8BFD0082E1}"/>
              </a:ext>
            </a:extLst>
          </p:cNvPr>
          <p:cNvSpPr txBox="1"/>
          <p:nvPr/>
        </p:nvSpPr>
        <p:spPr>
          <a:xfrm>
            <a:off x="3062340" y="1019811"/>
            <a:ext cx="1119217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92" i="1" dirty="0">
                <a:latin typeface="Helvetica" pitchFamily="2" charset="0"/>
              </a:rPr>
              <a:t>dreb2g-1</a:t>
            </a:r>
            <a:r>
              <a:rPr kumimoji="1" lang="en-US" altLang="ja-JP" sz="1292" dirty="0">
                <a:latin typeface="Helvetica" pitchFamily="2" charset="0"/>
              </a:rPr>
              <a:t>/VC</a:t>
            </a:r>
            <a:endParaRPr kumimoji="1" lang="ja-JP" altLang="en-US" sz="1292">
              <a:latin typeface="Helvetica" pitchFamily="2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D4CD8C9-0D87-B781-7CDD-769EE39586CC}"/>
              </a:ext>
            </a:extLst>
          </p:cNvPr>
          <p:cNvSpPr txBox="1"/>
          <p:nvPr/>
        </p:nvSpPr>
        <p:spPr>
          <a:xfrm>
            <a:off x="1388427" y="4469498"/>
            <a:ext cx="1443024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92" dirty="0">
                <a:latin typeface="Helvetica" pitchFamily="2" charset="0"/>
              </a:rPr>
              <a:t>OE-</a:t>
            </a:r>
            <a:r>
              <a:rPr kumimoji="1" lang="en-US" altLang="ja-JP" sz="1292" i="1" dirty="0">
                <a:latin typeface="Helvetica" pitchFamily="2" charset="0"/>
              </a:rPr>
              <a:t>DREB2G </a:t>
            </a:r>
            <a:r>
              <a:rPr kumimoji="1" lang="en-US" altLang="ja-JP" sz="1292" dirty="0">
                <a:latin typeface="Helvetica" pitchFamily="2" charset="0"/>
              </a:rPr>
              <a:t>3-6</a:t>
            </a:r>
            <a:endParaRPr kumimoji="1" lang="ja-JP" altLang="en-US" sz="1292">
              <a:latin typeface="Helvetica" pitchFamily="2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BA75B93-F48F-CCD5-E5D8-E276DC7EC9AC}"/>
              </a:ext>
            </a:extLst>
          </p:cNvPr>
          <p:cNvSpPr txBox="1"/>
          <p:nvPr/>
        </p:nvSpPr>
        <p:spPr>
          <a:xfrm>
            <a:off x="2812249" y="4469498"/>
            <a:ext cx="1853392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92" i="1" dirty="0">
                <a:latin typeface="Helvetica" pitchFamily="2" charset="0"/>
              </a:rPr>
              <a:t>dreb2g-1</a:t>
            </a:r>
            <a:r>
              <a:rPr kumimoji="1" lang="en-US" altLang="ja-JP" sz="1292" dirty="0">
                <a:latin typeface="Helvetica" pitchFamily="2" charset="0"/>
              </a:rPr>
              <a:t>/</a:t>
            </a:r>
            <a:r>
              <a:rPr kumimoji="1" lang="en-US" altLang="ja-JP" sz="1292" i="1" dirty="0">
                <a:latin typeface="Helvetica" pitchFamily="2" charset="0"/>
              </a:rPr>
              <a:t>DREB2G </a:t>
            </a:r>
            <a:r>
              <a:rPr kumimoji="1" lang="en-US" altLang="ja-JP" sz="1292" dirty="0">
                <a:latin typeface="Helvetica" pitchFamily="2" charset="0"/>
              </a:rPr>
              <a:t>6-1</a:t>
            </a:r>
            <a:endParaRPr kumimoji="1" lang="ja-JP" altLang="en-US" sz="1292" i="1">
              <a:latin typeface="Helvetica" pitchFamily="2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4ABD488-5E81-2076-0587-E5FC2F740EDB}"/>
              </a:ext>
            </a:extLst>
          </p:cNvPr>
          <p:cNvSpPr txBox="1"/>
          <p:nvPr/>
        </p:nvSpPr>
        <p:spPr>
          <a:xfrm>
            <a:off x="4850275" y="4469498"/>
            <a:ext cx="1443024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92" dirty="0">
                <a:latin typeface="Helvetica" pitchFamily="2" charset="0"/>
              </a:rPr>
              <a:t>OE-</a:t>
            </a:r>
            <a:r>
              <a:rPr kumimoji="1" lang="en-US" altLang="ja-JP" sz="1292" i="1" dirty="0">
                <a:latin typeface="Helvetica" pitchFamily="2" charset="0"/>
              </a:rPr>
              <a:t>DREB2G </a:t>
            </a:r>
            <a:r>
              <a:rPr kumimoji="1" lang="en-US" altLang="ja-JP" sz="1292" dirty="0">
                <a:latin typeface="Helvetica" pitchFamily="2" charset="0"/>
              </a:rPr>
              <a:t>3-6</a:t>
            </a:r>
            <a:endParaRPr kumimoji="1" lang="ja-JP" altLang="en-US" sz="1292">
              <a:latin typeface="Helvetica" pitchFamily="2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251E7E6-6254-7465-1BDA-993FDCF9AAC8}"/>
              </a:ext>
            </a:extLst>
          </p:cNvPr>
          <p:cNvSpPr txBox="1"/>
          <p:nvPr/>
        </p:nvSpPr>
        <p:spPr>
          <a:xfrm>
            <a:off x="6274097" y="4469498"/>
            <a:ext cx="1853392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92" i="1" dirty="0">
                <a:latin typeface="Helvetica" pitchFamily="2" charset="0"/>
              </a:rPr>
              <a:t>dreb2g-1</a:t>
            </a:r>
            <a:r>
              <a:rPr kumimoji="1" lang="en-US" altLang="ja-JP" sz="1292" dirty="0">
                <a:latin typeface="Helvetica" pitchFamily="2" charset="0"/>
              </a:rPr>
              <a:t>/</a:t>
            </a:r>
            <a:r>
              <a:rPr kumimoji="1" lang="en-US" altLang="ja-JP" sz="1292" i="1" dirty="0">
                <a:latin typeface="Helvetica" pitchFamily="2" charset="0"/>
              </a:rPr>
              <a:t>DREB2G </a:t>
            </a:r>
            <a:r>
              <a:rPr kumimoji="1" lang="en-US" altLang="ja-JP" sz="1292" dirty="0">
                <a:latin typeface="Helvetica" pitchFamily="2" charset="0"/>
              </a:rPr>
              <a:t>6-1</a:t>
            </a:r>
            <a:endParaRPr kumimoji="1" lang="ja-JP" altLang="en-US" sz="1292" i="1">
              <a:latin typeface="Helvetica" pitchFamily="2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C96EE318-5213-F34D-2449-255C5FBA148B}"/>
              </a:ext>
            </a:extLst>
          </p:cNvPr>
          <p:cNvSpPr txBox="1"/>
          <p:nvPr/>
        </p:nvSpPr>
        <p:spPr>
          <a:xfrm>
            <a:off x="5242756" y="1019811"/>
            <a:ext cx="679994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92" dirty="0">
                <a:latin typeface="Helvetica" pitchFamily="2" charset="0"/>
              </a:rPr>
              <a:t>control</a:t>
            </a:r>
            <a:endParaRPr kumimoji="1" lang="ja-JP" altLang="en-US" sz="1292">
              <a:latin typeface="Helvetica" pitchFamily="2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A7E49D6-E7A5-368F-A615-0A3F5C4EF46C}"/>
              </a:ext>
            </a:extLst>
          </p:cNvPr>
          <p:cNvSpPr txBox="1"/>
          <p:nvPr/>
        </p:nvSpPr>
        <p:spPr>
          <a:xfrm>
            <a:off x="6500199" y="1019811"/>
            <a:ext cx="1119217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92" i="1" dirty="0">
                <a:latin typeface="Helvetica" pitchFamily="2" charset="0"/>
              </a:rPr>
              <a:t>dreb2g-1</a:t>
            </a:r>
            <a:r>
              <a:rPr kumimoji="1" lang="en-US" altLang="ja-JP" sz="1292" dirty="0">
                <a:latin typeface="Helvetica" pitchFamily="2" charset="0"/>
              </a:rPr>
              <a:t>/VC</a:t>
            </a:r>
            <a:endParaRPr kumimoji="1" lang="ja-JP" altLang="en-US" sz="1292">
              <a:latin typeface="Helvetica" pitchFamily="2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785CED2-1B13-6777-C1B8-CB4B0AADD516}"/>
              </a:ext>
            </a:extLst>
          </p:cNvPr>
          <p:cNvSpPr txBox="1"/>
          <p:nvPr/>
        </p:nvSpPr>
        <p:spPr>
          <a:xfrm>
            <a:off x="0" y="5168348"/>
            <a:ext cx="9144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4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Supplemental Fig. S5 Freezing </a:t>
            </a:r>
            <a:r>
              <a:rPr lang="en-US" altLang="ja-JP" sz="14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stress tolerance of </a:t>
            </a:r>
            <a:r>
              <a:rPr lang="en-US" altLang="ja-JP" sz="1400" b="1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AtDREB2G</a:t>
            </a:r>
            <a:r>
              <a:rPr lang="en-US" altLang="ja-JP" sz="14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overexpressing lines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Two-week-old plants, cultivated on 1/2 MS medium with 1% sucrose, were exposed to -20˚C for 5 hours and subsequently returned to and grown under standard growth conditions for 3 days. 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sz="1400"/>
          </a:p>
        </p:txBody>
      </p:sp>
    </p:spTree>
    <p:extLst>
      <p:ext uri="{BB962C8B-B14F-4D97-AF65-F5344CB8AC3E}">
        <p14:creationId xmlns:p14="http://schemas.microsoft.com/office/powerpoint/2010/main" val="658735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1</TotalTime>
  <Words>760</Words>
  <Application>Microsoft Macintosh PowerPoint</Application>
  <PresentationFormat>画面に合わせる (4:3)</PresentationFormat>
  <Paragraphs>188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4" baseType="lpstr">
      <vt:lpstr>MS Sans Serif</vt:lpstr>
      <vt:lpstr>游ゴシック</vt:lpstr>
      <vt:lpstr>游明朝</vt:lpstr>
      <vt:lpstr>Arial</vt:lpstr>
      <vt:lpstr>Calibri</vt:lpstr>
      <vt:lpstr>Calibri Light</vt:lpstr>
      <vt:lpstr>Helvetica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貴央 小川</dc:creator>
  <cp:lastModifiedBy>貴央 小川</cp:lastModifiedBy>
  <cp:revision>3</cp:revision>
  <dcterms:created xsi:type="dcterms:W3CDTF">2023-09-06T09:13:44Z</dcterms:created>
  <dcterms:modified xsi:type="dcterms:W3CDTF">2023-09-06T23:11:18Z</dcterms:modified>
</cp:coreProperties>
</file>